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57" r:id="rId2"/>
    <p:sldId id="258" r:id="rId3"/>
    <p:sldId id="259" r:id="rId4"/>
    <p:sldId id="260" r:id="rId5"/>
    <p:sldId id="261" r:id="rId6"/>
    <p:sldId id="262" r:id="rId7"/>
    <p:sldId id="266" r:id="rId8"/>
    <p:sldId id="264" r:id="rId9"/>
    <p:sldId id="265" r:id="rId10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22222"/>
    <a:srgbClr val="999999"/>
    <a:srgbClr val="D76F07"/>
    <a:srgbClr val="EFC499"/>
    <a:srgbClr val="0060D3"/>
    <a:srgbClr val="99C4EF"/>
    <a:srgbClr val="D600D6"/>
    <a:srgbClr val="EF9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A1F683-E2FE-4F38-AC98-D010B3A44686}" v="73" dt="2025-11-16T18:09:10.48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0" autoAdjust="0"/>
    <p:restoredTop sz="96274" autoAdjust="0"/>
  </p:normalViewPr>
  <p:slideViewPr>
    <p:cSldViewPr snapToGrid="0">
      <p:cViewPr>
        <p:scale>
          <a:sx n="140" d="100"/>
          <a:sy n="140" d="100"/>
        </p:scale>
        <p:origin x="3258" y="-6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ristiano Scotta (Staff)" userId="148a4c0a-b783-4644-995d-d7219bf253bf" providerId="ADAL" clId="{78DB3C64-0425-4929-998D-72919CA357E8}"/>
    <pc:docChg chg="custSel modSld">
      <pc:chgData name="Cristiano Scotta (Staff)" userId="148a4c0a-b783-4644-995d-d7219bf253bf" providerId="ADAL" clId="{78DB3C64-0425-4929-998D-72919CA357E8}" dt="2025-11-08T19:05:09.172" v="257" actId="1076"/>
      <pc:docMkLst>
        <pc:docMk/>
      </pc:docMkLst>
      <pc:sldChg chg="addSp delSp modSp mod">
        <pc:chgData name="Cristiano Scotta (Staff)" userId="148a4c0a-b783-4644-995d-d7219bf253bf" providerId="ADAL" clId="{78DB3C64-0425-4929-998D-72919CA357E8}" dt="2025-11-08T19:05:09.172" v="257" actId="1076"/>
        <pc:sldMkLst>
          <pc:docMk/>
          <pc:sldMk cId="1795505856" sldId="257"/>
        </pc:sldMkLst>
        <pc:spChg chg="mod topLvl">
          <ac:chgData name="Cristiano Scotta (Staff)" userId="148a4c0a-b783-4644-995d-d7219bf253bf" providerId="ADAL" clId="{78DB3C64-0425-4929-998D-72919CA357E8}" dt="2025-11-08T19:05:09.172" v="257" actId="1076"/>
          <ac:spMkLst>
            <pc:docMk/>
            <pc:sldMk cId="1795505856" sldId="257"/>
            <ac:spMk id="2" creationId="{26B787E4-D2BC-E5C8-39B2-1ED2B7862641}"/>
          </ac:spMkLst>
        </pc:spChg>
        <pc:spChg chg="mod topLvl">
          <ac:chgData name="Cristiano Scotta (Staff)" userId="148a4c0a-b783-4644-995d-d7219bf253bf" providerId="ADAL" clId="{78DB3C64-0425-4929-998D-72919CA357E8}" dt="2025-11-05T20:13:35.019" v="100" actId="1037"/>
          <ac:spMkLst>
            <pc:docMk/>
            <pc:sldMk cId="1795505856" sldId="257"/>
            <ac:spMk id="17" creationId="{AE7B04D8-5923-56BE-005E-E8694C4ACB87}"/>
          </ac:spMkLst>
        </pc:spChg>
        <pc:spChg chg="mod">
          <ac:chgData name="Cristiano Scotta (Staff)" userId="148a4c0a-b783-4644-995d-d7219bf253bf" providerId="ADAL" clId="{78DB3C64-0425-4929-998D-72919CA357E8}" dt="2025-11-05T20:13:49.414" v="103" actId="1076"/>
          <ac:spMkLst>
            <pc:docMk/>
            <pc:sldMk cId="1795505856" sldId="257"/>
            <ac:spMk id="31" creationId="{ADF571AA-05CC-1B94-4999-2BA89ED4F450}"/>
          </ac:spMkLst>
        </pc:spChg>
        <pc:spChg chg="mod">
          <ac:chgData name="Cristiano Scotta (Staff)" userId="148a4c0a-b783-4644-995d-d7219bf253bf" providerId="ADAL" clId="{78DB3C64-0425-4929-998D-72919CA357E8}" dt="2025-11-05T20:13:57.671" v="112" actId="1035"/>
          <ac:spMkLst>
            <pc:docMk/>
            <pc:sldMk cId="1795505856" sldId="257"/>
            <ac:spMk id="37" creationId="{02270A85-E596-1CC6-8EEE-4D51097AFD21}"/>
          </ac:spMkLst>
        </pc:spChg>
        <pc:spChg chg="mod">
          <ac:chgData name="Cristiano Scotta (Staff)" userId="148a4c0a-b783-4644-995d-d7219bf253bf" providerId="ADAL" clId="{78DB3C64-0425-4929-998D-72919CA357E8}" dt="2025-11-08T18:51:04.733" v="125" actId="6549"/>
          <ac:spMkLst>
            <pc:docMk/>
            <pc:sldMk cId="1795505856" sldId="257"/>
            <ac:spMk id="100" creationId="{4E081C8B-0D3A-7BFD-E000-2C1EEC635EE6}"/>
          </ac:spMkLst>
        </pc:spChg>
        <pc:spChg chg="mod">
          <ac:chgData name="Cristiano Scotta (Staff)" userId="148a4c0a-b783-4644-995d-d7219bf253bf" providerId="ADAL" clId="{78DB3C64-0425-4929-998D-72919CA357E8}" dt="2025-11-08T18:51:13.738" v="126"/>
          <ac:spMkLst>
            <pc:docMk/>
            <pc:sldMk cId="1795505856" sldId="257"/>
            <ac:spMk id="104" creationId="{C51D73C6-DE3B-3366-6707-4E8D3A3E1C06}"/>
          </ac:spMkLst>
        </pc:spChg>
        <pc:spChg chg="mod">
          <ac:chgData name="Cristiano Scotta (Staff)" userId="148a4c0a-b783-4644-995d-d7219bf253bf" providerId="ADAL" clId="{78DB3C64-0425-4929-998D-72919CA357E8}" dt="2025-11-08T18:51:18.825" v="127"/>
          <ac:spMkLst>
            <pc:docMk/>
            <pc:sldMk cId="1795505856" sldId="257"/>
            <ac:spMk id="108" creationId="{B7CAE794-5414-CBD9-3BB8-8C902B7859B0}"/>
          </ac:spMkLst>
        </pc:spChg>
        <pc:spChg chg="mod">
          <ac:chgData name="Cristiano Scotta (Staff)" userId="148a4c0a-b783-4644-995d-d7219bf253bf" providerId="ADAL" clId="{78DB3C64-0425-4929-998D-72919CA357E8}" dt="2025-11-08T18:51:22.266" v="128"/>
          <ac:spMkLst>
            <pc:docMk/>
            <pc:sldMk cId="1795505856" sldId="257"/>
            <ac:spMk id="112" creationId="{02125A9B-6D52-1EA1-03EE-C7EFDD501077}"/>
          </ac:spMkLst>
        </pc:spChg>
        <pc:graphicFrameChg chg="mod modGraphic">
          <ac:chgData name="Cristiano Scotta (Staff)" userId="148a4c0a-b783-4644-995d-d7219bf253bf" providerId="ADAL" clId="{78DB3C64-0425-4929-998D-72919CA357E8}" dt="2025-11-08T18:52:53.141" v="141" actId="14100"/>
          <ac:graphicFrameMkLst>
            <pc:docMk/>
            <pc:sldMk cId="1795505856" sldId="257"/>
            <ac:graphicFrameMk id="39" creationId="{356A72EE-CF48-5DCD-1CB0-15144AB3DD6A}"/>
          </ac:graphicFrameMkLst>
        </pc:graphicFrameChg>
        <pc:picChg chg="add mod">
          <ac:chgData name="Cristiano Scotta (Staff)" userId="148a4c0a-b783-4644-995d-d7219bf253bf" providerId="ADAL" clId="{78DB3C64-0425-4929-998D-72919CA357E8}" dt="2025-11-08T19:04:59.117" v="256" actId="1076"/>
          <ac:picMkLst>
            <pc:docMk/>
            <pc:sldMk cId="1795505856" sldId="257"/>
            <ac:picMk id="5" creationId="{B233F325-BA06-8F5E-78E1-C961739BD741}"/>
          </ac:picMkLst>
        </pc:picChg>
        <pc:picChg chg="add mod">
          <ac:chgData name="Cristiano Scotta (Staff)" userId="148a4c0a-b783-4644-995d-d7219bf253bf" providerId="ADAL" clId="{78DB3C64-0425-4929-998D-72919CA357E8}" dt="2025-11-05T20:13:28.671" v="87" actId="1038"/>
          <ac:picMkLst>
            <pc:docMk/>
            <pc:sldMk cId="1795505856" sldId="257"/>
            <ac:picMk id="16" creationId="{50D6D08E-7F18-75B5-6F82-31386D5A30E5}"/>
          </ac:picMkLst>
        </pc:picChg>
        <pc:picChg chg="mod">
          <ac:chgData name="Cristiano Scotta (Staff)" userId="148a4c0a-b783-4644-995d-d7219bf253bf" providerId="ADAL" clId="{78DB3C64-0425-4929-998D-72919CA357E8}" dt="2025-11-05T20:13:44.847" v="102" actId="1076"/>
          <ac:picMkLst>
            <pc:docMk/>
            <pc:sldMk cId="1795505856" sldId="257"/>
            <ac:picMk id="40" creationId="{1348D30B-CE02-99A2-6A4E-5465CC0F3E9D}"/>
          </ac:picMkLst>
        </pc:picChg>
      </pc:sldChg>
      <pc:sldChg chg="addSp delSp modSp mod">
        <pc:chgData name="Cristiano Scotta (Staff)" userId="148a4c0a-b783-4644-995d-d7219bf253bf" providerId="ADAL" clId="{78DB3C64-0425-4929-998D-72919CA357E8}" dt="2025-11-08T18:55:09.939" v="178" actId="1038"/>
        <pc:sldMkLst>
          <pc:docMk/>
          <pc:sldMk cId="723831022" sldId="260"/>
        </pc:sldMkLst>
        <pc:spChg chg="mod">
          <ac:chgData name="Cristiano Scotta (Staff)" userId="148a4c0a-b783-4644-995d-d7219bf253bf" providerId="ADAL" clId="{78DB3C64-0425-4929-998D-72919CA357E8}" dt="2025-11-08T18:53:42.665" v="153" actId="113"/>
          <ac:spMkLst>
            <pc:docMk/>
            <pc:sldMk cId="723831022" sldId="260"/>
            <ac:spMk id="16" creationId="{363BD92D-AD9B-A111-8E5A-11912A922FF3}"/>
          </ac:spMkLst>
        </pc:spChg>
        <pc:spChg chg="mod">
          <ac:chgData name="Cristiano Scotta (Staff)" userId="148a4c0a-b783-4644-995d-d7219bf253bf" providerId="ADAL" clId="{78DB3C64-0425-4929-998D-72919CA357E8}" dt="2025-11-08T18:53:23.941" v="150"/>
          <ac:spMkLst>
            <pc:docMk/>
            <pc:sldMk cId="723831022" sldId="260"/>
            <ac:spMk id="17" creationId="{A51D08E3-6E7C-2B9A-44EE-E620526EBF08}"/>
          </ac:spMkLst>
        </pc:spChg>
        <pc:spChg chg="mod">
          <ac:chgData name="Cristiano Scotta (Staff)" userId="148a4c0a-b783-4644-995d-d7219bf253bf" providerId="ADAL" clId="{78DB3C64-0425-4929-998D-72919CA357E8}" dt="2025-11-08T18:53:23.941" v="150"/>
          <ac:spMkLst>
            <pc:docMk/>
            <pc:sldMk cId="723831022" sldId="260"/>
            <ac:spMk id="18" creationId="{D5F5488A-B7AB-A15C-6BBF-1688B2380E7D}"/>
          </ac:spMkLst>
        </pc:spChg>
        <pc:spChg chg="mod">
          <ac:chgData name="Cristiano Scotta (Staff)" userId="148a4c0a-b783-4644-995d-d7219bf253bf" providerId="ADAL" clId="{78DB3C64-0425-4929-998D-72919CA357E8}" dt="2025-11-08T18:53:23.941" v="150"/>
          <ac:spMkLst>
            <pc:docMk/>
            <pc:sldMk cId="723831022" sldId="260"/>
            <ac:spMk id="19" creationId="{D5CC032D-355D-2A6D-1F8E-86171900DD32}"/>
          </ac:spMkLst>
        </pc:spChg>
        <pc:spChg chg="mod">
          <ac:chgData name="Cristiano Scotta (Staff)" userId="148a4c0a-b783-4644-995d-d7219bf253bf" providerId="ADAL" clId="{78DB3C64-0425-4929-998D-72919CA357E8}" dt="2025-11-08T18:53:52.213" v="155" actId="113"/>
          <ac:spMkLst>
            <pc:docMk/>
            <pc:sldMk cId="723831022" sldId="260"/>
            <ac:spMk id="20" creationId="{9FD6E1D1-900D-BF70-6D82-61986970060D}"/>
          </ac:spMkLst>
        </pc:spChg>
        <pc:spChg chg="mod">
          <ac:chgData name="Cristiano Scotta (Staff)" userId="148a4c0a-b783-4644-995d-d7219bf253bf" providerId="ADAL" clId="{78DB3C64-0425-4929-998D-72919CA357E8}" dt="2025-11-08T18:53:23.941" v="150"/>
          <ac:spMkLst>
            <pc:docMk/>
            <pc:sldMk cId="723831022" sldId="260"/>
            <ac:spMk id="25" creationId="{F8A6ABB6-7E9A-730E-9BF3-B53443A2D429}"/>
          </ac:spMkLst>
        </pc:spChg>
        <pc:spChg chg="mod">
          <ac:chgData name="Cristiano Scotta (Staff)" userId="148a4c0a-b783-4644-995d-d7219bf253bf" providerId="ADAL" clId="{78DB3C64-0425-4929-998D-72919CA357E8}" dt="2025-11-08T18:53:23.941" v="150"/>
          <ac:spMkLst>
            <pc:docMk/>
            <pc:sldMk cId="723831022" sldId="260"/>
            <ac:spMk id="26" creationId="{270B316A-BABF-3A3F-2371-7B4AA5D5A729}"/>
          </ac:spMkLst>
        </pc:spChg>
        <pc:picChg chg="mod">
          <ac:chgData name="Cristiano Scotta (Staff)" userId="148a4c0a-b783-4644-995d-d7219bf253bf" providerId="ADAL" clId="{78DB3C64-0425-4929-998D-72919CA357E8}" dt="2025-11-08T18:53:23.941" v="150"/>
          <ac:picMkLst>
            <pc:docMk/>
            <pc:sldMk cId="723831022" sldId="260"/>
            <ac:picMk id="7" creationId="{327FAE6F-DE4F-BEF6-025F-EB00004A7C39}"/>
          </ac:picMkLst>
        </pc:picChg>
        <pc:picChg chg="mod">
          <ac:chgData name="Cristiano Scotta (Staff)" userId="148a4c0a-b783-4644-995d-d7219bf253bf" providerId="ADAL" clId="{78DB3C64-0425-4929-998D-72919CA357E8}" dt="2025-11-08T18:53:23.941" v="150"/>
          <ac:picMkLst>
            <pc:docMk/>
            <pc:sldMk cId="723831022" sldId="260"/>
            <ac:picMk id="9" creationId="{D8CF6CF2-EF08-CE8F-13A4-EDE2E424D3D6}"/>
          </ac:picMkLst>
        </pc:picChg>
        <pc:picChg chg="mod">
          <ac:chgData name="Cristiano Scotta (Staff)" userId="148a4c0a-b783-4644-995d-d7219bf253bf" providerId="ADAL" clId="{78DB3C64-0425-4929-998D-72919CA357E8}" dt="2025-11-08T18:53:23.941" v="150"/>
          <ac:picMkLst>
            <pc:docMk/>
            <pc:sldMk cId="723831022" sldId="260"/>
            <ac:picMk id="13" creationId="{5B7C4BA7-9B43-4EF6-F2A3-CEF98146C0A1}"/>
          </ac:picMkLst>
        </pc:picChg>
      </pc:sldChg>
      <pc:sldChg chg="addSp modSp mod">
        <pc:chgData name="Cristiano Scotta (Staff)" userId="148a4c0a-b783-4644-995d-d7219bf253bf" providerId="ADAL" clId="{78DB3C64-0425-4929-998D-72919CA357E8}" dt="2025-11-08T18:56:53.118" v="206" actId="1076"/>
        <pc:sldMkLst>
          <pc:docMk/>
          <pc:sldMk cId="961122723" sldId="261"/>
        </pc:sldMkLst>
        <pc:spChg chg="mod">
          <ac:chgData name="Cristiano Scotta (Staff)" userId="148a4c0a-b783-4644-995d-d7219bf253bf" providerId="ADAL" clId="{78DB3C64-0425-4929-998D-72919CA357E8}" dt="2025-11-08T18:56:53.118" v="206" actId="1076"/>
          <ac:spMkLst>
            <pc:docMk/>
            <pc:sldMk cId="961122723" sldId="261"/>
            <ac:spMk id="39" creationId="{2A12F814-9E25-8084-07C9-A04BCAC842BC}"/>
          </ac:spMkLst>
        </pc:spChg>
        <pc:spChg chg="mod">
          <ac:chgData name="Cristiano Scotta (Staff)" userId="148a4c0a-b783-4644-995d-d7219bf253bf" providerId="ADAL" clId="{78DB3C64-0425-4929-998D-72919CA357E8}" dt="2025-11-08T18:56:15.756" v="204" actId="6549"/>
          <ac:spMkLst>
            <pc:docMk/>
            <pc:sldMk cId="961122723" sldId="261"/>
            <ac:spMk id="41" creationId="{AACF16D4-A905-A108-D3A8-29C817ECA506}"/>
          </ac:spMkLst>
        </pc:spChg>
        <pc:graphicFrameChg chg="modGraphic">
          <ac:chgData name="Cristiano Scotta (Staff)" userId="148a4c0a-b783-4644-995d-d7219bf253bf" providerId="ADAL" clId="{78DB3C64-0425-4929-998D-72919CA357E8}" dt="2025-11-08T18:56:04.780" v="197" actId="404"/>
          <ac:graphicFrameMkLst>
            <pc:docMk/>
            <pc:sldMk cId="961122723" sldId="261"/>
            <ac:graphicFrameMk id="30" creationId="{62966A52-CB8A-DA22-F5FC-58C119363C66}"/>
          </ac:graphicFrameMkLst>
        </pc:graphicFrameChg>
        <pc:graphicFrameChg chg="modGraphic">
          <ac:chgData name="Cristiano Scotta (Staff)" userId="148a4c0a-b783-4644-995d-d7219bf253bf" providerId="ADAL" clId="{78DB3C64-0425-4929-998D-72919CA357E8}" dt="2025-11-08T18:55:43.508" v="188" actId="404"/>
          <ac:graphicFrameMkLst>
            <pc:docMk/>
            <pc:sldMk cId="961122723" sldId="261"/>
            <ac:graphicFrameMk id="35" creationId="{CAEFFD95-7451-72CC-3774-1667D8EAC0DE}"/>
          </ac:graphicFrameMkLst>
        </pc:graphicFrameChg>
      </pc:sldChg>
      <pc:sldChg chg="modSp mod">
        <pc:chgData name="Cristiano Scotta (Staff)" userId="148a4c0a-b783-4644-995d-d7219bf253bf" providerId="ADAL" clId="{78DB3C64-0425-4929-998D-72919CA357E8}" dt="2025-11-08T18:58:25.824" v="248" actId="1038"/>
        <pc:sldMkLst>
          <pc:docMk/>
          <pc:sldMk cId="617935119" sldId="262"/>
        </pc:sldMkLst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32" creationId="{F4B8F24C-7B79-3C2E-30CE-9B53AD76219E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36" creationId="{341CA838-15DD-C719-C58D-BCAFD11CA79F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41" creationId="{A505A3EC-47A6-65A6-6369-03EC1BC6B4E1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47" creationId="{F42795B3-21CF-09A7-9307-830724BFA20B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74" creationId="{218F192C-D8FF-FBED-408A-22D21B2A6DD2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75" creationId="{C1597731-D2E5-4D51-021B-56F7C288F64D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78" creationId="{34067E4D-9C50-DDED-668C-385AA5B8F25F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81" creationId="{6ABA9F73-400F-F63B-9655-2D8D9F6BDE07}"/>
          </ac:spMkLst>
        </pc:spChg>
        <pc:spChg chg="mod">
          <ac:chgData name="Cristiano Scotta (Staff)" userId="148a4c0a-b783-4644-995d-d7219bf253bf" providerId="ADAL" clId="{78DB3C64-0425-4929-998D-72919CA357E8}" dt="2025-11-08T18:57:49.777" v="225" actId="1038"/>
          <ac:spMkLst>
            <pc:docMk/>
            <pc:sldMk cId="617935119" sldId="262"/>
            <ac:spMk id="83" creationId="{4F07C37B-34AE-9FE7-1162-C0E7B3B4E965}"/>
          </ac:spMkLst>
        </pc:spChg>
        <pc:spChg chg="mod">
          <ac:chgData name="Cristiano Scotta (Staff)" userId="148a4c0a-b783-4644-995d-d7219bf253bf" providerId="ADAL" clId="{78DB3C64-0425-4929-998D-72919CA357E8}" dt="2025-11-08T18:57:49.777" v="225" actId="1038"/>
          <ac:spMkLst>
            <pc:docMk/>
            <pc:sldMk cId="617935119" sldId="262"/>
            <ac:spMk id="86" creationId="{200A6785-81BC-22D2-15F7-5823D8FDB828}"/>
          </ac:spMkLst>
        </pc:spChg>
        <pc:spChg chg="mod">
          <ac:chgData name="Cristiano Scotta (Staff)" userId="148a4c0a-b783-4644-995d-d7219bf253bf" providerId="ADAL" clId="{78DB3C64-0425-4929-998D-72919CA357E8}" dt="2025-11-08T18:57:49.777" v="225" actId="1038"/>
          <ac:spMkLst>
            <pc:docMk/>
            <pc:sldMk cId="617935119" sldId="262"/>
            <ac:spMk id="89" creationId="{D208CD6C-F25D-18F0-5F2D-4A4EFED46528}"/>
          </ac:spMkLst>
        </pc:spChg>
        <pc:spChg chg="mod">
          <ac:chgData name="Cristiano Scotta (Staff)" userId="148a4c0a-b783-4644-995d-d7219bf253bf" providerId="ADAL" clId="{78DB3C64-0425-4929-998D-72919CA357E8}" dt="2025-11-08T18:57:49.777" v="225" actId="1038"/>
          <ac:spMkLst>
            <pc:docMk/>
            <pc:sldMk cId="617935119" sldId="262"/>
            <ac:spMk id="92" creationId="{72D58A28-0B40-55B4-5CCC-D17F0A4FB725}"/>
          </ac:spMkLst>
        </pc:spChg>
        <pc:spChg chg="mod">
          <ac:chgData name="Cristiano Scotta (Staff)" userId="148a4c0a-b783-4644-995d-d7219bf253bf" providerId="ADAL" clId="{78DB3C64-0425-4929-998D-72919CA357E8}" dt="2025-11-08T18:57:39.138" v="219"/>
          <ac:spMkLst>
            <pc:docMk/>
            <pc:sldMk cId="617935119" sldId="262"/>
            <ac:spMk id="93" creationId="{C6186F1C-6A15-B572-CBB7-2AB2BCC733BD}"/>
          </ac:spMkLst>
        </pc:spChg>
        <pc:graphicFrameChg chg="mod modGraphic">
          <ac:chgData name="Cristiano Scotta (Staff)" userId="148a4c0a-b783-4644-995d-d7219bf253bf" providerId="ADAL" clId="{78DB3C64-0425-4929-998D-72919CA357E8}" dt="2025-11-08T18:58:25.824" v="248" actId="1038"/>
          <ac:graphicFrameMkLst>
            <pc:docMk/>
            <pc:sldMk cId="617935119" sldId="262"/>
            <ac:graphicFrameMk id="119" creationId="{941E53D3-B8AF-E9FF-38C6-475119063D74}"/>
          </ac:graphicFrameMkLst>
        </pc:graphicFrameChg>
      </pc:sldChg>
      <pc:sldChg chg="modSp mod">
        <pc:chgData name="Cristiano Scotta (Staff)" userId="148a4c0a-b783-4644-995d-d7219bf253bf" providerId="ADAL" clId="{78DB3C64-0425-4929-998D-72919CA357E8}" dt="2025-11-05T18:43:55.945" v="1" actId="14100"/>
        <pc:sldMkLst>
          <pc:docMk/>
          <pc:sldMk cId="4261885939" sldId="265"/>
        </pc:sldMkLst>
      </pc:sldChg>
    </pc:docChg>
  </pc:docChgLst>
  <pc:docChgLst>
    <pc:chgData name="Cristiano Scotta (Staff)" userId="148a4c0a-b783-4644-995d-d7219bf253bf" providerId="ADAL" clId="{1741BDD3-BFC8-4EB7-A20B-B654CB38E1E5}"/>
    <pc:docChg chg="modSld">
      <pc:chgData name="Cristiano Scotta (Staff)" userId="148a4c0a-b783-4644-995d-d7219bf253bf" providerId="ADAL" clId="{1741BDD3-BFC8-4EB7-A20B-B654CB38E1E5}" dt="2025-11-16T18:09:10.486" v="71"/>
      <pc:docMkLst>
        <pc:docMk/>
      </pc:docMkLst>
      <pc:sldChg chg="addSp modSp">
        <pc:chgData name="Cristiano Scotta (Staff)" userId="148a4c0a-b783-4644-995d-d7219bf253bf" providerId="ADAL" clId="{1741BDD3-BFC8-4EB7-A20B-B654CB38E1E5}" dt="2025-11-16T15:42:06.407" v="5"/>
        <pc:sldMkLst>
          <pc:docMk/>
          <pc:sldMk cId="1795505856" sldId="257"/>
        </pc:sldMkLst>
        <pc:spChg chg="add mod">
          <ac:chgData name="Cristiano Scotta (Staff)" userId="148a4c0a-b783-4644-995d-d7219bf253bf" providerId="ADAL" clId="{1741BDD3-BFC8-4EB7-A20B-B654CB38E1E5}" dt="2025-11-16T15:42:06.407" v="5"/>
          <ac:spMkLst>
            <pc:docMk/>
            <pc:sldMk cId="1795505856" sldId="257"/>
            <ac:spMk id="13" creationId="{F04C5A1D-BF98-481A-5B44-0B95F4736D42}"/>
          </ac:spMkLst>
        </pc:spChg>
        <pc:grpChg chg="add mod">
          <ac:chgData name="Cristiano Scotta (Staff)" userId="148a4c0a-b783-4644-995d-d7219bf253bf" providerId="ADAL" clId="{1741BDD3-BFC8-4EB7-A20B-B654CB38E1E5}" dt="2025-11-16T15:41:38.843" v="4" actId="164"/>
          <ac:grpSpMkLst>
            <pc:docMk/>
            <pc:sldMk cId="1795505856" sldId="257"/>
            <ac:grpSpMk id="12" creationId="{3AF61089-7960-860D-A7C7-43119405AB5A}"/>
          </ac:grpSpMkLst>
        </pc:grpChg>
        <pc:picChg chg="add mod">
          <ac:chgData name="Cristiano Scotta (Staff)" userId="148a4c0a-b783-4644-995d-d7219bf253bf" providerId="ADAL" clId="{1741BDD3-BFC8-4EB7-A20B-B654CB38E1E5}" dt="2025-11-16T15:41:38.843" v="4" actId="164"/>
          <ac:picMkLst>
            <pc:docMk/>
            <pc:sldMk cId="1795505856" sldId="257"/>
            <ac:picMk id="8" creationId="{457B8EF8-5806-B397-9464-3FD6677E2968}"/>
          </ac:picMkLst>
        </pc:picChg>
        <pc:picChg chg="add mod">
          <ac:chgData name="Cristiano Scotta (Staff)" userId="148a4c0a-b783-4644-995d-d7219bf253bf" providerId="ADAL" clId="{1741BDD3-BFC8-4EB7-A20B-B654CB38E1E5}" dt="2025-11-16T15:41:38.843" v="4" actId="164"/>
          <ac:picMkLst>
            <pc:docMk/>
            <pc:sldMk cId="1795505856" sldId="257"/>
            <ac:picMk id="9" creationId="{09A625CD-46A5-8649-D5ED-5DC31FD761C8}"/>
          </ac:picMkLst>
        </pc:picChg>
        <pc:picChg chg="add mod">
          <ac:chgData name="Cristiano Scotta (Staff)" userId="148a4c0a-b783-4644-995d-d7219bf253bf" providerId="ADAL" clId="{1741BDD3-BFC8-4EB7-A20B-B654CB38E1E5}" dt="2025-11-16T15:41:38.843" v="4" actId="164"/>
          <ac:picMkLst>
            <pc:docMk/>
            <pc:sldMk cId="1795505856" sldId="257"/>
            <ac:picMk id="10" creationId="{B4C10F0E-A70C-CB93-51C2-D3557E9B7375}"/>
          </ac:picMkLst>
        </pc:picChg>
        <pc:picChg chg="add mod">
          <ac:chgData name="Cristiano Scotta (Staff)" userId="148a4c0a-b783-4644-995d-d7219bf253bf" providerId="ADAL" clId="{1741BDD3-BFC8-4EB7-A20B-B654CB38E1E5}" dt="2025-11-16T15:41:38.843" v="4" actId="164"/>
          <ac:picMkLst>
            <pc:docMk/>
            <pc:sldMk cId="1795505856" sldId="257"/>
            <ac:picMk id="11" creationId="{3BF1DF0D-1F8D-F9B2-5E04-74E7D2AD50C9}"/>
          </ac:picMkLst>
        </pc:picChg>
      </pc:sldChg>
      <pc:sldChg chg="addSp modSp">
        <pc:chgData name="Cristiano Scotta (Staff)" userId="148a4c0a-b783-4644-995d-d7219bf253bf" providerId="ADAL" clId="{1741BDD3-BFC8-4EB7-A20B-B654CB38E1E5}" dt="2025-11-16T18:09:10.486" v="71"/>
        <pc:sldMkLst>
          <pc:docMk/>
          <pc:sldMk cId="1380494824" sldId="258"/>
        </pc:sldMkLst>
        <pc:spChg chg="add mod">
          <ac:chgData name="Cristiano Scotta (Staff)" userId="148a4c0a-b783-4644-995d-d7219bf253bf" providerId="ADAL" clId="{1741BDD3-BFC8-4EB7-A20B-B654CB38E1E5}" dt="2025-11-16T15:52:03.259" v="9"/>
          <ac:spMkLst>
            <pc:docMk/>
            <pc:sldMk cId="1380494824" sldId="258"/>
            <ac:spMk id="11" creationId="{82674994-E8BD-B480-5E4F-1BA260DE290E}"/>
          </ac:spMkLst>
        </pc:spChg>
        <pc:spChg chg="add mod">
          <ac:chgData name="Cristiano Scotta (Staff)" userId="148a4c0a-b783-4644-995d-d7219bf253bf" providerId="ADAL" clId="{1741BDD3-BFC8-4EB7-A20B-B654CB38E1E5}" dt="2025-11-16T16:20:33.766" v="21"/>
          <ac:spMkLst>
            <pc:docMk/>
            <pc:sldMk cId="1380494824" sldId="258"/>
            <ac:spMk id="19" creationId="{6FEA1A09-3B88-9954-5FC0-D96DD6136C41}"/>
          </ac:spMkLst>
        </pc:spChg>
        <pc:spChg chg="add mod">
          <ac:chgData name="Cristiano Scotta (Staff)" userId="148a4c0a-b783-4644-995d-d7219bf253bf" providerId="ADAL" clId="{1741BDD3-BFC8-4EB7-A20B-B654CB38E1E5}" dt="2025-11-16T18:03:04.606" v="70"/>
          <ac:spMkLst>
            <pc:docMk/>
            <pc:sldMk cId="1380494824" sldId="258"/>
            <ac:spMk id="24" creationId="{47B69845-DB24-461C-2692-0DCB6B3BB8CC}"/>
          </ac:spMkLst>
        </pc:spChg>
        <pc:spChg chg="add mod">
          <ac:chgData name="Cristiano Scotta (Staff)" userId="148a4c0a-b783-4644-995d-d7219bf253bf" providerId="ADAL" clId="{1741BDD3-BFC8-4EB7-A20B-B654CB38E1E5}" dt="2025-11-16T18:09:10.486" v="71"/>
          <ac:spMkLst>
            <pc:docMk/>
            <pc:sldMk cId="1380494824" sldId="258"/>
            <ac:spMk id="31" creationId="{210F9B54-CAEE-5B46-6E86-CCDE9E48005D}"/>
          </ac:spMkLst>
        </pc:spChg>
        <pc:picChg chg="add">
          <ac:chgData name="Cristiano Scotta (Staff)" userId="148a4c0a-b783-4644-995d-d7219bf253bf" providerId="ADAL" clId="{1741BDD3-BFC8-4EB7-A20B-B654CB38E1E5}" dt="2025-11-16T15:46:57.171" v="6"/>
          <ac:picMkLst>
            <pc:docMk/>
            <pc:sldMk cId="1380494824" sldId="258"/>
            <ac:picMk id="6" creationId="{2650DD08-908B-EAAD-1F9C-A0BDD3F01F97}"/>
          </ac:picMkLst>
        </pc:picChg>
        <pc:picChg chg="add">
          <ac:chgData name="Cristiano Scotta (Staff)" userId="148a4c0a-b783-4644-995d-d7219bf253bf" providerId="ADAL" clId="{1741BDD3-BFC8-4EB7-A20B-B654CB38E1E5}" dt="2025-11-16T15:49:40.177" v="7"/>
          <ac:picMkLst>
            <pc:docMk/>
            <pc:sldMk cId="1380494824" sldId="258"/>
            <ac:picMk id="7" creationId="{C6098BDE-344D-A342-AD98-8EA781878FB9}"/>
          </ac:picMkLst>
        </pc:picChg>
        <pc:picChg chg="add">
          <ac:chgData name="Cristiano Scotta (Staff)" userId="148a4c0a-b783-4644-995d-d7219bf253bf" providerId="ADAL" clId="{1741BDD3-BFC8-4EB7-A20B-B654CB38E1E5}" dt="2025-11-16T15:50:17.893" v="8"/>
          <ac:picMkLst>
            <pc:docMk/>
            <pc:sldMk cId="1380494824" sldId="258"/>
            <ac:picMk id="8" creationId="{311E55AE-1DC3-23C5-574E-D426735DED1B}"/>
          </ac:picMkLst>
        </pc:picChg>
        <pc:picChg chg="add">
          <ac:chgData name="Cristiano Scotta (Staff)" userId="148a4c0a-b783-4644-995d-d7219bf253bf" providerId="ADAL" clId="{1741BDD3-BFC8-4EB7-A20B-B654CB38E1E5}" dt="2025-11-16T15:53:43.492" v="10"/>
          <ac:picMkLst>
            <pc:docMk/>
            <pc:sldMk cId="1380494824" sldId="258"/>
            <ac:picMk id="13" creationId="{86794AD4-0D13-044D-E25A-C83B813CC81E}"/>
          </ac:picMkLst>
        </pc:picChg>
        <pc:picChg chg="add">
          <ac:chgData name="Cristiano Scotta (Staff)" userId="148a4c0a-b783-4644-995d-d7219bf253bf" providerId="ADAL" clId="{1741BDD3-BFC8-4EB7-A20B-B654CB38E1E5}" dt="2025-11-16T15:54:30.928" v="11"/>
          <ac:picMkLst>
            <pc:docMk/>
            <pc:sldMk cId="1380494824" sldId="258"/>
            <ac:picMk id="15" creationId="{FA9B7899-3CA4-F2F6-7BDF-F3DE5378C707}"/>
          </ac:picMkLst>
        </pc:picChg>
        <pc:picChg chg="add">
          <ac:chgData name="Cristiano Scotta (Staff)" userId="148a4c0a-b783-4644-995d-d7219bf253bf" providerId="ADAL" clId="{1741BDD3-BFC8-4EB7-A20B-B654CB38E1E5}" dt="2025-11-16T16:20:07.106" v="20"/>
          <ac:picMkLst>
            <pc:docMk/>
            <pc:sldMk cId="1380494824" sldId="258"/>
            <ac:picMk id="17" creationId="{3C8D003F-A5E8-3831-8B17-E1FC8B8DEEC1}"/>
          </ac:picMkLst>
        </pc:picChg>
      </pc:sldChg>
      <pc:sldChg chg="addSp modSp">
        <pc:chgData name="Cristiano Scotta (Staff)" userId="148a4c0a-b783-4644-995d-d7219bf253bf" providerId="ADAL" clId="{1741BDD3-BFC8-4EB7-A20B-B654CB38E1E5}" dt="2025-11-16T16:15:46.513" v="19" actId="164"/>
        <pc:sldMkLst>
          <pc:docMk/>
          <pc:sldMk cId="876619201" sldId="259"/>
        </pc:sldMkLst>
        <pc:spChg chg="add mod">
          <ac:chgData name="Cristiano Scotta (Staff)" userId="148a4c0a-b783-4644-995d-d7219bf253bf" providerId="ADAL" clId="{1741BDD3-BFC8-4EB7-A20B-B654CB38E1E5}" dt="2025-11-16T16:15:46.513" v="19" actId="164"/>
          <ac:spMkLst>
            <pc:docMk/>
            <pc:sldMk cId="876619201" sldId="259"/>
            <ac:spMk id="8" creationId="{9180DA4D-9E98-3338-1843-6891D7146608}"/>
          </ac:spMkLst>
        </pc:spChg>
        <pc:spChg chg="add mod">
          <ac:chgData name="Cristiano Scotta (Staff)" userId="148a4c0a-b783-4644-995d-d7219bf253bf" providerId="ADAL" clId="{1741BDD3-BFC8-4EB7-A20B-B654CB38E1E5}" dt="2025-11-16T16:15:46.513" v="19" actId="164"/>
          <ac:spMkLst>
            <pc:docMk/>
            <pc:sldMk cId="876619201" sldId="259"/>
            <ac:spMk id="9" creationId="{FFDA0C4E-A8E2-5BD5-2E6D-EDC72667A5DD}"/>
          </ac:spMkLst>
        </pc:spChg>
        <pc:spChg chg="add mod">
          <ac:chgData name="Cristiano Scotta (Staff)" userId="148a4c0a-b783-4644-995d-d7219bf253bf" providerId="ADAL" clId="{1741BDD3-BFC8-4EB7-A20B-B654CB38E1E5}" dt="2025-11-16T16:15:46.513" v="19" actId="164"/>
          <ac:spMkLst>
            <pc:docMk/>
            <pc:sldMk cId="876619201" sldId="259"/>
            <ac:spMk id="10" creationId="{4C8131FE-25E8-35B4-6ED4-0BC9E7E13338}"/>
          </ac:spMkLst>
        </pc:spChg>
        <pc:grpChg chg="add mod">
          <ac:chgData name="Cristiano Scotta (Staff)" userId="148a4c0a-b783-4644-995d-d7219bf253bf" providerId="ADAL" clId="{1741BDD3-BFC8-4EB7-A20B-B654CB38E1E5}" dt="2025-11-16T16:15:46.513" v="19" actId="164"/>
          <ac:grpSpMkLst>
            <pc:docMk/>
            <pc:sldMk cId="876619201" sldId="259"/>
            <ac:grpSpMk id="11" creationId="{EB6DF23C-D9BD-D61C-19C3-2B0970596394}"/>
          </ac:grpSpMkLst>
        </pc:grpChg>
        <pc:picChg chg="add">
          <ac:chgData name="Cristiano Scotta (Staff)" userId="148a4c0a-b783-4644-995d-d7219bf253bf" providerId="ADAL" clId="{1741BDD3-BFC8-4EB7-A20B-B654CB38E1E5}" dt="2025-11-16T15:59:27.768" v="12"/>
          <ac:picMkLst>
            <pc:docMk/>
            <pc:sldMk cId="876619201" sldId="259"/>
            <ac:picMk id="3" creationId="{6A2114DA-06EA-EA30-DE58-041DF0EC3E11}"/>
          </ac:picMkLst>
        </pc:picChg>
        <pc:picChg chg="mod">
          <ac:chgData name="Cristiano Scotta (Staff)" userId="148a4c0a-b783-4644-995d-d7219bf253bf" providerId="ADAL" clId="{1741BDD3-BFC8-4EB7-A20B-B654CB38E1E5}" dt="2025-11-16T16:15:46.513" v="19" actId="164"/>
          <ac:picMkLst>
            <pc:docMk/>
            <pc:sldMk cId="876619201" sldId="259"/>
            <ac:picMk id="4" creationId="{34CE11B1-7862-4EAC-B3FB-41ED20584CDC}"/>
          </ac:picMkLst>
        </pc:picChg>
        <pc:picChg chg="add mod">
          <ac:chgData name="Cristiano Scotta (Staff)" userId="148a4c0a-b783-4644-995d-d7219bf253bf" providerId="ADAL" clId="{1741BDD3-BFC8-4EB7-A20B-B654CB38E1E5}" dt="2025-11-16T16:15:46.513" v="19" actId="164"/>
          <ac:picMkLst>
            <pc:docMk/>
            <pc:sldMk cId="876619201" sldId="259"/>
            <ac:picMk id="5" creationId="{A99D8300-744A-65F8-C961-04A9B07248FF}"/>
          </ac:picMkLst>
        </pc:picChg>
        <pc:picChg chg="add mod">
          <ac:chgData name="Cristiano Scotta (Staff)" userId="148a4c0a-b783-4644-995d-d7219bf253bf" providerId="ADAL" clId="{1741BDD3-BFC8-4EB7-A20B-B654CB38E1E5}" dt="2025-11-16T16:15:46.513" v="19" actId="164"/>
          <ac:picMkLst>
            <pc:docMk/>
            <pc:sldMk cId="876619201" sldId="259"/>
            <ac:picMk id="6" creationId="{BF1B74D8-F23E-1E3B-E95E-E6BA847DD35C}"/>
          </ac:picMkLst>
        </pc:picChg>
        <pc:picChg chg="add mod">
          <ac:chgData name="Cristiano Scotta (Staff)" userId="148a4c0a-b783-4644-995d-d7219bf253bf" providerId="ADAL" clId="{1741BDD3-BFC8-4EB7-A20B-B654CB38E1E5}" dt="2025-11-16T16:15:46.513" v="19" actId="164"/>
          <ac:picMkLst>
            <pc:docMk/>
            <pc:sldMk cId="876619201" sldId="259"/>
            <ac:picMk id="7" creationId="{0321DFF9-C4EB-EEC7-8BDE-5303990757F9}"/>
          </ac:picMkLst>
        </pc:picChg>
      </pc:sldChg>
      <pc:sldChg chg="addSp">
        <pc:chgData name="Cristiano Scotta (Staff)" userId="148a4c0a-b783-4644-995d-d7219bf253bf" providerId="ADAL" clId="{1741BDD3-BFC8-4EB7-A20B-B654CB38E1E5}" dt="2025-11-16T16:29:10.769" v="23"/>
        <pc:sldMkLst>
          <pc:docMk/>
          <pc:sldMk cId="723831022" sldId="260"/>
        </pc:sldMkLst>
        <pc:picChg chg="add">
          <ac:chgData name="Cristiano Scotta (Staff)" userId="148a4c0a-b783-4644-995d-d7219bf253bf" providerId="ADAL" clId="{1741BDD3-BFC8-4EB7-A20B-B654CB38E1E5}" dt="2025-11-16T16:26:39.901" v="22"/>
          <ac:picMkLst>
            <pc:docMk/>
            <pc:sldMk cId="723831022" sldId="260"/>
            <ac:picMk id="4" creationId="{BE50FF7A-DA78-9E21-6C5B-5758EA3E5964}"/>
          </ac:picMkLst>
        </pc:picChg>
        <pc:picChg chg="add">
          <ac:chgData name="Cristiano Scotta (Staff)" userId="148a4c0a-b783-4644-995d-d7219bf253bf" providerId="ADAL" clId="{1741BDD3-BFC8-4EB7-A20B-B654CB38E1E5}" dt="2025-11-16T16:29:10.769" v="23"/>
          <ac:picMkLst>
            <pc:docMk/>
            <pc:sldMk cId="723831022" sldId="260"/>
            <ac:picMk id="14" creationId="{FB6DDD78-70DB-19A0-638A-A971C13D06B6}"/>
          </ac:picMkLst>
        </pc:picChg>
      </pc:sldChg>
      <pc:sldChg chg="addSp delSp modSp">
        <pc:chgData name="Cristiano Scotta (Staff)" userId="148a4c0a-b783-4644-995d-d7219bf253bf" providerId="ADAL" clId="{1741BDD3-BFC8-4EB7-A20B-B654CB38E1E5}" dt="2025-11-16T16:46:59.566" v="33" actId="1076"/>
        <pc:sldMkLst>
          <pc:docMk/>
          <pc:sldMk cId="1452295943" sldId="263"/>
        </pc:sldMkLst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236" creationId="{419B5F8A-33B8-1927-353E-BF856AD59AEA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289" creationId="{411930D6-4BC0-57A6-3638-21D7B5E1F409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513" creationId="{5C32AE58-CFAF-176F-1944-AC2B57AFA94A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1688" creationId="{7E75A70F-01DF-CAE4-710D-D285D4CC312B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2329" creationId="{980070CC-3291-EDD4-22C6-ED37B9D94170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2647" creationId="{7D5C8DBC-9E63-8CD0-CE08-9E81B7D9DCB2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2945" creationId="{20893274-B55C-3CFE-F6A9-15C2A87319B1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3848" creationId="{85E95B99-A9F4-8675-C555-32CE8CA10AF2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3908" creationId="{AFD91D19-3390-139D-4F82-8542C929DA11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3967" creationId="{9E0C5570-CC57-2085-068B-C34D0F85AF3D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4232" creationId="{2362FBC2-E30E-52B0-4E80-3F0389A07655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4379" creationId="{1410FC26-69BE-A4B6-CF7A-88FBF2E05B7A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4632" creationId="{67B51B61-6CDE-39AB-38E8-479E51F4BF92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4672" creationId="{F47A6CBA-4678-61C8-B504-A3FD42E70603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4691" creationId="{4BC5FF18-33EB-2425-6DC8-6331DE5ADCB8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4734" creationId="{F7DAEFBF-A343-D0DF-50D3-6213F3EAFBBE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5043" creationId="{AA2030BC-646E-67E6-E366-1CDF0B7C0A3B}"/>
          </ac:spMkLst>
        </pc:spChg>
        <pc:spChg chg="mod">
          <ac:chgData name="Cristiano Scotta (Staff)" userId="148a4c0a-b783-4644-995d-d7219bf253bf" providerId="ADAL" clId="{1741BDD3-BFC8-4EB7-A20B-B654CB38E1E5}" dt="2025-11-16T16:38:53.594" v="27" actId="165"/>
          <ac:spMkLst>
            <pc:docMk/>
            <pc:sldMk cId="1452295943" sldId="263"/>
            <ac:spMk id="5188" creationId="{5FFACE16-47A4-CA4C-8C98-360E1B4677FF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5253" creationId="{B97B1C99-820C-C217-3690-609A7AB5B448}"/>
          </ac:spMkLst>
        </pc:spChg>
        <pc:spChg chg="mod">
          <ac:chgData name="Cristiano Scotta (Staff)" userId="148a4c0a-b783-4644-995d-d7219bf253bf" providerId="ADAL" clId="{1741BDD3-BFC8-4EB7-A20B-B654CB38E1E5}" dt="2025-11-16T16:38:47.618" v="26" actId="165"/>
          <ac:spMkLst>
            <pc:docMk/>
            <pc:sldMk cId="1452295943" sldId="263"/>
            <ac:spMk id="5387" creationId="{CF06D40B-2147-62D4-62AE-8038E143C215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051" creationId="{AE6A3582-AC12-5799-5DAD-B5DD4D9B5490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125" creationId="{0D22C914-C737-D73A-6208-2A9541A530EF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227" creationId="{A04F5F0F-207B-300D-A60A-79AA7A95BBC0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281" creationId="{108DB0F6-FFE6-CB40-3F6B-03EB1FBC784B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330" creationId="{EADCFB99-5856-2D5B-E9CE-FF04C21BAB6F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720" creationId="{76FDE3C3-3125-0D40-82E0-843978DC269B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7921" creationId="{2D65036C-AC14-4C48-2B76-E2B5D18A8243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8291" creationId="{67D7AFAA-C0E2-DAD9-D15A-7A2BDF2F4FCB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8423" creationId="{47C6405C-1AD1-1A22-9226-D3DABE902AC4}"/>
          </ac:spMkLst>
        </pc:spChg>
        <pc:spChg chg="mod">
          <ac:chgData name="Cristiano Scotta (Staff)" userId="148a4c0a-b783-4644-995d-d7219bf253bf" providerId="ADAL" clId="{1741BDD3-BFC8-4EB7-A20B-B654CB38E1E5}" dt="2025-11-16T16:40:57.668" v="30" actId="14100"/>
          <ac:spMkLst>
            <pc:docMk/>
            <pc:sldMk cId="1452295943" sldId="263"/>
            <ac:spMk id="8809" creationId="{AF47681F-155C-7C3B-EC85-8A5DAE9D9481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9700" creationId="{2C28CABC-8CA3-4529-8A09-0FD17DA274F6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9883" creationId="{0B6469C2-706A-0A43-9CE9-22438D96CEB0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0053" creationId="{32CD4175-3257-9CB5-8FB9-3C29947BD387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0270" creationId="{73E17920-ECAA-6018-BFB1-34C6F66431F9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0338" creationId="{74CE7EAE-2E96-0BF0-1997-DC87F9D972C1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0709" creationId="{DBBDCD54-9BEE-BEF9-26F6-310A58F94F1C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0784" creationId="{46BB33A5-C7A2-EF8A-D5A0-EC55FAAE8555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1293" creationId="{EDEA5E75-5EFD-80BC-FA3B-B42152DB5672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1536" creationId="{737E2662-8030-335A-234A-369ED97FF530}"/>
          </ac:spMkLst>
        </pc:spChg>
        <pc:spChg chg="mod">
          <ac:chgData name="Cristiano Scotta (Staff)" userId="148a4c0a-b783-4644-995d-d7219bf253bf" providerId="ADAL" clId="{1741BDD3-BFC8-4EB7-A20B-B654CB38E1E5}" dt="2025-11-16T16:46:59.566" v="33" actId="1076"/>
          <ac:spMkLst>
            <pc:docMk/>
            <pc:sldMk cId="1452295943" sldId="263"/>
            <ac:spMk id="11674" creationId="{78282BC1-701E-FB11-A86E-551FEA81534D}"/>
          </ac:spMkLst>
        </pc:spChg>
        <pc:grpChg chg="del">
          <ac:chgData name="Cristiano Scotta (Staff)" userId="148a4c0a-b783-4644-995d-d7219bf253bf" providerId="ADAL" clId="{1741BDD3-BFC8-4EB7-A20B-B654CB38E1E5}" dt="2025-11-16T16:39:06.648" v="28" actId="478"/>
          <ac:grpSpMkLst>
            <pc:docMk/>
            <pc:sldMk cId="1452295943" sldId="263"/>
            <ac:grpSpMk id="4" creationId="{CD34BFD9-AB11-4D9F-67E0-5493A55EDEC6}"/>
          </ac:grpSpMkLst>
        </pc:grpChg>
        <pc:grpChg chg="del">
          <ac:chgData name="Cristiano Scotta (Staff)" userId="148a4c0a-b783-4644-995d-d7219bf253bf" providerId="ADAL" clId="{1741BDD3-BFC8-4EB7-A20B-B654CB38E1E5}" dt="2025-11-16T16:41:07.625" v="31" actId="478"/>
          <ac:grpSpMkLst>
            <pc:docMk/>
            <pc:sldMk cId="1452295943" sldId="263"/>
            <ac:grpSpMk id="5466" creationId="{DAF517BD-A51F-437D-AF9B-B119E084589F}"/>
          </ac:grpSpMkLst>
        </pc:grpChg>
      </pc:sldChg>
      <pc:sldChg chg="addSp delSp modSp">
        <pc:chgData name="Cristiano Scotta (Staff)" userId="148a4c0a-b783-4644-995d-d7219bf253bf" providerId="ADAL" clId="{1741BDD3-BFC8-4EB7-A20B-B654CB38E1E5}" dt="2025-11-16T17:50:11.949" v="68"/>
        <pc:sldMkLst>
          <pc:docMk/>
          <pc:sldMk cId="2688260449" sldId="264"/>
        </pc:sldMkLst>
        <pc:spChg chg="mod topLvl">
          <ac:chgData name="Cristiano Scotta (Staff)" userId="148a4c0a-b783-4644-995d-d7219bf253bf" providerId="ADAL" clId="{1741BDD3-BFC8-4EB7-A20B-B654CB38E1E5}" dt="2025-11-16T17:47:14.280" v="63" actId="165"/>
          <ac:spMkLst>
            <pc:docMk/>
            <pc:sldMk cId="2688260449" sldId="264"/>
            <ac:spMk id="7" creationId="{48046DCA-D434-A7DB-DB97-A76CCA2C2129}"/>
          </ac:spMkLst>
        </pc:spChg>
        <pc:spChg chg="mod topLvl">
          <ac:chgData name="Cristiano Scotta (Staff)" userId="148a4c0a-b783-4644-995d-d7219bf253bf" providerId="ADAL" clId="{1741BDD3-BFC8-4EB7-A20B-B654CB38E1E5}" dt="2025-11-16T17:47:14.280" v="63" actId="165"/>
          <ac:spMkLst>
            <pc:docMk/>
            <pc:sldMk cId="2688260449" sldId="264"/>
            <ac:spMk id="10" creationId="{FB0D2901-1190-612A-DCF9-FDE84FF880AA}"/>
          </ac:spMkLst>
        </pc:spChg>
        <pc:spChg chg="mod topLvl">
          <ac:chgData name="Cristiano Scotta (Staff)" userId="148a4c0a-b783-4644-995d-d7219bf253bf" providerId="ADAL" clId="{1741BDD3-BFC8-4EB7-A20B-B654CB38E1E5}" dt="2025-11-16T17:47:14.280" v="63" actId="165"/>
          <ac:spMkLst>
            <pc:docMk/>
            <pc:sldMk cId="2688260449" sldId="264"/>
            <ac:spMk id="11" creationId="{EB56C097-7999-4601-C36E-90327C54FABE}"/>
          </ac:spMkLst>
        </pc:spChg>
        <pc:spChg chg="mod topLvl">
          <ac:chgData name="Cristiano Scotta (Staff)" userId="148a4c0a-b783-4644-995d-d7219bf253bf" providerId="ADAL" clId="{1741BDD3-BFC8-4EB7-A20B-B654CB38E1E5}" dt="2025-11-16T17:47:14.280" v="63" actId="165"/>
          <ac:spMkLst>
            <pc:docMk/>
            <pc:sldMk cId="2688260449" sldId="264"/>
            <ac:spMk id="12" creationId="{2FEBFFA3-E810-E25F-00E8-42448BF39811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7" creationId="{F092F49B-59D4-EC3B-8079-75CA3E8405A3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312" creationId="{16C0441D-2625-7C66-315F-A606097D4336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19713" creationId="{E0CECAE2-C986-60C3-E80B-27559F513D64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19755" creationId="{E699BF7F-79D4-9BC4-2CE0-94910FCE6031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119" creationId="{240FC30A-F907-653E-534F-0D598CB5E956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239" creationId="{0DD000EC-47A5-3F2E-1453-7E1FE02403E2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306" creationId="{EFB53D92-B74D-9DBC-8EF2-F477FB21DAC9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318" creationId="{6E922D84-8D90-371C-DF7D-79B34FDFD054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454" creationId="{13E87DCA-106A-2562-236C-14E08F694452}"/>
          </ac:spMkLst>
        </pc:spChg>
        <pc:spChg chg="mod">
          <ac:chgData name="Cristiano Scotta (Staff)" userId="148a4c0a-b783-4644-995d-d7219bf253bf" providerId="ADAL" clId="{1741BDD3-BFC8-4EB7-A20B-B654CB38E1E5}" dt="2025-11-16T17:44:06.528" v="61" actId="338"/>
          <ac:spMkLst>
            <pc:docMk/>
            <pc:sldMk cId="2688260449" sldId="264"/>
            <ac:spMk id="20627" creationId="{A2C8157C-6AA3-4F0B-18E1-AF2DD855F702}"/>
          </ac:spMkLst>
        </pc:spChg>
        <pc:spChg chg="add mod">
          <ac:chgData name="Cristiano Scotta (Staff)" userId="148a4c0a-b783-4644-995d-d7219bf253bf" providerId="ADAL" clId="{1741BDD3-BFC8-4EB7-A20B-B654CB38E1E5}" dt="2025-11-16T17:47:40.466" v="64" actId="767"/>
          <ac:spMkLst>
            <pc:docMk/>
            <pc:sldMk cId="2688260449" sldId="264"/>
            <ac:spMk id="20647" creationId="{542C7F94-D5F8-AE5C-19AF-17459286D5FF}"/>
          </ac:spMkLst>
        </pc:spChg>
        <pc:spChg chg="add mod">
          <ac:chgData name="Cristiano Scotta (Staff)" userId="148a4c0a-b783-4644-995d-d7219bf253bf" providerId="ADAL" clId="{1741BDD3-BFC8-4EB7-A20B-B654CB38E1E5}" dt="2025-11-16T17:48:07.501" v="65"/>
          <ac:spMkLst>
            <pc:docMk/>
            <pc:sldMk cId="2688260449" sldId="264"/>
            <ac:spMk id="20648" creationId="{EDA50000-2AFF-B3FE-1A94-7E37BB6CDF33}"/>
          </ac:spMkLst>
        </pc:spChg>
        <pc:spChg chg="add mod">
          <ac:chgData name="Cristiano Scotta (Staff)" userId="148a4c0a-b783-4644-995d-d7219bf253bf" providerId="ADAL" clId="{1741BDD3-BFC8-4EB7-A20B-B654CB38E1E5}" dt="2025-11-16T17:48:07.719" v="66"/>
          <ac:spMkLst>
            <pc:docMk/>
            <pc:sldMk cId="2688260449" sldId="264"/>
            <ac:spMk id="20649" creationId="{288693EF-FEA5-AF0B-2721-ADB598D03068}"/>
          </ac:spMkLst>
        </pc:spChg>
        <pc:spChg chg="add mod">
          <ac:chgData name="Cristiano Scotta (Staff)" userId="148a4c0a-b783-4644-995d-d7219bf253bf" providerId="ADAL" clId="{1741BDD3-BFC8-4EB7-A20B-B654CB38E1E5}" dt="2025-11-16T17:50:11.949" v="68"/>
          <ac:spMkLst>
            <pc:docMk/>
            <pc:sldMk cId="2688260449" sldId="264"/>
            <ac:spMk id="20657" creationId="{768537C1-2BF3-43CB-9FBB-8E3062069CE5}"/>
          </ac:spMkLst>
        </pc:spChg>
        <pc:grpChg chg="del">
          <ac:chgData name="Cristiano Scotta (Staff)" userId="148a4c0a-b783-4644-995d-d7219bf253bf" providerId="ADAL" clId="{1741BDD3-BFC8-4EB7-A20B-B654CB38E1E5}" dt="2025-11-16T17:47:14.280" v="63" actId="165"/>
          <ac:grpSpMkLst>
            <pc:docMk/>
            <pc:sldMk cId="2688260449" sldId="264"/>
            <ac:grpSpMk id="3" creationId="{0C7E3D28-F94A-85FA-CC37-7F25960EAD87}"/>
          </ac:grpSpMkLst>
        </pc:grpChg>
        <pc:picChg chg="mod topLvl">
          <ac:chgData name="Cristiano Scotta (Staff)" userId="148a4c0a-b783-4644-995d-d7219bf253bf" providerId="ADAL" clId="{1741BDD3-BFC8-4EB7-A20B-B654CB38E1E5}" dt="2025-11-16T17:47:14.280" v="63" actId="165"/>
          <ac:picMkLst>
            <pc:docMk/>
            <pc:sldMk cId="2688260449" sldId="264"/>
            <ac:picMk id="4" creationId="{354E04E3-25B1-99CC-BC91-1CB64FD720E0}"/>
          </ac:picMkLst>
        </pc:picChg>
        <pc:picChg chg="add">
          <ac:chgData name="Cristiano Scotta (Staff)" userId="148a4c0a-b783-4644-995d-d7219bf253bf" providerId="ADAL" clId="{1741BDD3-BFC8-4EB7-A20B-B654CB38E1E5}" dt="2025-11-16T17:33:02.721" v="56"/>
          <ac:picMkLst>
            <pc:docMk/>
            <pc:sldMk cId="2688260449" sldId="264"/>
            <ac:picMk id="8" creationId="{BDA87EB0-DEBE-0F58-A94F-D9B8E493748B}"/>
          </ac:picMkLst>
        </pc:picChg>
        <pc:picChg chg="add">
          <ac:chgData name="Cristiano Scotta (Staff)" userId="148a4c0a-b783-4644-995d-d7219bf253bf" providerId="ADAL" clId="{1741BDD3-BFC8-4EB7-A20B-B654CB38E1E5}" dt="2025-11-16T17:35:29.284" v="57"/>
          <ac:picMkLst>
            <pc:docMk/>
            <pc:sldMk cId="2688260449" sldId="264"/>
            <ac:picMk id="9" creationId="{7C3AB2D3-B813-728E-E1B9-4FCF78DB9517}"/>
          </ac:picMkLst>
        </pc:picChg>
        <pc:picChg chg="add">
          <ac:chgData name="Cristiano Scotta (Staff)" userId="148a4c0a-b783-4644-995d-d7219bf253bf" providerId="ADAL" clId="{1741BDD3-BFC8-4EB7-A20B-B654CB38E1E5}" dt="2025-11-16T17:36:39.045" v="58"/>
          <ac:picMkLst>
            <pc:docMk/>
            <pc:sldMk cId="2688260449" sldId="264"/>
            <ac:picMk id="17" creationId="{63AF3A73-84CF-25E7-4A93-DB163AA774CE}"/>
          </ac:picMkLst>
        </pc:picChg>
        <pc:picChg chg="add">
          <ac:chgData name="Cristiano Scotta (Staff)" userId="148a4c0a-b783-4644-995d-d7219bf253bf" providerId="ADAL" clId="{1741BDD3-BFC8-4EB7-A20B-B654CB38E1E5}" dt="2025-11-16T17:37:52.762" v="59"/>
          <ac:picMkLst>
            <pc:docMk/>
            <pc:sldMk cId="2688260449" sldId="264"/>
            <ac:picMk id="18" creationId="{74702070-24A1-7628-273D-7394CB0D6F10}"/>
          </ac:picMkLst>
        </pc:picChg>
        <pc:picChg chg="add">
          <ac:chgData name="Cristiano Scotta (Staff)" userId="148a4c0a-b783-4644-995d-d7219bf253bf" providerId="ADAL" clId="{1741BDD3-BFC8-4EB7-A20B-B654CB38E1E5}" dt="2025-11-16T17:41:13.253" v="60"/>
          <ac:picMkLst>
            <pc:docMk/>
            <pc:sldMk cId="2688260449" sldId="264"/>
            <ac:picMk id="21" creationId="{AF5EAB1F-DC6C-72D3-2F8A-CF656F2C02A1}"/>
          </ac:picMkLst>
        </pc:picChg>
        <pc:picChg chg="add">
          <ac:chgData name="Cristiano Scotta (Staff)" userId="148a4c0a-b783-4644-995d-d7219bf253bf" providerId="ADAL" clId="{1741BDD3-BFC8-4EB7-A20B-B654CB38E1E5}" dt="2025-11-16T17:44:17.563" v="62" actId="338"/>
          <ac:picMkLst>
            <pc:docMk/>
            <pc:sldMk cId="2688260449" sldId="264"/>
            <ac:picMk id="23" creationId="{A5A25AF6-E4AF-DD50-CA45-4346DCBA5E93}"/>
          </ac:picMkLst>
        </pc:picChg>
        <pc:cxnChg chg="mod topLvl">
          <ac:chgData name="Cristiano Scotta (Staff)" userId="148a4c0a-b783-4644-995d-d7219bf253bf" providerId="ADAL" clId="{1741BDD3-BFC8-4EB7-A20B-B654CB38E1E5}" dt="2025-11-16T17:47:14.280" v="63" actId="165"/>
          <ac:cxnSpMkLst>
            <pc:docMk/>
            <pc:sldMk cId="2688260449" sldId="264"/>
            <ac:cxnSpMk id="5" creationId="{180A5084-651F-6C21-0761-7E999D47FCAA}"/>
          </ac:cxnSpMkLst>
        </pc:cxnChg>
        <pc:cxnChg chg="add mod">
          <ac:chgData name="Cristiano Scotta (Staff)" userId="148a4c0a-b783-4644-995d-d7219bf253bf" providerId="ADAL" clId="{1741BDD3-BFC8-4EB7-A20B-B654CB38E1E5}" dt="2025-11-16T17:49:11.581" v="67"/>
          <ac:cxnSpMkLst>
            <pc:docMk/>
            <pc:sldMk cId="2688260449" sldId="264"/>
            <ac:cxnSpMk id="20650" creationId="{79ECC16D-E6B4-A706-FF23-F7DBEF5A620D}"/>
          </ac:cxnSpMkLst>
        </pc:cxnChg>
      </pc:sldChg>
      <pc:sldChg chg="addSp modSp">
        <pc:chgData name="Cristiano Scotta (Staff)" userId="148a4c0a-b783-4644-995d-d7219bf253bf" providerId="ADAL" clId="{1741BDD3-BFC8-4EB7-A20B-B654CB38E1E5}" dt="2025-11-16T17:56:12.781" v="69" actId="164"/>
        <pc:sldMkLst>
          <pc:docMk/>
          <pc:sldMk cId="4261885939" sldId="265"/>
        </pc:sldMkLst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35" creationId="{2080A462-CA35-63B4-A2B0-E5A651840DA5}"/>
          </ac:spMkLst>
        </pc:spChg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36" creationId="{B8202C66-A69B-3AA3-C2A6-501DB3F7DAA1}"/>
          </ac:spMkLst>
        </pc:spChg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37" creationId="{7279EAD7-D360-4D70-A167-6C23D64E1194}"/>
          </ac:spMkLst>
        </pc:spChg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38" creationId="{8761E5D2-0BF6-0D1F-32D8-86B3423A15A2}"/>
          </ac:spMkLst>
        </pc:spChg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39" creationId="{01E9E50A-30FC-359F-CF6C-100588C1F1DF}"/>
          </ac:spMkLst>
        </pc:spChg>
        <pc:spChg chg="mod">
          <ac:chgData name="Cristiano Scotta (Staff)" userId="148a4c0a-b783-4644-995d-d7219bf253bf" providerId="ADAL" clId="{1741BDD3-BFC8-4EB7-A20B-B654CB38E1E5}" dt="2025-11-16T17:56:12.781" v="69" actId="164"/>
          <ac:spMkLst>
            <pc:docMk/>
            <pc:sldMk cId="4261885939" sldId="265"/>
            <ac:spMk id="140" creationId="{A5E08E18-AD75-0C0F-61A8-D54AE9FAF0E3}"/>
          </ac:spMkLst>
        </pc:spChg>
        <pc:grpChg chg="add mod">
          <ac:chgData name="Cristiano Scotta (Staff)" userId="148a4c0a-b783-4644-995d-d7219bf253bf" providerId="ADAL" clId="{1741BDD3-BFC8-4EB7-A20B-B654CB38E1E5}" dt="2025-11-16T17:56:12.781" v="69" actId="164"/>
          <ac:grpSpMkLst>
            <pc:docMk/>
            <pc:sldMk cId="4261885939" sldId="265"/>
            <ac:grpSpMk id="4" creationId="{2BC1E739-0690-826F-6398-AB4C7C443A7C}"/>
          </ac:grpSpMkLst>
        </pc:grpChg>
        <pc:picChg chg="mod">
          <ac:chgData name="Cristiano Scotta (Staff)" userId="148a4c0a-b783-4644-995d-d7219bf253bf" providerId="ADAL" clId="{1741BDD3-BFC8-4EB7-A20B-B654CB38E1E5}" dt="2025-11-16T17:56:12.781" v="69" actId="164"/>
          <ac:picMkLst>
            <pc:docMk/>
            <pc:sldMk cId="4261885939" sldId="265"/>
            <ac:picMk id="3" creationId="{6E83CB84-B8D5-F2B8-141C-283E06AF87AE}"/>
          </ac:picMkLst>
        </pc:picChg>
      </pc:sldChg>
      <pc:sldChg chg="addSp delSp modSp">
        <pc:chgData name="Cristiano Scotta (Staff)" userId="148a4c0a-b783-4644-995d-d7219bf253bf" providerId="ADAL" clId="{1741BDD3-BFC8-4EB7-A20B-B654CB38E1E5}" dt="2025-11-16T17:28:57.996" v="55" actId="165"/>
        <pc:sldMkLst>
          <pc:docMk/>
          <pc:sldMk cId="3401450892" sldId="266"/>
        </pc:sldMkLst>
        <pc:spChg chg="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30" creationId="{C516A399-B8D6-96B6-E42F-11FDCACF4D44}"/>
          </ac:spMkLst>
        </pc:spChg>
        <pc:spChg chg="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32" creationId="{7C039334-E0FC-ADE6-66A0-82521C8AD6FD}"/>
          </ac:spMkLst>
        </pc:spChg>
        <pc:spChg chg="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34" creationId="{B584F1E2-794A-A3F6-5C8F-8A45CA2819D6}"/>
          </ac:spMkLst>
        </pc:spChg>
        <pc:spChg chg="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35" creationId="{25EA98A3-8519-D7B1-2CA7-C1CEF550206D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8832" creationId="{07A0C375-BCD7-0A50-159D-82CC1B13869A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8931" creationId="{3FD2C089-D25F-79BF-ED40-E03CAC40B31B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9696" creationId="{7366AF1E-7C77-FE39-DB4D-EC148C307376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9710" creationId="{02584914-B445-6B01-88F2-91EE843E5B63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9738" creationId="{0BEAA4AF-DE35-192A-CE11-D0DD3B1DE94A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9880" creationId="{6DBEF395-EF2E-3B5D-5F9D-FAF5C57FF61C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9932" creationId="{86385AAA-101D-DE87-F506-3AAB6042D2BB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10302" creationId="{F7002F3A-04B9-2FD2-6B45-30C0EBB7B408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10570" creationId="{64D8A1B1-8F32-9D18-8373-A82321915671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11727" creationId="{BB06B32C-84A0-7A71-B025-F464165041CF}"/>
          </ac:spMkLst>
        </pc:spChg>
        <pc:spChg chg="mod">
          <ac:chgData name="Cristiano Scotta (Staff)" userId="148a4c0a-b783-4644-995d-d7219bf253bf" providerId="ADAL" clId="{1741BDD3-BFC8-4EB7-A20B-B654CB38E1E5}" dt="2025-11-16T16:47:56.485" v="37" actId="1076"/>
          <ac:spMkLst>
            <pc:docMk/>
            <pc:sldMk cId="3401450892" sldId="266"/>
            <ac:spMk id="11824" creationId="{03E13A08-9084-1D32-587B-8A5536617B3E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2074" creationId="{924BA48C-4E75-9F97-F9A5-5E918711C2DA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2156" creationId="{BB698F4C-60D8-3025-0FB1-0DD29CC72D52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2444" creationId="{412D62FB-F00B-4CA9-7FD4-92784F8C2F32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2915" creationId="{CB3274EB-9A95-5D1B-713B-4D126D6D98F5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3990" creationId="{17080A12-68F1-1C60-05DA-C4E98414D07D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4038" creationId="{02AC2197-B5EB-CA76-B2A1-1198BD26A008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4586" creationId="{7D21C747-8103-8E64-3E81-1E475AFA2A39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4688" creationId="{66858FC3-5514-C143-B30C-7DD4EE1103EE}"/>
          </ac:spMkLst>
        </pc:spChg>
        <pc:spChg chg="mod">
          <ac:chgData name="Cristiano Scotta (Staff)" userId="148a4c0a-b783-4644-995d-d7219bf253bf" providerId="ADAL" clId="{1741BDD3-BFC8-4EB7-A20B-B654CB38E1E5}" dt="2025-11-16T16:52:38.954" v="39" actId="338"/>
          <ac:spMkLst>
            <pc:docMk/>
            <pc:sldMk cId="3401450892" sldId="266"/>
            <ac:spMk id="14926" creationId="{CA4AF3B5-52E7-2311-E822-C0AA9D28ED47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15128" creationId="{D720E777-3F2D-2D05-C347-A13324858AB5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16701" creationId="{FC93E402-94F0-2633-D0EC-428C81C5A070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19689" creationId="{341F7A60-268E-F8EA-1013-A85AED0EA995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0452" creationId="{961B8C7F-C956-42A0-AA0D-FABD1328F4BD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0642" creationId="{8547B830-2B33-91EF-711B-FED78E662CED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1826" creationId="{53D12CF6-2B58-CCC6-09EA-C2F6FAACCEB1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1991" creationId="{34C142AF-A260-B3E4-74AD-85A7123104C6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2238" creationId="{944E2558-FA5B-BA46-D50F-B6ECA8D8ECC7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2266" creationId="{2D66FCA7-EBF2-D212-4E2E-1216D3775641}"/>
          </ac:spMkLst>
        </pc:spChg>
        <pc:spChg chg="mod">
          <ac:chgData name="Cristiano Scotta (Staff)" userId="148a4c0a-b783-4644-995d-d7219bf253bf" providerId="ADAL" clId="{1741BDD3-BFC8-4EB7-A20B-B654CB38E1E5}" dt="2025-11-16T17:06:38.762" v="42" actId="338"/>
          <ac:spMkLst>
            <pc:docMk/>
            <pc:sldMk cId="3401450892" sldId="266"/>
            <ac:spMk id="22433" creationId="{123B6C57-AF3C-6165-C673-9ABC1826482D}"/>
          </ac:spMkLst>
        </pc:spChg>
        <pc:spChg chg="add 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23450" creationId="{5E4E881E-0CD1-63AB-2FF7-D7EA066E6205}"/>
          </ac:spMkLst>
        </pc:spChg>
        <pc:spChg chg="add mod">
          <ac:chgData name="Cristiano Scotta (Staff)" userId="148a4c0a-b783-4644-995d-d7219bf253bf" providerId="ADAL" clId="{1741BDD3-BFC8-4EB7-A20B-B654CB38E1E5}" dt="2025-11-16T17:11:17.116" v="47" actId="164"/>
          <ac:spMkLst>
            <pc:docMk/>
            <pc:sldMk cId="3401450892" sldId="266"/>
            <ac:spMk id="23451" creationId="{6E687EDF-206B-0E78-671B-B0B8A98828B3}"/>
          </ac:spMkLst>
        </pc:spChg>
        <pc:spChg chg="add mod">
          <ac:chgData name="Cristiano Scotta (Staff)" userId="148a4c0a-b783-4644-995d-d7219bf253bf" providerId="ADAL" clId="{1741BDD3-BFC8-4EB7-A20B-B654CB38E1E5}" dt="2025-11-16T17:12:23.566" v="49"/>
          <ac:spMkLst>
            <pc:docMk/>
            <pc:sldMk cId="3401450892" sldId="266"/>
            <ac:spMk id="23456" creationId="{9022E55D-2915-60CA-6290-8BA696E62264}"/>
          </ac:spMkLst>
        </pc:spChg>
        <pc:spChg chg="add mod">
          <ac:chgData name="Cristiano Scotta (Staff)" userId="148a4c0a-b783-4644-995d-d7219bf253bf" providerId="ADAL" clId="{1741BDD3-BFC8-4EB7-A20B-B654CB38E1E5}" dt="2025-11-16T17:12:23.566" v="49"/>
          <ac:spMkLst>
            <pc:docMk/>
            <pc:sldMk cId="3401450892" sldId="266"/>
            <ac:spMk id="23457" creationId="{6425E51A-581D-B758-8C47-589A04992BD0}"/>
          </ac:spMkLst>
        </pc:spChg>
        <pc:spChg chg="add mod">
          <ac:chgData name="Cristiano Scotta (Staff)" userId="148a4c0a-b783-4644-995d-d7219bf253bf" providerId="ADAL" clId="{1741BDD3-BFC8-4EB7-A20B-B654CB38E1E5}" dt="2025-11-16T17:15:18.718" v="50"/>
          <ac:spMkLst>
            <pc:docMk/>
            <pc:sldMk cId="3401450892" sldId="266"/>
            <ac:spMk id="23465" creationId="{3E107B68-AC72-228F-F077-EEEF375051DB}"/>
          </ac:spMkLst>
        </pc:spChg>
        <pc:spChg chg="add mod">
          <ac:chgData name="Cristiano Scotta (Staff)" userId="148a4c0a-b783-4644-995d-d7219bf253bf" providerId="ADAL" clId="{1741BDD3-BFC8-4EB7-A20B-B654CB38E1E5}" dt="2025-11-16T17:15:33.638" v="51"/>
          <ac:spMkLst>
            <pc:docMk/>
            <pc:sldMk cId="3401450892" sldId="266"/>
            <ac:spMk id="23466" creationId="{D449A14E-236C-19D6-4351-2EC4A422A8E4}"/>
          </ac:spMkLst>
        </pc:spChg>
        <pc:grpChg chg="del">
          <ac:chgData name="Cristiano Scotta (Staff)" userId="148a4c0a-b783-4644-995d-d7219bf253bf" providerId="ADAL" clId="{1741BDD3-BFC8-4EB7-A20B-B654CB38E1E5}" dt="2025-11-16T16:52:53.920" v="41" actId="478"/>
          <ac:grpSpMkLst>
            <pc:docMk/>
            <pc:sldMk cId="3401450892" sldId="266"/>
            <ac:grpSpMk id="5" creationId="{2859B206-D54B-D19D-3658-5648D4F79988}"/>
          </ac:grpSpMkLst>
        </pc:grpChg>
        <pc:grpChg chg="mod topLvl">
          <ac:chgData name="Cristiano Scotta (Staff)" userId="148a4c0a-b783-4644-995d-d7219bf253bf" providerId="ADAL" clId="{1741BDD3-BFC8-4EB7-A20B-B654CB38E1E5}" dt="2025-11-16T17:28:57.996" v="55" actId="165"/>
          <ac:grpSpMkLst>
            <pc:docMk/>
            <pc:sldMk cId="3401450892" sldId="266"/>
            <ac:grpSpMk id="8" creationId="{C0119622-4E58-2A17-0015-B6DB0A4410C7}"/>
          </ac:grpSpMkLst>
        </pc:grpChg>
        <pc:grpChg chg="del">
          <ac:chgData name="Cristiano Scotta (Staff)" userId="148a4c0a-b783-4644-995d-d7219bf253bf" providerId="ADAL" clId="{1741BDD3-BFC8-4EB7-A20B-B654CB38E1E5}" dt="2025-11-16T17:28:57.996" v="55" actId="165"/>
          <ac:grpSpMkLst>
            <pc:docMk/>
            <pc:sldMk cId="3401450892" sldId="266"/>
            <ac:grpSpMk id="25" creationId="{C8A134E6-AF5E-64B5-9971-67F644AE8316}"/>
          </ac:grpSpMkLst>
        </pc:grpChg>
        <pc:grpChg chg="del">
          <ac:chgData name="Cristiano Scotta (Staff)" userId="148a4c0a-b783-4644-995d-d7219bf253bf" providerId="ADAL" clId="{1741BDD3-BFC8-4EB7-A20B-B654CB38E1E5}" dt="2025-11-16T16:48:01.688" v="38" actId="478"/>
          <ac:grpSpMkLst>
            <pc:docMk/>
            <pc:sldMk cId="3401450892" sldId="266"/>
            <ac:grpSpMk id="8837" creationId="{41241A3A-F906-3860-E897-D90951A82191}"/>
          </ac:grpSpMkLst>
        </pc:grpChg>
        <pc:grpChg chg="del">
          <ac:chgData name="Cristiano Scotta (Staff)" userId="148a4c0a-b783-4644-995d-d7219bf253bf" providerId="ADAL" clId="{1741BDD3-BFC8-4EB7-A20B-B654CB38E1E5}" dt="2025-11-16T17:06:59.797" v="44" actId="478"/>
          <ac:grpSpMkLst>
            <pc:docMk/>
            <pc:sldMk cId="3401450892" sldId="266"/>
            <ac:grpSpMk id="15066" creationId="{CC38FE0B-06C8-A38F-5147-5665A3573B45}"/>
          </ac:grpSpMkLst>
        </pc:grpChg>
        <pc:grpChg chg="add mod">
          <ac:chgData name="Cristiano Scotta (Staff)" userId="148a4c0a-b783-4644-995d-d7219bf253bf" providerId="ADAL" clId="{1741BDD3-BFC8-4EB7-A20B-B654CB38E1E5}" dt="2025-11-16T17:11:21.793" v="48" actId="164"/>
          <ac:grpSpMkLst>
            <pc:docMk/>
            <pc:sldMk cId="3401450892" sldId="266"/>
            <ac:grpSpMk id="23452" creationId="{A3527AFA-A778-F1F4-27F3-3BB87DD0F462}"/>
          </ac:grpSpMkLst>
        </pc:grpChg>
        <pc:grpChg chg="add mod">
          <ac:chgData name="Cristiano Scotta (Staff)" userId="148a4c0a-b783-4644-995d-d7219bf253bf" providerId="ADAL" clId="{1741BDD3-BFC8-4EB7-A20B-B654CB38E1E5}" dt="2025-11-16T17:11:21.793" v="48" actId="164"/>
          <ac:grpSpMkLst>
            <pc:docMk/>
            <pc:sldMk cId="3401450892" sldId="266"/>
            <ac:grpSpMk id="23453" creationId="{849F8603-A2AE-D5A0-52C8-9A292124A598}"/>
          </ac:grpSpMkLst>
        </pc:grpChg>
        <pc:picChg chg="add">
          <ac:chgData name="Cristiano Scotta (Staff)" userId="148a4c0a-b783-4644-995d-d7219bf253bf" providerId="ADAL" clId="{1741BDD3-BFC8-4EB7-A20B-B654CB38E1E5}" dt="2025-11-16T16:47:41.578" v="36"/>
          <ac:picMkLst>
            <pc:docMk/>
            <pc:sldMk cId="3401450892" sldId="266"/>
            <ac:picMk id="2" creationId="{496B66BA-0973-E6D0-4104-13BEB274D340}"/>
          </ac:picMkLst>
        </pc:picChg>
        <pc:picChg chg="mod topLvl">
          <ac:chgData name="Cristiano Scotta (Staff)" userId="148a4c0a-b783-4644-995d-d7219bf253bf" providerId="ADAL" clId="{1741BDD3-BFC8-4EB7-A20B-B654CB38E1E5}" dt="2025-11-16T17:28:57.996" v="55" actId="165"/>
          <ac:picMkLst>
            <pc:docMk/>
            <pc:sldMk cId="3401450892" sldId="266"/>
            <ac:picMk id="18" creationId="{80EB6BA3-1F9F-1737-4D9C-9C8C97656398}"/>
          </ac:picMkLst>
        </pc:picChg>
        <pc:picChg chg="mod topLvl">
          <ac:chgData name="Cristiano Scotta (Staff)" userId="148a4c0a-b783-4644-995d-d7219bf253bf" providerId="ADAL" clId="{1741BDD3-BFC8-4EB7-A20B-B654CB38E1E5}" dt="2025-11-16T17:28:57.996" v="55" actId="165"/>
          <ac:picMkLst>
            <pc:docMk/>
            <pc:sldMk cId="3401450892" sldId="266"/>
            <ac:picMk id="19" creationId="{566EA1CE-4690-41A5-5114-6CDE13067022}"/>
          </ac:picMkLst>
        </pc:picChg>
        <pc:picChg chg="mod">
          <ac:chgData name="Cristiano Scotta (Staff)" userId="148a4c0a-b783-4644-995d-d7219bf253bf" providerId="ADAL" clId="{1741BDD3-BFC8-4EB7-A20B-B654CB38E1E5}" dt="2025-11-16T17:28:57.996" v="55" actId="165"/>
          <ac:picMkLst>
            <pc:docMk/>
            <pc:sldMk cId="3401450892" sldId="266"/>
            <ac:picMk id="20" creationId="{4F2D944B-D43E-A4CA-7CFA-32A31D424126}"/>
          </ac:picMkLst>
        </pc:picChg>
        <pc:picChg chg="mod">
          <ac:chgData name="Cristiano Scotta (Staff)" userId="148a4c0a-b783-4644-995d-d7219bf253bf" providerId="ADAL" clId="{1741BDD3-BFC8-4EB7-A20B-B654CB38E1E5}" dt="2025-11-16T17:28:57.996" v="55" actId="165"/>
          <ac:picMkLst>
            <pc:docMk/>
            <pc:sldMk cId="3401450892" sldId="266"/>
            <ac:picMk id="22" creationId="{F8DDBAA1-A100-5853-2EA1-7EF59885AF43}"/>
          </ac:picMkLst>
        </pc:picChg>
        <pc:picChg chg="mod topLvl">
          <ac:chgData name="Cristiano Scotta (Staff)" userId="148a4c0a-b783-4644-995d-d7219bf253bf" providerId="ADAL" clId="{1741BDD3-BFC8-4EB7-A20B-B654CB38E1E5}" dt="2025-11-16T17:28:57.996" v="55" actId="165"/>
          <ac:picMkLst>
            <pc:docMk/>
            <pc:sldMk cId="3401450892" sldId="266"/>
            <ac:picMk id="24" creationId="{52ED085A-F6BD-D389-2BA9-CAAF6D85B35A}"/>
          </ac:picMkLst>
        </pc:picChg>
        <pc:picChg chg="add">
          <ac:chgData name="Cristiano Scotta (Staff)" userId="148a4c0a-b783-4644-995d-d7219bf253bf" providerId="ADAL" clId="{1741BDD3-BFC8-4EB7-A20B-B654CB38E1E5}" dt="2025-11-16T16:52:47.798" v="40"/>
          <ac:picMkLst>
            <pc:docMk/>
            <pc:sldMk cId="3401450892" sldId="266"/>
            <ac:picMk id="15063" creationId="{2E133D7E-BD0C-1760-82A4-19A1C6EE752D}"/>
          </ac:picMkLst>
        </pc:picChg>
        <pc:picChg chg="add">
          <ac:chgData name="Cristiano Scotta (Staff)" userId="148a4c0a-b783-4644-995d-d7219bf253bf" providerId="ADAL" clId="{1741BDD3-BFC8-4EB7-A20B-B654CB38E1E5}" dt="2025-11-16T17:06:54.455" v="43"/>
          <ac:picMkLst>
            <pc:docMk/>
            <pc:sldMk cId="3401450892" sldId="266"/>
            <ac:picMk id="23448" creationId="{4663F004-F8DE-9423-11B6-AFECA0183BF2}"/>
          </ac:picMkLst>
        </pc:picChg>
        <pc:picChg chg="mod">
          <ac:chgData name="Cristiano Scotta (Staff)" userId="148a4c0a-b783-4644-995d-d7219bf253bf" providerId="ADAL" clId="{1741BDD3-BFC8-4EB7-A20B-B654CB38E1E5}" dt="2025-11-16T17:11:21.793" v="48" actId="164"/>
          <ac:picMkLst>
            <pc:docMk/>
            <pc:sldMk cId="3401450892" sldId="266"/>
            <ac:picMk id="23449" creationId="{31A871F3-DED9-C648-4725-5038F76FAA8F}"/>
          </ac:picMkLst>
        </pc:picChg>
        <pc:picChg chg="add">
          <ac:chgData name="Cristiano Scotta (Staff)" userId="148a4c0a-b783-4644-995d-d7219bf253bf" providerId="ADAL" clId="{1741BDD3-BFC8-4EB7-A20B-B654CB38E1E5}" dt="2025-11-16T17:27:23.598" v="52"/>
          <ac:picMkLst>
            <pc:docMk/>
            <pc:sldMk cId="3401450892" sldId="266"/>
            <ac:picMk id="23467" creationId="{E01E9121-319E-2E83-9772-2C93F1540FFC}"/>
          </ac:picMkLst>
        </pc:picChg>
        <pc:picChg chg="add">
          <ac:chgData name="Cristiano Scotta (Staff)" userId="148a4c0a-b783-4644-995d-d7219bf253bf" providerId="ADAL" clId="{1741BDD3-BFC8-4EB7-A20B-B654CB38E1E5}" dt="2025-11-16T17:27:58.226" v="53"/>
          <ac:picMkLst>
            <pc:docMk/>
            <pc:sldMk cId="3401450892" sldId="266"/>
            <ac:picMk id="23468" creationId="{DD9F741D-724D-D456-7294-BC66E3D09B92}"/>
          </ac:picMkLst>
        </pc:picChg>
        <pc:picChg chg="add">
          <ac:chgData name="Cristiano Scotta (Staff)" userId="148a4c0a-b783-4644-995d-d7219bf253bf" providerId="ADAL" clId="{1741BDD3-BFC8-4EB7-A20B-B654CB38E1E5}" dt="2025-11-16T17:28:43.493" v="54"/>
          <ac:picMkLst>
            <pc:docMk/>
            <pc:sldMk cId="3401450892" sldId="266"/>
            <ac:picMk id="23469" creationId="{8BA3B507-A3B5-163E-47D2-2F203A7EE309}"/>
          </ac:picMkLst>
        </pc:picChg>
        <pc:cxnChg chg="add mod">
          <ac:chgData name="Cristiano Scotta (Staff)" userId="148a4c0a-b783-4644-995d-d7219bf253bf" providerId="ADAL" clId="{1741BDD3-BFC8-4EB7-A20B-B654CB38E1E5}" dt="2025-11-16T17:12:23.566" v="49"/>
          <ac:cxnSpMkLst>
            <pc:docMk/>
            <pc:sldMk cId="3401450892" sldId="266"/>
            <ac:cxnSpMk id="23454" creationId="{9CBF03D8-5BF0-F1D8-D7FD-3556FC04EE08}"/>
          </ac:cxnSpMkLst>
        </pc:cxnChg>
        <pc:cxnChg chg="add mod">
          <ac:chgData name="Cristiano Scotta (Staff)" userId="148a4c0a-b783-4644-995d-d7219bf253bf" providerId="ADAL" clId="{1741BDD3-BFC8-4EB7-A20B-B654CB38E1E5}" dt="2025-11-16T17:12:23.566" v="49"/>
          <ac:cxnSpMkLst>
            <pc:docMk/>
            <pc:sldMk cId="3401450892" sldId="266"/>
            <ac:cxnSpMk id="23455" creationId="{35C7263E-9148-6277-ED54-E3A060E1B35B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F5DC49-8BCB-FC46-95F1-A34F70A51DF8}" type="datetimeFigureOut">
              <a:rPr lang="en-US" smtClean="0"/>
              <a:t>11/1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BC8FF-CD24-3046-82B6-1627F3645C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8106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C7FFE2-4E98-199C-0613-A681BA74A8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755C4F8-126F-591A-66F3-14D00E6CC2A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DBE400B7-A904-1B3E-7E1A-691DE2FA127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A0EED12-760C-81B8-5240-E61219D0D13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BC8FF-CD24-3046-82B6-1627F3645C1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7098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D45241-5B7C-7E15-B58D-8E59C9631A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8FDD87C-37E7-2C4A-CD69-B6B82EADA37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289643C-1C6D-5AF7-E911-485DA2B68D9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A3E48C-1252-3572-8B59-B17C5FA58F8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BC8FF-CD24-3046-82B6-1627F3645C1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1988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1159A2-46C3-DF27-788C-7691FCB701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3ADD6DD-67B3-3E7D-4B82-5C1AAEDD898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662B380-A30F-C567-C8FF-49271C47A52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91E8B9-51CE-A06E-A682-8934FC23865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BC8FF-CD24-3046-82B6-1627F3645C1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54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4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04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806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0660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41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051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754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5760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98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3239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154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16622-F93F-4E16-B179-223EA3DA7C18}" type="datetimeFigureOut">
              <a:rPr lang="en-GB" smtClean="0"/>
              <a:t>1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7555BB-B75A-4BFD-8DA1-79CF4EDDB7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50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svg"/><Relationship Id="rId21" Type="http://schemas.openxmlformats.org/officeDocument/2006/relationships/image" Target="../media/image20.emf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24" Type="http://schemas.openxmlformats.org/officeDocument/2006/relationships/image" Target="../media/image23.emf"/><Relationship Id="rId5" Type="http://schemas.openxmlformats.org/officeDocument/2006/relationships/image" Target="../media/image4.svg"/><Relationship Id="rId15" Type="http://schemas.openxmlformats.org/officeDocument/2006/relationships/image" Target="../media/image14.svg"/><Relationship Id="rId23" Type="http://schemas.openxmlformats.org/officeDocument/2006/relationships/image" Target="../media/image22.emf"/><Relationship Id="rId10" Type="http://schemas.openxmlformats.org/officeDocument/2006/relationships/image" Target="../media/image9.png"/><Relationship Id="rId19" Type="http://schemas.openxmlformats.org/officeDocument/2006/relationships/image" Target="../media/image18.emf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Relationship Id="rId22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svg"/><Relationship Id="rId3" Type="http://schemas.openxmlformats.org/officeDocument/2006/relationships/image" Target="../media/image25.emf"/><Relationship Id="rId7" Type="http://schemas.openxmlformats.org/officeDocument/2006/relationships/image" Target="../media/image29.png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5" Type="http://schemas.openxmlformats.org/officeDocument/2006/relationships/image" Target="../media/image27.emf"/><Relationship Id="rId10" Type="http://schemas.openxmlformats.org/officeDocument/2006/relationships/image" Target="../media/image32.svg"/><Relationship Id="rId4" Type="http://schemas.openxmlformats.org/officeDocument/2006/relationships/image" Target="../media/image26.emf"/><Relationship Id="rId9" Type="http://schemas.openxmlformats.org/officeDocument/2006/relationships/image" Target="../media/image3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svg"/><Relationship Id="rId3" Type="http://schemas.openxmlformats.org/officeDocument/2006/relationships/image" Target="../media/image38.svg"/><Relationship Id="rId7" Type="http://schemas.openxmlformats.org/officeDocument/2006/relationships/image" Target="../media/image42.svg"/><Relationship Id="rId12" Type="http://schemas.openxmlformats.org/officeDocument/2006/relationships/image" Target="../media/image47.png"/><Relationship Id="rId17" Type="http://schemas.openxmlformats.org/officeDocument/2006/relationships/image" Target="../media/image52.emf"/><Relationship Id="rId2" Type="http://schemas.openxmlformats.org/officeDocument/2006/relationships/image" Target="../media/image37.png"/><Relationship Id="rId16" Type="http://schemas.openxmlformats.org/officeDocument/2006/relationships/image" Target="../media/image5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svg"/><Relationship Id="rId5" Type="http://schemas.openxmlformats.org/officeDocument/2006/relationships/image" Target="../media/image40.svg"/><Relationship Id="rId15" Type="http://schemas.openxmlformats.org/officeDocument/2006/relationships/image" Target="../media/image50.sv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svg"/><Relationship Id="rId14" Type="http://schemas.openxmlformats.org/officeDocument/2006/relationships/image" Target="../media/image4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13" Type="http://schemas.openxmlformats.org/officeDocument/2006/relationships/image" Target="../media/image64.svg"/><Relationship Id="rId3" Type="http://schemas.openxmlformats.org/officeDocument/2006/relationships/image" Target="../media/image54.svg"/><Relationship Id="rId7" Type="http://schemas.openxmlformats.org/officeDocument/2006/relationships/image" Target="../media/image58.svg"/><Relationship Id="rId12" Type="http://schemas.openxmlformats.org/officeDocument/2006/relationships/image" Target="../media/image63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png"/><Relationship Id="rId11" Type="http://schemas.openxmlformats.org/officeDocument/2006/relationships/image" Target="../media/image62.svg"/><Relationship Id="rId5" Type="http://schemas.openxmlformats.org/officeDocument/2006/relationships/image" Target="../media/image56.svg"/><Relationship Id="rId15" Type="http://schemas.openxmlformats.org/officeDocument/2006/relationships/image" Target="../media/image66.svg"/><Relationship Id="rId10" Type="http://schemas.openxmlformats.org/officeDocument/2006/relationships/image" Target="../media/image61.png"/><Relationship Id="rId4" Type="http://schemas.openxmlformats.org/officeDocument/2006/relationships/image" Target="../media/image55.png"/><Relationship Id="rId9" Type="http://schemas.openxmlformats.org/officeDocument/2006/relationships/image" Target="../media/image60.svg"/><Relationship Id="rId14" Type="http://schemas.openxmlformats.org/officeDocument/2006/relationships/image" Target="../media/image65.png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8.svg"/><Relationship Id="rId18" Type="http://schemas.openxmlformats.org/officeDocument/2006/relationships/image" Target="../media/image83.png"/><Relationship Id="rId26" Type="http://schemas.openxmlformats.org/officeDocument/2006/relationships/image" Target="../media/image91.png"/><Relationship Id="rId3" Type="http://schemas.openxmlformats.org/officeDocument/2006/relationships/image" Target="../media/image68.svg"/><Relationship Id="rId21" Type="http://schemas.openxmlformats.org/officeDocument/2006/relationships/image" Target="../media/image86.svg"/><Relationship Id="rId7" Type="http://schemas.openxmlformats.org/officeDocument/2006/relationships/image" Target="../media/image72.svg"/><Relationship Id="rId12" Type="http://schemas.openxmlformats.org/officeDocument/2006/relationships/image" Target="../media/image77.png"/><Relationship Id="rId17" Type="http://schemas.openxmlformats.org/officeDocument/2006/relationships/image" Target="../media/image82.svg"/><Relationship Id="rId25" Type="http://schemas.openxmlformats.org/officeDocument/2006/relationships/image" Target="../media/image90.svg"/><Relationship Id="rId33" Type="http://schemas.openxmlformats.org/officeDocument/2006/relationships/image" Target="../media/image98.emf"/><Relationship Id="rId2" Type="http://schemas.openxmlformats.org/officeDocument/2006/relationships/image" Target="../media/image67.png"/><Relationship Id="rId16" Type="http://schemas.openxmlformats.org/officeDocument/2006/relationships/image" Target="../media/image81.png"/><Relationship Id="rId20" Type="http://schemas.openxmlformats.org/officeDocument/2006/relationships/image" Target="../media/image85.png"/><Relationship Id="rId29" Type="http://schemas.openxmlformats.org/officeDocument/2006/relationships/image" Target="../media/image94.sv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11" Type="http://schemas.openxmlformats.org/officeDocument/2006/relationships/image" Target="../media/image76.svg"/><Relationship Id="rId24" Type="http://schemas.openxmlformats.org/officeDocument/2006/relationships/image" Target="../media/image89.png"/><Relationship Id="rId32" Type="http://schemas.openxmlformats.org/officeDocument/2006/relationships/image" Target="../media/image97.emf"/><Relationship Id="rId5" Type="http://schemas.openxmlformats.org/officeDocument/2006/relationships/image" Target="../media/image70.svg"/><Relationship Id="rId15" Type="http://schemas.openxmlformats.org/officeDocument/2006/relationships/image" Target="../media/image80.svg"/><Relationship Id="rId23" Type="http://schemas.openxmlformats.org/officeDocument/2006/relationships/image" Target="../media/image88.svg"/><Relationship Id="rId28" Type="http://schemas.openxmlformats.org/officeDocument/2006/relationships/image" Target="../media/image93.png"/><Relationship Id="rId10" Type="http://schemas.openxmlformats.org/officeDocument/2006/relationships/image" Target="../media/image75.png"/><Relationship Id="rId19" Type="http://schemas.openxmlformats.org/officeDocument/2006/relationships/image" Target="../media/image84.svg"/><Relationship Id="rId31" Type="http://schemas.openxmlformats.org/officeDocument/2006/relationships/image" Target="../media/image96.emf"/><Relationship Id="rId4" Type="http://schemas.openxmlformats.org/officeDocument/2006/relationships/image" Target="../media/image69.png"/><Relationship Id="rId9" Type="http://schemas.openxmlformats.org/officeDocument/2006/relationships/image" Target="../media/image74.svg"/><Relationship Id="rId14" Type="http://schemas.openxmlformats.org/officeDocument/2006/relationships/image" Target="../media/image79.png"/><Relationship Id="rId22" Type="http://schemas.openxmlformats.org/officeDocument/2006/relationships/image" Target="../media/image87.png"/><Relationship Id="rId27" Type="http://schemas.openxmlformats.org/officeDocument/2006/relationships/image" Target="../media/image92.svg"/><Relationship Id="rId30" Type="http://schemas.openxmlformats.org/officeDocument/2006/relationships/image" Target="../media/image95.emf"/><Relationship Id="rId8" Type="http://schemas.openxmlformats.org/officeDocument/2006/relationships/image" Target="../media/image7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4.emf"/><Relationship Id="rId3" Type="http://schemas.openxmlformats.org/officeDocument/2006/relationships/image" Target="../media/image99.png"/><Relationship Id="rId7" Type="http://schemas.openxmlformats.org/officeDocument/2006/relationships/image" Target="../media/image10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2.png"/><Relationship Id="rId5" Type="http://schemas.openxmlformats.org/officeDocument/2006/relationships/image" Target="../media/image101.png"/><Relationship Id="rId10" Type="http://schemas.openxmlformats.org/officeDocument/2006/relationships/image" Target="../media/image106.emf"/><Relationship Id="rId4" Type="http://schemas.openxmlformats.org/officeDocument/2006/relationships/image" Target="../media/image100.svg"/><Relationship Id="rId9" Type="http://schemas.openxmlformats.org/officeDocument/2006/relationships/image" Target="../media/image10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emf"/><Relationship Id="rId7" Type="http://schemas.openxmlformats.org/officeDocument/2006/relationships/image" Target="../media/image111.sv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png"/><Relationship Id="rId5" Type="http://schemas.openxmlformats.org/officeDocument/2006/relationships/image" Target="../media/image109.emf"/><Relationship Id="rId4" Type="http://schemas.openxmlformats.org/officeDocument/2006/relationships/image" Target="../media/image10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5.svg"/><Relationship Id="rId5" Type="http://schemas.openxmlformats.org/officeDocument/2006/relationships/image" Target="../media/image114.png"/><Relationship Id="rId4" Type="http://schemas.openxmlformats.org/officeDocument/2006/relationships/image" Target="../media/image11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>
            <a:extLst>
              <a:ext uri="{FF2B5EF4-FFF2-40B4-BE49-F238E27FC236}">
                <a16:creationId xmlns:a16="http://schemas.microsoft.com/office/drawing/2014/main" id="{D03597D9-CB75-496C-BB17-9CD3B4AD7CC8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1 </a:t>
            </a:r>
          </a:p>
        </p:txBody>
      </p:sp>
      <p:graphicFrame>
        <p:nvGraphicFramePr>
          <p:cNvPr id="33" name="Table 32">
            <a:extLst>
              <a:ext uri="{FF2B5EF4-FFF2-40B4-BE49-F238E27FC236}">
                <a16:creationId xmlns:a16="http://schemas.microsoft.com/office/drawing/2014/main" id="{7DB486A4-14ED-011C-BDEC-FBACAA6E36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53273"/>
              </p:ext>
            </p:extLst>
          </p:nvPr>
        </p:nvGraphicFramePr>
        <p:xfrm>
          <a:off x="966191" y="8329303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4" name="Table 33">
            <a:extLst>
              <a:ext uri="{FF2B5EF4-FFF2-40B4-BE49-F238E27FC236}">
                <a16:creationId xmlns:a16="http://schemas.microsoft.com/office/drawing/2014/main" id="{B39801E5-0807-0752-7298-6927FDDA7C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8069916"/>
              </p:ext>
            </p:extLst>
          </p:nvPr>
        </p:nvGraphicFramePr>
        <p:xfrm>
          <a:off x="2477399" y="8329303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5" name="Table 34">
            <a:extLst>
              <a:ext uri="{FF2B5EF4-FFF2-40B4-BE49-F238E27FC236}">
                <a16:creationId xmlns:a16="http://schemas.microsoft.com/office/drawing/2014/main" id="{E42CE44A-196B-B305-5E43-399C6DD744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0604924"/>
              </p:ext>
            </p:extLst>
          </p:nvPr>
        </p:nvGraphicFramePr>
        <p:xfrm>
          <a:off x="3941543" y="8329303"/>
          <a:ext cx="771934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163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163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65414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163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163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6" name="Table 35">
            <a:extLst>
              <a:ext uri="{FF2B5EF4-FFF2-40B4-BE49-F238E27FC236}">
                <a16:creationId xmlns:a16="http://schemas.microsoft.com/office/drawing/2014/main" id="{2346C7C8-8F94-B36F-F5F3-C0A09ED266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8339520"/>
              </p:ext>
            </p:extLst>
          </p:nvPr>
        </p:nvGraphicFramePr>
        <p:xfrm>
          <a:off x="5359103" y="8329303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9" name="Table 38">
            <a:extLst>
              <a:ext uri="{FF2B5EF4-FFF2-40B4-BE49-F238E27FC236}">
                <a16:creationId xmlns:a16="http://schemas.microsoft.com/office/drawing/2014/main" id="{356A72EE-CF48-5DCD-1CB0-15144AB3DD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3023959"/>
              </p:ext>
            </p:extLst>
          </p:nvPr>
        </p:nvGraphicFramePr>
        <p:xfrm>
          <a:off x="282606" y="8343351"/>
          <a:ext cx="576000" cy="71747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76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</a:tblGrid>
              <a:tr h="239157"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39157"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Treg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39157"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-Treg</a:t>
                      </a:r>
                      <a:endParaRPr lang="en-GB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sp>
        <p:nvSpPr>
          <p:cNvPr id="2" name="TextBox 6">
            <a:extLst>
              <a:ext uri="{FF2B5EF4-FFF2-40B4-BE49-F238E27FC236}">
                <a16:creationId xmlns:a16="http://schemas.microsoft.com/office/drawing/2014/main" id="{26B787E4-D2BC-E5C8-39B2-1ED2B7862641}"/>
              </a:ext>
            </a:extLst>
          </p:cNvPr>
          <p:cNvSpPr txBox="1"/>
          <p:nvPr/>
        </p:nvSpPr>
        <p:spPr>
          <a:xfrm>
            <a:off x="125569" y="360540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Box 6">
            <a:extLst>
              <a:ext uri="{FF2B5EF4-FFF2-40B4-BE49-F238E27FC236}">
                <a16:creationId xmlns:a16="http://schemas.microsoft.com/office/drawing/2014/main" id="{AE7B04D8-5923-56BE-005E-E8694C4ACB87}"/>
              </a:ext>
            </a:extLst>
          </p:cNvPr>
          <p:cNvSpPr txBox="1"/>
          <p:nvPr/>
        </p:nvSpPr>
        <p:spPr>
          <a:xfrm>
            <a:off x="3729999" y="360540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7147B35-715A-98EE-D702-AE6494C7FC19}"/>
              </a:ext>
            </a:extLst>
          </p:cNvPr>
          <p:cNvGrpSpPr/>
          <p:nvPr/>
        </p:nvGrpSpPr>
        <p:grpSpPr>
          <a:xfrm>
            <a:off x="82550" y="3639882"/>
            <a:ext cx="6565129" cy="2728844"/>
            <a:chOff x="82550" y="3048639"/>
            <a:chExt cx="6565129" cy="2728844"/>
          </a:xfrm>
        </p:grpSpPr>
        <p:pic>
          <p:nvPicPr>
            <p:cNvPr id="42" name="Graphic 41">
              <a:extLst>
                <a:ext uri="{FF2B5EF4-FFF2-40B4-BE49-F238E27FC236}">
                  <a16:creationId xmlns:a16="http://schemas.microsoft.com/office/drawing/2014/main" id="{E9AB1D68-7CBF-C50D-CCC5-1A8F55904D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378457" y="3903319"/>
              <a:ext cx="1349530" cy="548247"/>
            </a:xfrm>
            <a:prstGeom prst="rect">
              <a:avLst/>
            </a:prstGeom>
          </p:spPr>
        </p:pic>
        <p:pic>
          <p:nvPicPr>
            <p:cNvPr id="44" name="Graphic 43">
              <a:extLst>
                <a:ext uri="{FF2B5EF4-FFF2-40B4-BE49-F238E27FC236}">
                  <a16:creationId xmlns:a16="http://schemas.microsoft.com/office/drawing/2014/main" id="{DB98D401-503D-8BF7-8528-5CDE9F07E9A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78457" y="4900307"/>
              <a:ext cx="1349532" cy="537704"/>
            </a:xfrm>
            <a:prstGeom prst="rect">
              <a:avLst/>
            </a:prstGeom>
          </p:spPr>
        </p:pic>
        <p:pic>
          <p:nvPicPr>
            <p:cNvPr id="46" name="Graphic 45">
              <a:extLst>
                <a:ext uri="{FF2B5EF4-FFF2-40B4-BE49-F238E27FC236}">
                  <a16:creationId xmlns:a16="http://schemas.microsoft.com/office/drawing/2014/main" id="{8C66190A-E8D0-2BAF-1BDB-C1707420670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2003793" y="3903319"/>
              <a:ext cx="1349530" cy="548247"/>
            </a:xfrm>
            <a:prstGeom prst="rect">
              <a:avLst/>
            </a:prstGeom>
          </p:spPr>
        </p:pic>
        <p:pic>
          <p:nvPicPr>
            <p:cNvPr id="48" name="Graphic 47">
              <a:extLst>
                <a:ext uri="{FF2B5EF4-FFF2-40B4-BE49-F238E27FC236}">
                  <a16:creationId xmlns:a16="http://schemas.microsoft.com/office/drawing/2014/main" id="{3F6A5EC4-B72D-5533-DA2F-C56E3A74EC3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2003793" y="4900307"/>
              <a:ext cx="1349532" cy="537704"/>
            </a:xfrm>
            <a:prstGeom prst="rect">
              <a:avLst/>
            </a:prstGeom>
          </p:spPr>
        </p:pic>
        <p:pic>
          <p:nvPicPr>
            <p:cNvPr id="53" name="Graphic 52">
              <a:extLst>
                <a:ext uri="{FF2B5EF4-FFF2-40B4-BE49-F238E27FC236}">
                  <a16:creationId xmlns:a16="http://schemas.microsoft.com/office/drawing/2014/main" id="{5724B702-271A-EF48-384C-7561C609540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tretch>
              <a:fillRect/>
            </a:stretch>
          </p:blipFill>
          <p:spPr>
            <a:xfrm>
              <a:off x="3629129" y="3903319"/>
              <a:ext cx="1349532" cy="537704"/>
            </a:xfrm>
            <a:prstGeom prst="rect">
              <a:avLst/>
            </a:prstGeom>
          </p:spPr>
        </p:pic>
        <p:pic>
          <p:nvPicPr>
            <p:cNvPr id="55" name="Graphic 54">
              <a:extLst>
                <a:ext uri="{FF2B5EF4-FFF2-40B4-BE49-F238E27FC236}">
                  <a16:creationId xmlns:a16="http://schemas.microsoft.com/office/drawing/2014/main" id="{C8D10C9C-7E02-3A6A-93D8-A23F486C6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p:blipFill>
          <p:spPr>
            <a:xfrm>
              <a:off x="3629129" y="4900307"/>
              <a:ext cx="1349532" cy="537704"/>
            </a:xfrm>
            <a:prstGeom prst="rect">
              <a:avLst/>
            </a:prstGeom>
          </p:spPr>
        </p:pic>
        <p:pic>
          <p:nvPicPr>
            <p:cNvPr id="57" name="Graphic 56">
              <a:extLst>
                <a:ext uri="{FF2B5EF4-FFF2-40B4-BE49-F238E27FC236}">
                  <a16:creationId xmlns:a16="http://schemas.microsoft.com/office/drawing/2014/main" id="{5633DA17-F12F-E9B6-8328-403B692268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96DAC541-7B7A-43D3-8B79-37D633B846F1}">
                  <asvg:svgBlip xmlns:asvg="http://schemas.microsoft.com/office/drawing/2016/SVG/main" r:embed="rId15"/>
                </a:ext>
              </a:extLst>
            </a:blip>
            <a:stretch>
              <a:fillRect/>
            </a:stretch>
          </p:blipFill>
          <p:spPr>
            <a:xfrm>
              <a:off x="5254466" y="3903319"/>
              <a:ext cx="1349532" cy="537704"/>
            </a:xfrm>
            <a:prstGeom prst="rect">
              <a:avLst/>
            </a:prstGeom>
          </p:spPr>
        </p:pic>
        <p:pic>
          <p:nvPicPr>
            <p:cNvPr id="67" name="Graphic 66">
              <a:extLst>
                <a:ext uri="{FF2B5EF4-FFF2-40B4-BE49-F238E27FC236}">
                  <a16:creationId xmlns:a16="http://schemas.microsoft.com/office/drawing/2014/main" id="{373E3184-842B-26F6-A620-EB377EBD95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96DAC541-7B7A-43D3-8B79-37D633B846F1}">
                  <asvg:svgBlip xmlns:asvg="http://schemas.microsoft.com/office/drawing/2016/SVG/main" r:embed="rId17"/>
                </a:ext>
              </a:extLst>
            </a:blip>
            <a:stretch>
              <a:fillRect/>
            </a:stretch>
          </p:blipFill>
          <p:spPr>
            <a:xfrm>
              <a:off x="5254466" y="4900307"/>
              <a:ext cx="1349532" cy="537704"/>
            </a:xfrm>
            <a:prstGeom prst="rect">
              <a:avLst/>
            </a:prstGeom>
          </p:spPr>
        </p:pic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94A9858B-F67C-E0B3-7759-E9FB2C8F49B1}"/>
                </a:ext>
              </a:extLst>
            </p:cNvPr>
            <p:cNvGrpSpPr/>
            <p:nvPr/>
          </p:nvGrpSpPr>
          <p:grpSpPr>
            <a:xfrm>
              <a:off x="82550" y="5056995"/>
              <a:ext cx="704925" cy="720488"/>
              <a:chOff x="97824" y="5530674"/>
              <a:chExt cx="704925" cy="720488"/>
            </a:xfrm>
          </p:grpSpPr>
          <p:cxnSp>
            <p:nvCxnSpPr>
              <p:cNvPr id="68" name="Straight Arrow Connector 67">
                <a:extLst>
                  <a:ext uri="{FF2B5EF4-FFF2-40B4-BE49-F238E27FC236}">
                    <a16:creationId xmlns:a16="http://schemas.microsoft.com/office/drawing/2014/main" id="{7BDCA23F-0209-3704-A593-A8CC4696875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id="{D8A64A9F-FB74-C345-0607-564EE70D31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C3BC2AD2-2164-3496-7B83-F78A22063CBB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19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01E3E934-EF7A-DEC8-D361-3A06E4E0B7D2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FN-</a:t>
                </a:r>
                <a:r>
                  <a:rPr lang="el-GR" sz="7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γ</a:t>
                </a:r>
                <a:endParaRPr lang="en-US" sz="700" dirty="0">
                  <a:latin typeface="Arial Rounded MT Bold" pitchFamily="34" charset="0"/>
                </a:endParaRPr>
              </a:p>
            </p:txBody>
          </p: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9FD076AC-26CC-61A7-7AEC-BC3F390729C3}"/>
                </a:ext>
              </a:extLst>
            </p:cNvPr>
            <p:cNvGrpSpPr/>
            <p:nvPr/>
          </p:nvGrpSpPr>
          <p:grpSpPr>
            <a:xfrm>
              <a:off x="1716895" y="5056995"/>
              <a:ext cx="704925" cy="720488"/>
              <a:chOff x="97824" y="5530674"/>
              <a:chExt cx="704925" cy="720488"/>
            </a:xfrm>
          </p:grpSpPr>
          <p:cxnSp>
            <p:nvCxnSpPr>
              <p:cNvPr id="81" name="Straight Arrow Connector 80">
                <a:extLst>
                  <a:ext uri="{FF2B5EF4-FFF2-40B4-BE49-F238E27FC236}">
                    <a16:creationId xmlns:a16="http://schemas.microsoft.com/office/drawing/2014/main" id="{E6D330C8-D27C-CD32-370A-CFB059B7ABE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Arrow Connector 82">
                <a:extLst>
                  <a:ext uri="{FF2B5EF4-FFF2-40B4-BE49-F238E27FC236}">
                    <a16:creationId xmlns:a16="http://schemas.microsoft.com/office/drawing/2014/main" id="{9B23750F-BF0C-DE61-C243-478E5C1057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BC0F54E4-63B1-E7C4-21E2-B32F75FC69A3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19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34FA3A57-8DED-A022-5DF1-E7C495196E5C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TNF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700" dirty="0">
                  <a:latin typeface="Arial Rounded MT Bold" pitchFamily="34" charset="0"/>
                </a:endParaRP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3BFE8511-ABEA-3C41-D1D8-AD54DFB08D45}"/>
                </a:ext>
              </a:extLst>
            </p:cNvPr>
            <p:cNvGrpSpPr/>
            <p:nvPr/>
          </p:nvGrpSpPr>
          <p:grpSpPr>
            <a:xfrm>
              <a:off x="3342472" y="5056995"/>
              <a:ext cx="704925" cy="720488"/>
              <a:chOff x="97824" y="5530674"/>
              <a:chExt cx="704925" cy="720488"/>
            </a:xfrm>
          </p:grpSpPr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30BF7708-2CA9-2D49-920F-28991893BCB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Arrow Connector 88">
                <a:extLst>
                  <a:ext uri="{FF2B5EF4-FFF2-40B4-BE49-F238E27FC236}">
                    <a16:creationId xmlns:a16="http://schemas.microsoft.com/office/drawing/2014/main" id="{FF8B1507-DC06-2D5C-CECE-911783487B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BAD241BD-B76B-E666-840F-02BC7F6EA57E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19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7FFF69A3-E15F-EED4-BE84-A0951F41014B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L-17</a:t>
                </a:r>
              </a:p>
            </p:txBody>
          </p:sp>
        </p:grp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C5D10EBE-7D70-E082-8776-8AB557EF223C}"/>
                </a:ext>
              </a:extLst>
            </p:cNvPr>
            <p:cNvGrpSpPr/>
            <p:nvPr/>
          </p:nvGrpSpPr>
          <p:grpSpPr>
            <a:xfrm>
              <a:off x="4964182" y="5056995"/>
              <a:ext cx="704925" cy="720488"/>
              <a:chOff x="97824" y="5530674"/>
              <a:chExt cx="704925" cy="720488"/>
            </a:xfrm>
          </p:grpSpPr>
          <p:cxnSp>
            <p:nvCxnSpPr>
              <p:cNvPr id="93" name="Straight Arrow Connector 92">
                <a:extLst>
                  <a:ext uri="{FF2B5EF4-FFF2-40B4-BE49-F238E27FC236}">
                    <a16:creationId xmlns:a16="http://schemas.microsoft.com/office/drawing/2014/main" id="{A1EE3DC0-56B7-8D91-90B1-464EAAD6A8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Arrow Connector 93">
                <a:extLst>
                  <a:ext uri="{FF2B5EF4-FFF2-40B4-BE49-F238E27FC236}">
                    <a16:creationId xmlns:a16="http://schemas.microsoft.com/office/drawing/2014/main" id="{95539401-1C1F-B03E-0E3C-EC26A4AB79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23A395D-8400-109F-F6C7-79837397267B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19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58E44451-8184-74D6-F938-A87250F9B718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L-10</a:t>
                </a:r>
              </a:p>
            </p:txBody>
          </p:sp>
        </p:grp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4F4CE57B-6158-D66C-5A22-2BDE3DB30F53}"/>
                </a:ext>
              </a:extLst>
            </p:cNvPr>
            <p:cNvSpPr txBox="1"/>
            <p:nvPr/>
          </p:nvSpPr>
          <p:spPr>
            <a:xfrm>
              <a:off x="311084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6A1458E-B070-DF9D-08DB-BF3F41E65E7A}"/>
                </a:ext>
              </a:extLst>
            </p:cNvPr>
            <p:cNvSpPr txBox="1"/>
            <p:nvPr/>
          </p:nvSpPr>
          <p:spPr>
            <a:xfrm>
              <a:off x="334372" y="4699811"/>
              <a:ext cx="7507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4E4EA8C-848F-0F68-0313-F81FB56B12D6}"/>
                </a:ext>
              </a:extLst>
            </p:cNvPr>
            <p:cNvSpPr txBox="1"/>
            <p:nvPr/>
          </p:nvSpPr>
          <p:spPr>
            <a:xfrm>
              <a:off x="1008216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F-Treg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E081C8B-0D3A-7BFD-E000-2C1EEC635EE6}"/>
                </a:ext>
              </a:extLst>
            </p:cNvPr>
            <p:cNvSpPr txBox="1"/>
            <p:nvPr/>
          </p:nvSpPr>
          <p:spPr>
            <a:xfrm>
              <a:off x="1094102" y="4699811"/>
              <a:ext cx="6386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Exp-Treg</a:t>
              </a:r>
              <a:endParaRPr lang="en-US" sz="700" baseline="-25000" dirty="0">
                <a:latin typeface="Arial Rounded MT Bold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86CBBFD-E515-E993-7B4C-5D8AB6B38B50}"/>
                </a:ext>
              </a:extLst>
            </p:cNvPr>
            <p:cNvSpPr txBox="1"/>
            <p:nvPr/>
          </p:nvSpPr>
          <p:spPr>
            <a:xfrm>
              <a:off x="1924307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4DDB869-B8DC-32E4-7F5F-0A78A284A7AF}"/>
                </a:ext>
              </a:extLst>
            </p:cNvPr>
            <p:cNvSpPr txBox="1"/>
            <p:nvPr/>
          </p:nvSpPr>
          <p:spPr>
            <a:xfrm>
              <a:off x="1984221" y="4699811"/>
              <a:ext cx="69974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1FF1FCF4-AB42-2B60-9CF1-026732B2B0B0}"/>
                </a:ext>
              </a:extLst>
            </p:cNvPr>
            <p:cNvSpPr txBox="1"/>
            <p:nvPr/>
          </p:nvSpPr>
          <p:spPr>
            <a:xfrm>
              <a:off x="2640098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F-Treg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C51D73C6-DE3B-3366-6707-4E8D3A3E1C06}"/>
                </a:ext>
              </a:extLst>
            </p:cNvPr>
            <p:cNvSpPr txBox="1"/>
            <p:nvPr/>
          </p:nvSpPr>
          <p:spPr>
            <a:xfrm>
              <a:off x="2713343" y="4699811"/>
              <a:ext cx="6386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Exp-Treg</a:t>
              </a:r>
              <a:endParaRPr lang="en-US" sz="700" baseline="-25000" dirty="0">
                <a:latin typeface="Arial Rounded MT Bold" pitchFamily="34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2F3E4339-412E-A704-5CC7-796406FC4492}"/>
                </a:ext>
              </a:extLst>
            </p:cNvPr>
            <p:cNvSpPr txBox="1"/>
            <p:nvPr/>
          </p:nvSpPr>
          <p:spPr>
            <a:xfrm>
              <a:off x="3559401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C033A2E-D171-0566-76E1-9B333DFD540F}"/>
                </a:ext>
              </a:extLst>
            </p:cNvPr>
            <p:cNvSpPr txBox="1"/>
            <p:nvPr/>
          </p:nvSpPr>
          <p:spPr>
            <a:xfrm>
              <a:off x="3604802" y="4699811"/>
              <a:ext cx="6924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F663C2CD-B328-E579-56C8-0D7D218FB847}"/>
                </a:ext>
              </a:extLst>
            </p:cNvPr>
            <p:cNvSpPr txBox="1"/>
            <p:nvPr/>
          </p:nvSpPr>
          <p:spPr>
            <a:xfrm>
              <a:off x="4243303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F-Treg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B7CAE794-5414-CBD9-3BB8-8C902B7859B0}"/>
                </a:ext>
              </a:extLst>
            </p:cNvPr>
            <p:cNvSpPr txBox="1"/>
            <p:nvPr/>
          </p:nvSpPr>
          <p:spPr>
            <a:xfrm>
              <a:off x="4354102" y="4699811"/>
              <a:ext cx="6386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Exp-Treg</a:t>
              </a:r>
              <a:endParaRPr lang="en-US" sz="700" baseline="-25000" dirty="0">
                <a:latin typeface="Arial Rounded MT Bold" pitchFamily="34" charset="0"/>
              </a:endParaRP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0626F8D1-CD88-A251-5184-3FB53FE1C3D6}"/>
                </a:ext>
              </a:extLst>
            </p:cNvPr>
            <p:cNvSpPr txBox="1"/>
            <p:nvPr/>
          </p:nvSpPr>
          <p:spPr>
            <a:xfrm>
              <a:off x="5184794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38759CCF-29CA-0401-4AF1-FB2D2B903D57}"/>
                </a:ext>
              </a:extLst>
            </p:cNvPr>
            <p:cNvSpPr txBox="1"/>
            <p:nvPr/>
          </p:nvSpPr>
          <p:spPr>
            <a:xfrm>
              <a:off x="5205350" y="4699811"/>
              <a:ext cx="704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alone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F1684BDB-610C-FAE0-A0C0-3E7F27F25F88}"/>
                </a:ext>
              </a:extLst>
            </p:cNvPr>
            <p:cNvSpPr txBox="1"/>
            <p:nvPr/>
          </p:nvSpPr>
          <p:spPr>
            <a:xfrm>
              <a:off x="5851768" y="3702822"/>
              <a:ext cx="7959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F-Treg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02125A9B-6D52-1EA1-03EE-C7EFDD501077}"/>
                </a:ext>
              </a:extLst>
            </p:cNvPr>
            <p:cNvSpPr txBox="1"/>
            <p:nvPr/>
          </p:nvSpPr>
          <p:spPr>
            <a:xfrm>
              <a:off x="5955811" y="4699811"/>
              <a:ext cx="6386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+Exp-Treg</a:t>
              </a:r>
              <a:endParaRPr lang="en-US" sz="700" baseline="-25000" dirty="0">
                <a:latin typeface="Arial Rounded MT Bold" pitchFamily="34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54E5D4-3946-3EEB-5034-B7AA7818130C}"/>
                </a:ext>
              </a:extLst>
            </p:cNvPr>
            <p:cNvSpPr txBox="1"/>
            <p:nvPr/>
          </p:nvSpPr>
          <p:spPr>
            <a:xfrm>
              <a:off x="2410113" y="3444854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TNF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900" dirty="0">
                <a:latin typeface="Arial Rounded MT Bold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3E26894-FD1D-ABFB-2EB0-53482D4C4FD6}"/>
                </a:ext>
              </a:extLst>
            </p:cNvPr>
            <p:cNvSpPr txBox="1"/>
            <p:nvPr/>
          </p:nvSpPr>
          <p:spPr>
            <a:xfrm>
              <a:off x="810776" y="3444854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FN-</a:t>
              </a:r>
              <a:r>
                <a:rPr lang="el-GR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endParaRPr lang="en-US" sz="900" dirty="0">
                <a:latin typeface="Arial Rounded MT Bold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266F5AF-0E04-E0A9-6DF6-789107719A1C}"/>
                </a:ext>
              </a:extLst>
            </p:cNvPr>
            <p:cNvSpPr txBox="1"/>
            <p:nvPr/>
          </p:nvSpPr>
          <p:spPr>
            <a:xfrm>
              <a:off x="4018143" y="3444854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L-17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F1ADD18-F46F-A762-F835-9AA7061E45F2}"/>
                </a:ext>
              </a:extLst>
            </p:cNvPr>
            <p:cNvSpPr txBox="1"/>
            <p:nvPr/>
          </p:nvSpPr>
          <p:spPr>
            <a:xfrm>
              <a:off x="5676741" y="3444854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L-10</a:t>
              </a:r>
            </a:p>
          </p:txBody>
        </p:sp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A865D424-BAD2-9E5D-6B37-025C5A870B25}"/>
                </a:ext>
              </a:extLst>
            </p:cNvPr>
            <p:cNvSpPr txBox="1"/>
            <p:nvPr/>
          </p:nvSpPr>
          <p:spPr>
            <a:xfrm>
              <a:off x="125569" y="3048639"/>
              <a:ext cx="371030" cy="2155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5000"/>
                </a:lnSpc>
                <a:spcAft>
                  <a:spcPts val="800"/>
                </a:spcAft>
              </a:pPr>
              <a:r>
                <a:rPr lang="en-GB" sz="8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)</a:t>
              </a:r>
              <a:endPara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6">
              <a:extLst>
                <a:ext uri="{FF2B5EF4-FFF2-40B4-BE49-F238E27FC236}">
                  <a16:creationId xmlns:a16="http://schemas.microsoft.com/office/drawing/2014/main" id="{5C22A221-6F03-DAF4-D917-EB75AF7920C9}"/>
                </a:ext>
              </a:extLst>
            </p:cNvPr>
            <p:cNvSpPr txBox="1"/>
            <p:nvPr/>
          </p:nvSpPr>
          <p:spPr>
            <a:xfrm>
              <a:off x="401017" y="3160334"/>
              <a:ext cx="1707381" cy="2618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5000"/>
                </a:lnSpc>
                <a:spcAft>
                  <a:spcPts val="800"/>
                </a:spcAft>
              </a:pPr>
              <a:r>
                <a:rPr lang="en-GB" sz="105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ted on B cells</a:t>
              </a:r>
              <a:endParaRPr lang="en-GB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ADF571AA-05CC-1B94-4999-2BA89ED4F450}"/>
              </a:ext>
            </a:extLst>
          </p:cNvPr>
          <p:cNvSpPr txBox="1"/>
          <p:nvPr/>
        </p:nvSpPr>
        <p:spPr>
          <a:xfrm>
            <a:off x="1760849" y="2646274"/>
            <a:ext cx="32843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Strategy for the activation of B cells and co-culture with Tregs</a:t>
            </a:r>
          </a:p>
        </p:txBody>
      </p:sp>
      <p:sp>
        <p:nvSpPr>
          <p:cNvPr id="37" name="TextBox 6">
            <a:extLst>
              <a:ext uri="{FF2B5EF4-FFF2-40B4-BE49-F238E27FC236}">
                <a16:creationId xmlns:a16="http://schemas.microsoft.com/office/drawing/2014/main" id="{02270A85-E596-1CC6-8EEE-4D51097AFD21}"/>
              </a:ext>
            </a:extLst>
          </p:cNvPr>
          <p:cNvSpPr txBox="1"/>
          <p:nvPr/>
        </p:nvSpPr>
        <p:spPr>
          <a:xfrm>
            <a:off x="125569" y="2603539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0" name="Picture 39" descr="A diagram of a molecule">
            <a:extLst>
              <a:ext uri="{FF2B5EF4-FFF2-40B4-BE49-F238E27FC236}">
                <a16:creationId xmlns:a16="http://schemas.microsoft.com/office/drawing/2014/main" id="{1348D30B-CE02-99A2-6A4E-5465CC0F3E9D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714" y="2870384"/>
            <a:ext cx="2535872" cy="86955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0D6D08E-7F18-75B5-6F82-31386D5A30E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887477" y="644709"/>
            <a:ext cx="2768602" cy="207369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233F325-BA06-8F5E-78E1-C961739BD74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11084" y="340107"/>
            <a:ext cx="3494150" cy="2262990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3AF61089-7960-860D-A7C7-43119405AB5A}"/>
              </a:ext>
            </a:extLst>
          </p:cNvPr>
          <p:cNvGrpSpPr/>
          <p:nvPr/>
        </p:nvGrpSpPr>
        <p:grpSpPr>
          <a:xfrm>
            <a:off x="447930" y="6337528"/>
            <a:ext cx="5857456" cy="2094556"/>
            <a:chOff x="447930" y="6337528"/>
            <a:chExt cx="5857456" cy="2094556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57B8EF8-5806-B397-9464-3FD6677E29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816192" y="6337528"/>
              <a:ext cx="1489194" cy="209455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9A625CD-46A5-8649-D5ED-5DC31FD761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461650" y="6607791"/>
              <a:ext cx="1393511" cy="182429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4C10F0E-A70C-CB93-51C2-D3557E9B73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928931" y="6368712"/>
              <a:ext cx="1481451" cy="206337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BF1DF0D-1F8D-F9B2-5E04-74E7D2AD50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47930" y="6857267"/>
              <a:ext cx="1455071" cy="1574817"/>
            </a:xfrm>
            <a:prstGeom prst="rect">
              <a:avLst/>
            </a:prstGeom>
          </p:spPr>
        </p:pic>
      </p:grpSp>
      <p:sp>
        <p:nvSpPr>
          <p:cNvPr id="13" name="TextBox 6">
            <a:extLst>
              <a:ext uri="{FF2B5EF4-FFF2-40B4-BE49-F238E27FC236}">
                <a16:creationId xmlns:a16="http://schemas.microsoft.com/office/drawing/2014/main" id="{F04C5A1D-BF98-481A-5B44-0B95F4736D42}"/>
              </a:ext>
            </a:extLst>
          </p:cNvPr>
          <p:cNvSpPr txBox="1"/>
          <p:nvPr/>
        </p:nvSpPr>
        <p:spPr>
          <a:xfrm>
            <a:off x="130537" y="6438897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5505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311E55AE-1DC3-23C5-574E-D426735DED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543" y="5403683"/>
            <a:ext cx="2240124" cy="145734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BCD8E1-3276-4897-FF6E-50157E346956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2 </a:t>
            </a:r>
          </a:p>
        </p:txBody>
      </p:sp>
      <p:sp>
        <p:nvSpPr>
          <p:cNvPr id="3" name="TextBox 6">
            <a:extLst>
              <a:ext uri="{FF2B5EF4-FFF2-40B4-BE49-F238E27FC236}">
                <a16:creationId xmlns:a16="http://schemas.microsoft.com/office/drawing/2014/main" id="{C43014C5-D19A-F133-D4EF-4F64B5A1A68E}"/>
              </a:ext>
            </a:extLst>
          </p:cNvPr>
          <p:cNvSpPr txBox="1"/>
          <p:nvPr/>
        </p:nvSpPr>
        <p:spPr>
          <a:xfrm>
            <a:off x="3297487" y="5353451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6">
            <a:extLst>
              <a:ext uri="{FF2B5EF4-FFF2-40B4-BE49-F238E27FC236}">
                <a16:creationId xmlns:a16="http://schemas.microsoft.com/office/drawing/2014/main" id="{D925FC4D-CD22-9725-4889-5C988CD56839}"/>
              </a:ext>
            </a:extLst>
          </p:cNvPr>
          <p:cNvSpPr txBox="1"/>
          <p:nvPr/>
        </p:nvSpPr>
        <p:spPr>
          <a:xfrm>
            <a:off x="951506" y="7115726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94DDB79D-78F2-95F1-FFE7-C870E4C8414C}"/>
              </a:ext>
            </a:extLst>
          </p:cNvPr>
          <p:cNvSpPr txBox="1"/>
          <p:nvPr/>
        </p:nvSpPr>
        <p:spPr>
          <a:xfrm>
            <a:off x="3297487" y="7099824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6098BDE-344D-A342-AD98-8EA781878F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7578" y="5311800"/>
            <a:ext cx="2873508" cy="1547004"/>
          </a:xfrm>
          <a:prstGeom prst="rect">
            <a:avLst/>
          </a:prstGeom>
        </p:spPr>
      </p:pic>
      <p:sp>
        <p:nvSpPr>
          <p:cNvPr id="11" name="TextBox 6">
            <a:extLst>
              <a:ext uri="{FF2B5EF4-FFF2-40B4-BE49-F238E27FC236}">
                <a16:creationId xmlns:a16="http://schemas.microsoft.com/office/drawing/2014/main" id="{82674994-E8BD-B480-5E4F-1BA260DE290E}"/>
              </a:ext>
            </a:extLst>
          </p:cNvPr>
          <p:cNvSpPr txBox="1"/>
          <p:nvPr/>
        </p:nvSpPr>
        <p:spPr>
          <a:xfrm>
            <a:off x="1053451" y="5353450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6794AD4-0D13-044D-E25A-C83B813CC8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5564" y="7084844"/>
            <a:ext cx="2199986" cy="200977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A9B7899-3CA4-F2F6-7BDF-F3DE5378C7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3228" y="7631649"/>
            <a:ext cx="2083624" cy="146297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C8D003F-A5E8-3831-8B17-E1FC8B8DEE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18968" y="581374"/>
            <a:ext cx="3239032" cy="1432573"/>
          </a:xfrm>
          <a:prstGeom prst="rect">
            <a:avLst/>
          </a:prstGeom>
        </p:spPr>
      </p:pic>
      <p:sp>
        <p:nvSpPr>
          <p:cNvPr id="19" name="TextBox 6">
            <a:extLst>
              <a:ext uri="{FF2B5EF4-FFF2-40B4-BE49-F238E27FC236}">
                <a16:creationId xmlns:a16="http://schemas.microsoft.com/office/drawing/2014/main" id="{6FEA1A09-3B88-9954-5FC0-D96DD6136C41}"/>
              </a:ext>
            </a:extLst>
          </p:cNvPr>
          <p:cNvSpPr txBox="1"/>
          <p:nvPr/>
        </p:nvSpPr>
        <p:spPr>
          <a:xfrm>
            <a:off x="3519636" y="544451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3" name="Graphic 22">
            <a:extLst>
              <a:ext uri="{FF2B5EF4-FFF2-40B4-BE49-F238E27FC236}">
                <a16:creationId xmlns:a16="http://schemas.microsoft.com/office/drawing/2014/main" id="{D7F9AD1F-CFE4-D7C3-9A33-B268D5219EA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18846" y="615605"/>
            <a:ext cx="3438125" cy="1398342"/>
          </a:xfrm>
          <a:prstGeom prst="rect">
            <a:avLst/>
          </a:prstGeom>
        </p:spPr>
      </p:pic>
      <p:sp>
        <p:nvSpPr>
          <p:cNvPr id="24" name="TextBox 6">
            <a:extLst>
              <a:ext uri="{FF2B5EF4-FFF2-40B4-BE49-F238E27FC236}">
                <a16:creationId xmlns:a16="http://schemas.microsoft.com/office/drawing/2014/main" id="{47B69845-DB24-461C-2692-0DCB6B3BB8CC}"/>
              </a:ext>
            </a:extLst>
          </p:cNvPr>
          <p:cNvSpPr txBox="1"/>
          <p:nvPr/>
        </p:nvSpPr>
        <p:spPr>
          <a:xfrm>
            <a:off x="0" y="544452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0" name="Graphic 29">
            <a:extLst>
              <a:ext uri="{FF2B5EF4-FFF2-40B4-BE49-F238E27FC236}">
                <a16:creationId xmlns:a16="http://schemas.microsoft.com/office/drawing/2014/main" id="{3730E0E5-5665-EEA6-7C93-7AFAE03DDDF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736383" y="2404441"/>
            <a:ext cx="4958334" cy="2725191"/>
          </a:xfrm>
          <a:prstGeom prst="rect">
            <a:avLst/>
          </a:prstGeom>
        </p:spPr>
      </p:pic>
      <p:sp>
        <p:nvSpPr>
          <p:cNvPr id="31" name="TextBox 6">
            <a:extLst>
              <a:ext uri="{FF2B5EF4-FFF2-40B4-BE49-F238E27FC236}">
                <a16:creationId xmlns:a16="http://schemas.microsoft.com/office/drawing/2014/main" id="{210F9B54-CAEE-5B46-6E86-CCDE9E48005D}"/>
              </a:ext>
            </a:extLst>
          </p:cNvPr>
          <p:cNvSpPr txBox="1"/>
          <p:nvPr/>
        </p:nvSpPr>
        <p:spPr>
          <a:xfrm>
            <a:off x="0" y="2304349"/>
            <a:ext cx="312361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endParaRPr lang="en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0494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868721-2264-7916-32C5-49806995C4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B08A913-A95A-7D94-4E0A-FB3C7D98EA4A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3 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B6DF23C-D9BD-D61C-19C3-2B0970596394}"/>
              </a:ext>
            </a:extLst>
          </p:cNvPr>
          <p:cNvGrpSpPr/>
          <p:nvPr/>
        </p:nvGrpSpPr>
        <p:grpSpPr>
          <a:xfrm>
            <a:off x="174109" y="812149"/>
            <a:ext cx="6532822" cy="4882723"/>
            <a:chOff x="174109" y="812149"/>
            <a:chExt cx="6532822" cy="488272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4CE11B1-7862-4EAC-B3FB-41ED20584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893" r="14391"/>
            <a:stretch>
              <a:fillRect/>
            </a:stretch>
          </p:blipFill>
          <p:spPr>
            <a:xfrm>
              <a:off x="423863" y="883920"/>
              <a:ext cx="5276850" cy="481095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99D8300-744A-65F8-C961-04A9B07248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62280" y="812149"/>
              <a:ext cx="944651" cy="151727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F1B74D8-F23E-1E3B-E95E-E6BA847DD3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22049" y="2329428"/>
              <a:ext cx="975356" cy="155549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321DFF9-C4EB-EEC7-8BDE-5303990757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07779" y="4067173"/>
              <a:ext cx="993279" cy="1344066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180DA4D-9E98-3338-1843-6891D7146608}"/>
                </a:ext>
              </a:extLst>
            </p:cNvPr>
            <p:cNvSpPr txBox="1"/>
            <p:nvPr/>
          </p:nvSpPr>
          <p:spPr>
            <a:xfrm rot="16200000">
              <a:off x="-171491" y="3081338"/>
              <a:ext cx="9444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n-US" sz="1000" b="1" dirty="0">
                  <a:latin typeface="Symbol" panose="05050102010706020507" pitchFamily="18" charset="2"/>
                  <a:cs typeface="Helvetica" panose="020B0604020202020204" pitchFamily="34" charset="0"/>
                </a:rPr>
                <a:t>a</a:t>
              </a:r>
              <a:r>
                <a:rPr lang="en-US" sz="1000" b="1" baseline="30000" dirty="0">
                  <a:latin typeface="Symbol" panose="05050102010706020507" pitchFamily="18" charset="2"/>
                  <a:cs typeface="Helvetica" panose="020B0604020202020204" pitchFamily="34" charset="0"/>
                </a:rPr>
                <a:t>+</a:t>
              </a:r>
              <a:r>
                <a:rPr lang="en-US" sz="1000" b="1" dirty="0">
                  <a:latin typeface="Symbol" panose="05050102010706020507" pitchFamily="18" charset="2"/>
                  <a:cs typeface="Helvetica" panose="020B0604020202020204" pitchFamily="34" charset="0"/>
                </a:rPr>
                <a:t> 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ells</a:t>
              </a:r>
              <a:endParaRPr lang="en-GB" sz="1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DA0C4E-A8E2-5BD5-2E6D-EDC72667A5DD}"/>
                </a:ext>
              </a:extLst>
            </p:cNvPr>
            <p:cNvSpPr txBox="1"/>
            <p:nvPr/>
          </p:nvSpPr>
          <p:spPr>
            <a:xfrm rot="16200000">
              <a:off x="-117411" y="1578500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FN-</a:t>
              </a:r>
              <a:r>
                <a:rPr lang="en-US" sz="1000" b="1" dirty="0">
                  <a:latin typeface="Symbol" panose="05050102010706020507" pitchFamily="18" charset="2"/>
                  <a:cs typeface="Helvetica" panose="020B0604020202020204" pitchFamily="34" charset="0"/>
                </a:rPr>
                <a:t>g</a:t>
              </a:r>
              <a:r>
                <a:rPr lang="en-US" sz="1000" b="1" baseline="30000" dirty="0">
                  <a:latin typeface="Symbol" panose="05050102010706020507" pitchFamily="18" charset="2"/>
                  <a:cs typeface="Helvetica" panose="020B0604020202020204" pitchFamily="34" charset="0"/>
                </a:rPr>
                <a:t>+</a:t>
              </a:r>
              <a:r>
                <a:rPr lang="en-US" sz="1000" b="1" dirty="0">
                  <a:latin typeface="Symbol" panose="05050102010706020507" pitchFamily="18" charset="2"/>
                  <a:cs typeface="Helvetica" panose="020B0604020202020204" pitchFamily="34" charset="0"/>
                </a:rPr>
                <a:t> 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ells</a:t>
              </a:r>
              <a:endParaRPr lang="en-GB" sz="1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C8131FE-25E8-35B4-6ED4-0BC9E7E13338}"/>
                </a:ext>
              </a:extLst>
            </p:cNvPr>
            <p:cNvSpPr txBox="1"/>
            <p:nvPr/>
          </p:nvSpPr>
          <p:spPr>
            <a:xfrm rot="16200000">
              <a:off x="-124531" y="4616095"/>
              <a:ext cx="8435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L-10</a:t>
              </a:r>
              <a:r>
                <a:rPr lang="en-US" sz="1000" b="1" baseline="30000" dirty="0">
                  <a:latin typeface="Symbol" panose="05050102010706020507" pitchFamily="18" charset="2"/>
                  <a:cs typeface="Helvetica" panose="020B0604020202020204" pitchFamily="34" charset="0"/>
                </a:rPr>
                <a:t>+</a:t>
              </a:r>
              <a:r>
                <a:rPr lang="en-US" sz="1000" b="1" dirty="0">
                  <a:latin typeface="Symbol" panose="05050102010706020507" pitchFamily="18" charset="2"/>
                  <a:cs typeface="Helvetica" panose="020B0604020202020204" pitchFamily="34" charset="0"/>
                </a:rPr>
                <a:t> 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ells</a:t>
              </a:r>
              <a:endParaRPr lang="en-GB" sz="1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66192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28A4EE-175E-2B5A-4C32-84E457F1226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3064AB-9ABD-02F2-4EAB-572B1D7F3D04}"/>
              </a:ext>
            </a:extLst>
          </p:cNvPr>
          <p:cNvSpPr txBox="1"/>
          <p:nvPr/>
        </p:nvSpPr>
        <p:spPr>
          <a:xfrm>
            <a:off x="0" y="-53286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4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FF6E67A-8F82-5458-E6C3-E476ECB234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977076"/>
              </p:ext>
            </p:extLst>
          </p:nvPr>
        </p:nvGraphicFramePr>
        <p:xfrm>
          <a:off x="390510" y="647941"/>
          <a:ext cx="6142668" cy="967484"/>
        </p:xfrm>
        <a:graphic>
          <a:graphicData uri="http://schemas.openxmlformats.org/drawingml/2006/table">
            <a:tbl>
              <a:tblPr/>
              <a:tblGrid>
                <a:gridCol w="492760">
                  <a:extLst>
                    <a:ext uri="{9D8B030D-6E8A-4147-A177-3AD203B41FA5}">
                      <a16:colId xmlns:a16="http://schemas.microsoft.com/office/drawing/2014/main" val="4163959633"/>
                    </a:ext>
                  </a:extLst>
                </a:gridCol>
                <a:gridCol w="864035">
                  <a:extLst>
                    <a:ext uri="{9D8B030D-6E8A-4147-A177-3AD203B41FA5}">
                      <a16:colId xmlns:a16="http://schemas.microsoft.com/office/drawing/2014/main" val="4245765904"/>
                    </a:ext>
                  </a:extLst>
                </a:gridCol>
                <a:gridCol w="391120">
                  <a:extLst>
                    <a:ext uri="{9D8B030D-6E8A-4147-A177-3AD203B41FA5}">
                      <a16:colId xmlns:a16="http://schemas.microsoft.com/office/drawing/2014/main" val="290750928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4174177052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2461545347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49062052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3476299372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3280558154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1942257937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3420277474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447435437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1747639364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3809660017"/>
                    </a:ext>
                  </a:extLst>
                </a:gridCol>
                <a:gridCol w="399523">
                  <a:extLst>
                    <a:ext uri="{9D8B030D-6E8A-4147-A177-3AD203B41FA5}">
                      <a16:colId xmlns:a16="http://schemas.microsoft.com/office/drawing/2014/main" val="3457628261"/>
                    </a:ext>
                  </a:extLst>
                </a:gridCol>
              </a:tblGrid>
              <a:tr h="16350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type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dition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229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5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34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-3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RP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OS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-4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200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0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3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0L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-9</a:t>
                      </a:r>
                    </a:p>
                  </a:txBody>
                  <a:tcPr marL="4809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117912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esh Tregs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timulated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4617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93E6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8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5A9E7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C96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9.3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D7A9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C4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0.1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2597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6385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0.8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E809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6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A728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E4E6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579C7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8324757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mulated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5.9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6E8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6365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71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6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AB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5F7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597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8.6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789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0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7D9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3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879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E6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64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3661804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g:B cell co-culture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564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E4E6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9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D7A9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1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E4F6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0567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0.8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5C7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8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055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0.6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E7F9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E507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0.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5B7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769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567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975098"/>
                  </a:ext>
                </a:extLst>
              </a:tr>
              <a:tr h="110606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6025382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gexp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timulated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2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C4A6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83C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4.8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3083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6.1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32869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2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F517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6365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8.6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45F7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9406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B476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83C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9416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7.3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235C7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9899450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mulated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6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3C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2.9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938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2.3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A5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2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517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3C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26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56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A6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73A5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06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2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A57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8422903"/>
                  </a:ext>
                </a:extLst>
              </a:tr>
              <a:tr h="115415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g: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ell co-culture</a:t>
                      </a:r>
                    </a:p>
                  </a:txBody>
                  <a:tcPr marL="36000" marR="4809" marT="48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5.3</a:t>
                      </a:r>
                    </a:p>
                  </a:txBody>
                  <a:tcPr marL="4809" marR="4809" marT="48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1587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A426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9.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9F7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527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055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4.7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083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5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C496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8.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B758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93E6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2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A436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1</a:t>
                      </a:r>
                    </a:p>
                  </a:txBody>
                  <a:tcPr marL="4809" marR="4809" marT="48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E1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0938406"/>
                  </a:ext>
                </a:extLst>
              </a:tr>
            </a:tbl>
          </a:graphicData>
        </a:graphic>
      </p:graphicFrame>
      <p:grpSp>
        <p:nvGrpSpPr>
          <p:cNvPr id="30" name="Group 29">
            <a:extLst>
              <a:ext uri="{FF2B5EF4-FFF2-40B4-BE49-F238E27FC236}">
                <a16:creationId xmlns:a16="http://schemas.microsoft.com/office/drawing/2014/main" id="{E88DE36A-C750-0340-B533-5D1625B3DC1F}"/>
              </a:ext>
            </a:extLst>
          </p:cNvPr>
          <p:cNvGrpSpPr/>
          <p:nvPr/>
        </p:nvGrpSpPr>
        <p:grpSpPr>
          <a:xfrm>
            <a:off x="347627" y="1968816"/>
            <a:ext cx="6142668" cy="3402389"/>
            <a:chOff x="469548" y="4529137"/>
            <a:chExt cx="3848594" cy="2686566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53F7B443-3F39-8D34-11CF-B335ECC9C63D}"/>
                </a:ext>
              </a:extLst>
            </p:cNvPr>
            <p:cNvGrpSpPr/>
            <p:nvPr/>
          </p:nvGrpSpPr>
          <p:grpSpPr>
            <a:xfrm>
              <a:off x="469548" y="4622698"/>
              <a:ext cx="3848594" cy="2593005"/>
              <a:chOff x="621806" y="4921478"/>
              <a:chExt cx="3848594" cy="2593005"/>
            </a:xfrm>
          </p:grpSpPr>
          <p:pic>
            <p:nvPicPr>
              <p:cNvPr id="5" name="Graphic 4">
                <a:extLst>
                  <a:ext uri="{FF2B5EF4-FFF2-40B4-BE49-F238E27FC236}">
                    <a16:creationId xmlns:a16="http://schemas.microsoft.com/office/drawing/2014/main" id="{BF9C6F32-1B97-111A-DFF3-F43BEA5BD4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1516062" y="5137466"/>
                <a:ext cx="828675" cy="962025"/>
              </a:xfrm>
              <a:prstGeom prst="rect">
                <a:avLst/>
              </a:prstGeom>
            </p:spPr>
          </p:pic>
          <p:pic>
            <p:nvPicPr>
              <p:cNvPr id="7" name="Graphic 6">
                <a:extLst>
                  <a:ext uri="{FF2B5EF4-FFF2-40B4-BE49-F238E27FC236}">
                    <a16:creationId xmlns:a16="http://schemas.microsoft.com/office/drawing/2014/main" id="{327FAE6F-DE4F-BEF6-025F-EB00004A7C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tretch>
                <a:fillRect/>
              </a:stretch>
            </p:blipFill>
            <p:spPr>
              <a:xfrm>
                <a:off x="2565082" y="5137466"/>
                <a:ext cx="828675" cy="962025"/>
              </a:xfrm>
              <a:prstGeom prst="rect">
                <a:avLst/>
              </a:prstGeom>
            </p:spPr>
          </p:pic>
          <p:pic>
            <p:nvPicPr>
              <p:cNvPr id="9" name="Graphic 8">
                <a:extLst>
                  <a:ext uri="{FF2B5EF4-FFF2-40B4-BE49-F238E27FC236}">
                    <a16:creationId xmlns:a16="http://schemas.microsoft.com/office/drawing/2014/main" id="{D8CF6CF2-EF08-CE8F-13A4-EDE2E424D3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3614102" y="5137466"/>
                <a:ext cx="828675" cy="962025"/>
              </a:xfrm>
              <a:prstGeom prst="rect">
                <a:avLst/>
              </a:prstGeom>
            </p:spPr>
          </p:pic>
          <p:pic>
            <p:nvPicPr>
              <p:cNvPr id="11" name="Graphic 10">
                <a:extLst>
                  <a:ext uri="{FF2B5EF4-FFF2-40B4-BE49-F238E27FC236}">
                    <a16:creationId xmlns:a16="http://schemas.microsoft.com/office/drawing/2014/main" id="{6B20B2A4-CA5D-D452-6E9A-73A8FC0403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96DAC541-7B7A-43D3-8B79-37D633B846F1}">
                    <asvg:svgBlip xmlns:asvg="http://schemas.microsoft.com/office/drawing/2016/SVG/main" r:embed="rId9"/>
                  </a:ext>
                </a:extLst>
              </a:blip>
              <a:stretch>
                <a:fillRect/>
              </a:stretch>
            </p:blipFill>
            <p:spPr>
              <a:xfrm>
                <a:off x="1516062" y="6184766"/>
                <a:ext cx="828675" cy="962025"/>
              </a:xfrm>
              <a:prstGeom prst="rect">
                <a:avLst/>
              </a:prstGeom>
            </p:spPr>
          </p:pic>
          <p:pic>
            <p:nvPicPr>
              <p:cNvPr id="13" name="Graphic 12">
                <a:extLst>
                  <a:ext uri="{FF2B5EF4-FFF2-40B4-BE49-F238E27FC236}">
                    <a16:creationId xmlns:a16="http://schemas.microsoft.com/office/drawing/2014/main" id="{5B7C4BA7-9B43-4EF6-F2A3-CEF98146C0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96DAC541-7B7A-43D3-8B79-37D633B846F1}">
                    <asvg:svgBlip xmlns:asvg="http://schemas.microsoft.com/office/drawing/2016/SVG/main" r:embed="rId11"/>
                  </a:ext>
                </a:extLst>
              </a:blip>
              <a:stretch>
                <a:fillRect/>
              </a:stretch>
            </p:blipFill>
            <p:spPr>
              <a:xfrm>
                <a:off x="2565082" y="6184766"/>
                <a:ext cx="828675" cy="962025"/>
              </a:xfrm>
              <a:prstGeom prst="rect">
                <a:avLst/>
              </a:prstGeom>
            </p:spPr>
          </p:pic>
          <p:pic>
            <p:nvPicPr>
              <p:cNvPr id="15" name="Graphic 14">
                <a:extLst>
                  <a:ext uri="{FF2B5EF4-FFF2-40B4-BE49-F238E27FC236}">
                    <a16:creationId xmlns:a16="http://schemas.microsoft.com/office/drawing/2014/main" id="{D77DB360-577B-54D3-690C-4C68DF31B9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3614102" y="6184766"/>
                <a:ext cx="828675" cy="962025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63BD92D-AD9B-A111-8E5A-11912A922FF3}"/>
                  </a:ext>
                </a:extLst>
              </p:cNvPr>
              <p:cNvSpPr txBox="1"/>
              <p:nvPr/>
            </p:nvSpPr>
            <p:spPr>
              <a:xfrm>
                <a:off x="621806" y="5510756"/>
                <a:ext cx="688009" cy="170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resh Treg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51D08E3-6E7C-2B9A-44EE-E620526EBF08}"/>
                  </a:ext>
                </a:extLst>
              </p:cNvPr>
              <p:cNvSpPr txBox="1"/>
              <p:nvPr/>
            </p:nvSpPr>
            <p:spPr>
              <a:xfrm>
                <a:off x="1537502" y="4921478"/>
                <a:ext cx="7857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Unstimulated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D5F5488A-B7AB-A15C-6BBF-1688B2380E7D}"/>
                  </a:ext>
                </a:extLst>
              </p:cNvPr>
              <p:cNvSpPr txBox="1"/>
              <p:nvPr/>
            </p:nvSpPr>
            <p:spPr>
              <a:xfrm>
                <a:off x="2643429" y="4921478"/>
                <a:ext cx="6719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timulated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5CC032D-355D-2A6D-1F8E-86171900DD32}"/>
                  </a:ext>
                </a:extLst>
              </p:cNvPr>
              <p:cNvSpPr txBox="1"/>
              <p:nvPr/>
            </p:nvSpPr>
            <p:spPr>
              <a:xfrm>
                <a:off x="3698861" y="4921478"/>
                <a:ext cx="6591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-culture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FD6E1D1-900D-BF70-6D82-61986970060D}"/>
                  </a:ext>
                </a:extLst>
              </p:cNvPr>
              <p:cNvSpPr txBox="1"/>
              <p:nvPr/>
            </p:nvSpPr>
            <p:spPr>
              <a:xfrm>
                <a:off x="621806" y="6558056"/>
                <a:ext cx="673911" cy="170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p-Treg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C372A770-115A-837B-4BDB-DD2DFCA0EDA1}"/>
                  </a:ext>
                </a:extLst>
              </p:cNvPr>
              <p:cNvCxnSpPr/>
              <p:nvPr/>
            </p:nvCxnSpPr>
            <p:spPr>
              <a:xfrm flipV="1">
                <a:off x="1343679" y="5054600"/>
                <a:ext cx="0" cy="2244591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869D785D-8D80-6103-AE5A-896F62ADAE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38599" y="7299191"/>
                <a:ext cx="3131801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8A6ABB6-7E9A-730E-9BF3-B53443A2D429}"/>
                  </a:ext>
                </a:extLst>
              </p:cNvPr>
              <p:cNvSpPr txBox="1"/>
              <p:nvPr/>
            </p:nvSpPr>
            <p:spPr>
              <a:xfrm>
                <a:off x="2663087" y="7299039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SNE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70B316A-BABF-3A3F-2371-7B4AA5D5A729}"/>
                  </a:ext>
                </a:extLst>
              </p:cNvPr>
              <p:cNvSpPr txBox="1"/>
              <p:nvPr/>
            </p:nvSpPr>
            <p:spPr>
              <a:xfrm rot="16200000">
                <a:off x="995936" y="6118972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SNE2</a:t>
                </a:r>
              </a:p>
            </p:txBody>
          </p:sp>
        </p:grpSp>
        <p:pic>
          <p:nvPicPr>
            <p:cNvPr id="29" name="Graphic 28">
              <a:extLst>
                <a:ext uri="{FF2B5EF4-FFF2-40B4-BE49-F238E27FC236}">
                  <a16:creationId xmlns:a16="http://schemas.microsoft.com/office/drawing/2014/main" id="{028A0CEC-230E-9E73-2103-711FE8BB9B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96DAC541-7B7A-43D3-8B79-37D633B846F1}">
                  <asvg:svgBlip xmlns:asvg="http://schemas.microsoft.com/office/drawing/2016/SVG/main" r:embed="rId15"/>
                </a:ext>
              </a:extLst>
            </a:blip>
            <a:stretch>
              <a:fillRect/>
            </a:stretch>
          </p:blipFill>
          <p:spPr>
            <a:xfrm>
              <a:off x="1893710" y="4529137"/>
              <a:ext cx="1866900" cy="85725"/>
            </a:xfrm>
            <a:prstGeom prst="rect">
              <a:avLst/>
            </a:prstGeom>
          </p:spPr>
        </p:pic>
      </p:grpSp>
      <p:sp>
        <p:nvSpPr>
          <p:cNvPr id="6" name="TextBox 6">
            <a:extLst>
              <a:ext uri="{FF2B5EF4-FFF2-40B4-BE49-F238E27FC236}">
                <a16:creationId xmlns:a16="http://schemas.microsoft.com/office/drawing/2014/main" id="{5AE508DB-96BE-7EDE-4724-AC6B44F81738}"/>
              </a:ext>
            </a:extLst>
          </p:cNvPr>
          <p:cNvSpPr txBox="1"/>
          <p:nvPr/>
        </p:nvSpPr>
        <p:spPr>
          <a:xfrm>
            <a:off x="125569" y="353340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1B154AD9-4B18-DA5F-403F-FC5DF4EEB88C}"/>
              </a:ext>
            </a:extLst>
          </p:cNvPr>
          <p:cNvSpPr txBox="1"/>
          <p:nvPr/>
        </p:nvSpPr>
        <p:spPr>
          <a:xfrm>
            <a:off x="125569" y="1875639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17AFE582-9DB0-C7D5-F113-754A9A5ED57A}"/>
              </a:ext>
            </a:extLst>
          </p:cNvPr>
          <p:cNvSpPr txBox="1"/>
          <p:nvPr/>
        </p:nvSpPr>
        <p:spPr>
          <a:xfrm>
            <a:off x="125569" y="5359100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E50FF7A-DA78-9E21-6C5B-5758EA3E596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85398" y="5776913"/>
            <a:ext cx="3638270" cy="247866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B6DDD78-70DB-19A0-638A-A971C13D06B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99203" y="5373389"/>
            <a:ext cx="1420470" cy="2437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38310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25C1BE-3A5C-1C29-FEE0-51D4A76AF7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98DB847-D965-9561-4E51-8F5C85C92DC2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5 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AAC0C910-65CC-D370-950C-149DD5034B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857423" y="1735045"/>
            <a:ext cx="903440" cy="1735556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5D3A7EF1-B935-1339-F7D1-7093B8AC82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990263" y="1913354"/>
            <a:ext cx="998540" cy="1557247"/>
          </a:xfrm>
          <a:prstGeom prst="rect">
            <a:avLst/>
          </a:prstGeom>
        </p:spPr>
      </p:pic>
      <p:pic>
        <p:nvPicPr>
          <p:cNvPr id="8" name="Graphic 7">
            <a:extLst>
              <a:ext uri="{FF2B5EF4-FFF2-40B4-BE49-F238E27FC236}">
                <a16:creationId xmlns:a16="http://schemas.microsoft.com/office/drawing/2014/main" id="{00DB5E75-BD69-7ACF-945A-64A8C02F2E0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4264073" y="1770706"/>
            <a:ext cx="950990" cy="1699895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687D3D76-9033-BBF8-EDBA-18B1496C59E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133475" y="5598464"/>
            <a:ext cx="933450" cy="1628775"/>
          </a:xfrm>
          <a:prstGeom prst="rect">
            <a:avLst/>
          </a:prstGeom>
        </p:spPr>
      </p:pic>
      <p:pic>
        <p:nvPicPr>
          <p:cNvPr id="12" name="Graphic 11">
            <a:extLst>
              <a:ext uri="{FF2B5EF4-FFF2-40B4-BE49-F238E27FC236}">
                <a16:creationId xmlns:a16="http://schemas.microsoft.com/office/drawing/2014/main" id="{EEFF5075-4BBF-DB4D-5865-B95E6A8284B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2365375" y="5779439"/>
            <a:ext cx="914400" cy="1447800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C3304560-B46B-B8CF-E559-5DFB7C4B545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3578225" y="5603226"/>
            <a:ext cx="981075" cy="1619250"/>
          </a:xfrm>
          <a:prstGeom prst="rect">
            <a:avLst/>
          </a:prstGeom>
        </p:spPr>
      </p:pic>
      <p:pic>
        <p:nvPicPr>
          <p:cNvPr id="16" name="Graphic 15">
            <a:extLst>
              <a:ext uri="{FF2B5EF4-FFF2-40B4-BE49-F238E27FC236}">
                <a16:creationId xmlns:a16="http://schemas.microsoft.com/office/drawing/2014/main" id="{BEB79144-BDEE-4389-A8CC-B9557C1C0F2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4857751" y="5631801"/>
            <a:ext cx="952500" cy="15621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DE3D5A08-0203-F09C-A324-B548A8A594B5}"/>
              </a:ext>
            </a:extLst>
          </p:cNvPr>
          <p:cNvSpPr txBox="1"/>
          <p:nvPr/>
        </p:nvSpPr>
        <p:spPr>
          <a:xfrm rot="16200000">
            <a:off x="414935" y="6383359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xpression (%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6AD6D3E-7DEB-1545-EBD5-C8E950A9F2C1}"/>
              </a:ext>
            </a:extLst>
          </p:cNvPr>
          <p:cNvSpPr txBox="1"/>
          <p:nvPr/>
        </p:nvSpPr>
        <p:spPr>
          <a:xfrm rot="16200000">
            <a:off x="1100784" y="2628728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xpression (%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34D7CB0-626B-43FF-08CF-B801E8DA9BC4}"/>
              </a:ext>
            </a:extLst>
          </p:cNvPr>
          <p:cNvSpPr txBox="1"/>
          <p:nvPr/>
        </p:nvSpPr>
        <p:spPr>
          <a:xfrm>
            <a:off x="1376827" y="524606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γ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5A02C4C-10E2-CD2F-57FE-7C22FB61692F}"/>
              </a:ext>
            </a:extLst>
          </p:cNvPr>
          <p:cNvSpPr txBox="1"/>
          <p:nvPr/>
        </p:nvSpPr>
        <p:spPr>
          <a:xfrm>
            <a:off x="2062675" y="131511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γ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FEB694F-8927-E2C5-619B-7FC1587598C9}"/>
              </a:ext>
            </a:extLst>
          </p:cNvPr>
          <p:cNvSpPr txBox="1"/>
          <p:nvPr/>
        </p:nvSpPr>
        <p:spPr>
          <a:xfrm>
            <a:off x="2608004" y="5246063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α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19A978F-1C3F-94F2-CB7F-8D4A9BBD7CB1}"/>
              </a:ext>
            </a:extLst>
          </p:cNvPr>
          <p:cNvSpPr txBox="1"/>
          <p:nvPr/>
        </p:nvSpPr>
        <p:spPr>
          <a:xfrm>
            <a:off x="3808935" y="5246063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AD2CCBB-7EF2-8888-809F-F2B1ACB28A0E}"/>
              </a:ext>
            </a:extLst>
          </p:cNvPr>
          <p:cNvSpPr txBox="1"/>
          <p:nvPr/>
        </p:nvSpPr>
        <p:spPr>
          <a:xfrm>
            <a:off x="5092589" y="5246063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0417578-C72D-2C34-7637-1E1D8CBA6169}"/>
              </a:ext>
            </a:extLst>
          </p:cNvPr>
          <p:cNvSpPr txBox="1"/>
          <p:nvPr/>
        </p:nvSpPr>
        <p:spPr>
          <a:xfrm>
            <a:off x="3293852" y="1315111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α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A806B38-0DD2-21D8-3D14-916334F24FDE}"/>
              </a:ext>
            </a:extLst>
          </p:cNvPr>
          <p:cNvSpPr txBox="1"/>
          <p:nvPr/>
        </p:nvSpPr>
        <p:spPr>
          <a:xfrm>
            <a:off x="4494783" y="1315111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</a:p>
        </p:txBody>
      </p:sp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C1F00FFE-8FC4-5296-A0A2-9E226E03F8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7788466"/>
              </p:ext>
            </p:extLst>
          </p:nvPr>
        </p:nvGraphicFramePr>
        <p:xfrm>
          <a:off x="1408315" y="7306296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id="{62966A52-CB8A-DA22-F5FC-58C119363C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8136574"/>
              </p:ext>
            </p:extLst>
          </p:nvPr>
        </p:nvGraphicFramePr>
        <p:xfrm>
          <a:off x="137160" y="7306296"/>
          <a:ext cx="922282" cy="685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2282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-Treg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 blocking</a:t>
                      </a:r>
                      <a:endParaRPr lang="en-GB" sz="9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1" name="Table 30">
            <a:extLst>
              <a:ext uri="{FF2B5EF4-FFF2-40B4-BE49-F238E27FC236}">
                <a16:creationId xmlns:a16="http://schemas.microsoft.com/office/drawing/2014/main" id="{47FE3E5A-E5CB-B7F2-9F69-322831D551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4722415"/>
              </p:ext>
            </p:extLst>
          </p:nvPr>
        </p:nvGraphicFramePr>
        <p:xfrm>
          <a:off x="2608004" y="7306296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FE4299FC-875B-7C38-7F5B-631FCE9FFD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8974147"/>
              </p:ext>
            </p:extLst>
          </p:nvPr>
        </p:nvGraphicFramePr>
        <p:xfrm>
          <a:off x="3869057" y="7306296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3" name="Table 32">
            <a:extLst>
              <a:ext uri="{FF2B5EF4-FFF2-40B4-BE49-F238E27FC236}">
                <a16:creationId xmlns:a16="http://schemas.microsoft.com/office/drawing/2014/main" id="{A91126BF-2713-2227-CD93-BB530A512C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9080528"/>
              </p:ext>
            </p:extLst>
          </p:nvPr>
        </p:nvGraphicFramePr>
        <p:xfrm>
          <a:off x="5130689" y="7306296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4" name="Table 33">
            <a:extLst>
              <a:ext uri="{FF2B5EF4-FFF2-40B4-BE49-F238E27FC236}">
                <a16:creationId xmlns:a16="http://schemas.microsoft.com/office/drawing/2014/main" id="{382F3110-2D03-267B-6011-D34B2EF414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3067339"/>
              </p:ext>
            </p:extLst>
          </p:nvPr>
        </p:nvGraphicFramePr>
        <p:xfrm>
          <a:off x="2079761" y="3470290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5" name="Table 34">
            <a:extLst>
              <a:ext uri="{FF2B5EF4-FFF2-40B4-BE49-F238E27FC236}">
                <a16:creationId xmlns:a16="http://schemas.microsoft.com/office/drawing/2014/main" id="{CAEFFD95-7451-72CC-3774-1667D8EAC0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1895295"/>
              </p:ext>
            </p:extLst>
          </p:nvPr>
        </p:nvGraphicFramePr>
        <p:xfrm>
          <a:off x="808606" y="3470290"/>
          <a:ext cx="922282" cy="685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2282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-Treg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 blocking</a:t>
                      </a:r>
                      <a:endParaRPr lang="en-GB" sz="9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6" name="Table 35">
            <a:extLst>
              <a:ext uri="{FF2B5EF4-FFF2-40B4-BE49-F238E27FC236}">
                <a16:creationId xmlns:a16="http://schemas.microsoft.com/office/drawing/2014/main" id="{A87AA5B9-A8C7-F24B-58E4-BF33847815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6679046"/>
              </p:ext>
            </p:extLst>
          </p:nvPr>
        </p:nvGraphicFramePr>
        <p:xfrm>
          <a:off x="3279450" y="3470290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37" name="Table 36">
            <a:extLst>
              <a:ext uri="{FF2B5EF4-FFF2-40B4-BE49-F238E27FC236}">
                <a16:creationId xmlns:a16="http://schemas.microsoft.com/office/drawing/2014/main" id="{154D1E8D-D47F-9725-E30A-B8ED63A6CD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7110305"/>
              </p:ext>
            </p:extLst>
          </p:nvPr>
        </p:nvGraphicFramePr>
        <p:xfrm>
          <a:off x="4540503" y="3470290"/>
          <a:ext cx="57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20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920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3CD3365A-48FB-5F35-69CB-1532B4EA5B99}"/>
              </a:ext>
            </a:extLst>
          </p:cNvPr>
          <p:cNvSpPr txBox="1"/>
          <p:nvPr/>
        </p:nvSpPr>
        <p:spPr>
          <a:xfrm>
            <a:off x="120853" y="517345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A12F814-9E25-8084-07C9-A04BCAC842BC}"/>
              </a:ext>
            </a:extLst>
          </p:cNvPr>
          <p:cNvSpPr txBox="1"/>
          <p:nvPr/>
        </p:nvSpPr>
        <p:spPr>
          <a:xfrm>
            <a:off x="664446" y="724181"/>
            <a:ext cx="1585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Gated on B cell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BE4283A-9102-7EED-0A1F-64BFA7D0CE15}"/>
              </a:ext>
            </a:extLst>
          </p:cNvPr>
          <p:cNvSpPr txBox="1"/>
          <p:nvPr/>
        </p:nvSpPr>
        <p:spPr>
          <a:xfrm>
            <a:off x="184718" y="4536437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ACF16D4-A905-A108-D3A8-29C817ECA506}"/>
              </a:ext>
            </a:extLst>
          </p:cNvPr>
          <p:cNvSpPr txBox="1"/>
          <p:nvPr/>
        </p:nvSpPr>
        <p:spPr>
          <a:xfrm>
            <a:off x="646568" y="4734030"/>
            <a:ext cx="1774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Gated on Exp-Treg</a:t>
            </a:r>
            <a:endParaRPr lang="en-GB" sz="1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11227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oup 93">
            <a:extLst>
              <a:ext uri="{FF2B5EF4-FFF2-40B4-BE49-F238E27FC236}">
                <a16:creationId xmlns:a16="http://schemas.microsoft.com/office/drawing/2014/main" id="{82224FA6-2E15-B707-1D09-AC6F46B3ED00}"/>
              </a:ext>
            </a:extLst>
          </p:cNvPr>
          <p:cNvGrpSpPr/>
          <p:nvPr/>
        </p:nvGrpSpPr>
        <p:grpSpPr>
          <a:xfrm>
            <a:off x="92710" y="4027264"/>
            <a:ext cx="6517873" cy="2498860"/>
            <a:chOff x="92710" y="1440680"/>
            <a:chExt cx="6517873" cy="2498860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5A915D3-CD81-78C1-7B78-2E98B9A31C6A}"/>
                </a:ext>
              </a:extLst>
            </p:cNvPr>
            <p:cNvGrpSpPr/>
            <p:nvPr/>
          </p:nvGrpSpPr>
          <p:grpSpPr>
            <a:xfrm>
              <a:off x="413386" y="1980331"/>
              <a:ext cx="1241418" cy="1570905"/>
              <a:chOff x="911225" y="1898015"/>
              <a:chExt cx="1299843" cy="1653222"/>
            </a:xfrm>
          </p:grpSpPr>
          <p:pic>
            <p:nvPicPr>
              <p:cNvPr id="7" name="Graphic 6">
                <a:extLst>
                  <a:ext uri="{FF2B5EF4-FFF2-40B4-BE49-F238E27FC236}">
                    <a16:creationId xmlns:a16="http://schemas.microsoft.com/office/drawing/2014/main" id="{E2C373B2-B57A-847E-F627-06DF3477CA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911225" y="1898015"/>
                <a:ext cx="1299843" cy="649922"/>
              </a:xfrm>
              <a:prstGeom prst="rect">
                <a:avLst/>
              </a:prstGeom>
            </p:spPr>
          </p:pic>
          <p:pic>
            <p:nvPicPr>
              <p:cNvPr id="13" name="Graphic 12">
                <a:extLst>
                  <a:ext uri="{FF2B5EF4-FFF2-40B4-BE49-F238E27FC236}">
                    <a16:creationId xmlns:a16="http://schemas.microsoft.com/office/drawing/2014/main" id="{5B79D21A-E944-7C29-41A0-3907688648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tretch>
                <a:fillRect/>
              </a:stretch>
            </p:blipFill>
            <p:spPr>
              <a:xfrm>
                <a:off x="911225" y="2901315"/>
                <a:ext cx="1299843" cy="649922"/>
              </a:xfrm>
              <a:prstGeom prst="rect">
                <a:avLst/>
              </a:prstGeom>
            </p:spPr>
          </p:pic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A06022AA-9F68-DAA2-4567-4C1AE58D8DCB}"/>
                </a:ext>
              </a:extLst>
            </p:cNvPr>
            <p:cNvGrpSpPr/>
            <p:nvPr/>
          </p:nvGrpSpPr>
          <p:grpSpPr>
            <a:xfrm>
              <a:off x="2062691" y="1980331"/>
              <a:ext cx="1241418" cy="1570906"/>
              <a:chOff x="2936877" y="1898014"/>
              <a:chExt cx="1299843" cy="1653223"/>
            </a:xfrm>
          </p:grpSpPr>
          <p:pic>
            <p:nvPicPr>
              <p:cNvPr id="11" name="Graphic 10">
                <a:extLst>
                  <a:ext uri="{FF2B5EF4-FFF2-40B4-BE49-F238E27FC236}">
                    <a16:creationId xmlns:a16="http://schemas.microsoft.com/office/drawing/2014/main" id="{6DE19515-0A41-F8F5-2AA0-9C5193301C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2936877" y="1898014"/>
                <a:ext cx="1299843" cy="649922"/>
              </a:xfrm>
              <a:prstGeom prst="rect">
                <a:avLst/>
              </a:prstGeom>
            </p:spPr>
          </p:pic>
          <p:pic>
            <p:nvPicPr>
              <p:cNvPr id="15" name="Graphic 14">
                <a:extLst>
                  <a:ext uri="{FF2B5EF4-FFF2-40B4-BE49-F238E27FC236}">
                    <a16:creationId xmlns:a16="http://schemas.microsoft.com/office/drawing/2014/main" id="{C3A98E9D-EC63-D2A4-F83C-8BBBE1F474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96DAC541-7B7A-43D3-8B79-37D633B846F1}">
                    <asvg:svgBlip xmlns:asvg="http://schemas.microsoft.com/office/drawing/2016/SVG/main" r:embed="rId9"/>
                  </a:ext>
                </a:extLst>
              </a:blip>
              <a:stretch>
                <a:fillRect/>
              </a:stretch>
            </p:blipFill>
            <p:spPr>
              <a:xfrm>
                <a:off x="2936877" y="2901315"/>
                <a:ext cx="1299843" cy="649922"/>
              </a:xfrm>
              <a:prstGeom prst="rect">
                <a:avLst/>
              </a:prstGeom>
            </p:spPr>
          </p:pic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8311CCA3-ADDA-6807-C92D-6B0AC55F9B9B}"/>
                </a:ext>
              </a:extLst>
            </p:cNvPr>
            <p:cNvGrpSpPr/>
            <p:nvPr/>
          </p:nvGrpSpPr>
          <p:grpSpPr>
            <a:xfrm>
              <a:off x="3711996" y="1981201"/>
              <a:ext cx="1241418" cy="1587498"/>
              <a:chOff x="911225" y="4674553"/>
              <a:chExt cx="1299843" cy="1670685"/>
            </a:xfrm>
          </p:grpSpPr>
          <p:pic>
            <p:nvPicPr>
              <p:cNvPr id="17" name="Graphic 16">
                <a:extLst>
                  <a:ext uri="{FF2B5EF4-FFF2-40B4-BE49-F238E27FC236}">
                    <a16:creationId xmlns:a16="http://schemas.microsoft.com/office/drawing/2014/main" id="{B0C48D25-194F-C72A-060B-185DE43756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96DAC541-7B7A-43D3-8B79-37D633B846F1}">
                    <asvg:svgBlip xmlns:asvg="http://schemas.microsoft.com/office/drawing/2016/SVG/main" r:embed="rId11"/>
                  </a:ext>
                </a:extLst>
              </a:blip>
              <a:stretch>
                <a:fillRect/>
              </a:stretch>
            </p:blipFill>
            <p:spPr>
              <a:xfrm>
                <a:off x="911225" y="4674553"/>
                <a:ext cx="1299843" cy="649922"/>
              </a:xfrm>
              <a:prstGeom prst="rect">
                <a:avLst/>
              </a:prstGeom>
            </p:spPr>
          </p:pic>
          <p:pic>
            <p:nvPicPr>
              <p:cNvPr id="19" name="Graphic 18">
                <a:extLst>
                  <a:ext uri="{FF2B5EF4-FFF2-40B4-BE49-F238E27FC236}">
                    <a16:creationId xmlns:a16="http://schemas.microsoft.com/office/drawing/2014/main" id="{A879D5B0-6A3C-EACB-E674-4A86A54824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911225" y="5695316"/>
                <a:ext cx="1299843" cy="649922"/>
              </a:xfrm>
              <a:prstGeom prst="rect">
                <a:avLst/>
              </a:prstGeom>
            </p:spPr>
          </p:pic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B0A547D5-4F17-D0F0-F8E1-7B45D250C7FC}"/>
                </a:ext>
              </a:extLst>
            </p:cNvPr>
            <p:cNvGrpSpPr/>
            <p:nvPr/>
          </p:nvGrpSpPr>
          <p:grpSpPr>
            <a:xfrm>
              <a:off x="5361300" y="1963737"/>
              <a:ext cx="1241418" cy="1587499"/>
              <a:chOff x="2936877" y="4674552"/>
              <a:chExt cx="1299843" cy="1670686"/>
            </a:xfrm>
          </p:grpSpPr>
          <p:pic>
            <p:nvPicPr>
              <p:cNvPr id="21" name="Graphic 20">
                <a:extLst>
                  <a:ext uri="{FF2B5EF4-FFF2-40B4-BE49-F238E27FC236}">
                    <a16:creationId xmlns:a16="http://schemas.microsoft.com/office/drawing/2014/main" id="{3480D3E1-3E33-1416-8A71-9E46838D7E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96DAC541-7B7A-43D3-8B79-37D633B846F1}">
                    <asvg:svgBlip xmlns:asvg="http://schemas.microsoft.com/office/drawing/2016/SVG/main" r:embed="rId15"/>
                  </a:ext>
                </a:extLst>
              </a:blip>
              <a:stretch>
                <a:fillRect/>
              </a:stretch>
            </p:blipFill>
            <p:spPr>
              <a:xfrm>
                <a:off x="2936877" y="4674552"/>
                <a:ext cx="1299843" cy="649922"/>
              </a:xfrm>
              <a:prstGeom prst="rect">
                <a:avLst/>
              </a:prstGeom>
            </p:spPr>
          </p:pic>
          <p:pic>
            <p:nvPicPr>
              <p:cNvPr id="23" name="Graphic 22">
                <a:extLst>
                  <a:ext uri="{FF2B5EF4-FFF2-40B4-BE49-F238E27FC236}">
                    <a16:creationId xmlns:a16="http://schemas.microsoft.com/office/drawing/2014/main" id="{F8E0F903-60EF-D3BB-38AE-DF6D515152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96DAC541-7B7A-43D3-8B79-37D633B846F1}">
                    <asvg:svgBlip xmlns:asvg="http://schemas.microsoft.com/office/drawing/2016/SVG/main" r:embed="rId17"/>
                  </a:ext>
                </a:extLst>
              </a:blip>
              <a:stretch>
                <a:fillRect/>
              </a:stretch>
            </p:blipFill>
            <p:spPr>
              <a:xfrm>
                <a:off x="2936877" y="5695316"/>
                <a:ext cx="1299843" cy="649922"/>
              </a:xfrm>
              <a:prstGeom prst="rect">
                <a:avLst/>
              </a:prstGeom>
            </p:spPr>
          </p:pic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69EAAD38-D756-B281-2731-4C7BFCA93241}"/>
                </a:ext>
              </a:extLst>
            </p:cNvPr>
            <p:cNvGrpSpPr/>
            <p:nvPr/>
          </p:nvGrpSpPr>
          <p:grpSpPr>
            <a:xfrm>
              <a:off x="92710" y="3219052"/>
              <a:ext cx="704925" cy="720488"/>
              <a:chOff x="97824" y="5530674"/>
              <a:chExt cx="704925" cy="720488"/>
            </a:xfrm>
          </p:grpSpPr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CC412DCA-AF2C-BD82-1D4D-B2C56FF3DB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E0126FDF-C19D-8709-5521-D8D8321231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6F09153-1F3C-781F-E9C9-521CC82F3829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25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4B8F24C-7B79-3C2E-30CE-9B53AD76219E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FN-</a:t>
                </a:r>
                <a:r>
                  <a:rPr lang="el-GR" sz="7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γ</a:t>
                </a:r>
                <a:endParaRPr lang="en-US" sz="700" dirty="0">
                  <a:latin typeface="Arial Rounded MT Bold" pitchFamily="34" charset="0"/>
                </a:endParaRP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93D204DC-0419-0223-8975-FCBCF164F4E1}"/>
                </a:ext>
              </a:extLst>
            </p:cNvPr>
            <p:cNvGrpSpPr/>
            <p:nvPr/>
          </p:nvGrpSpPr>
          <p:grpSpPr>
            <a:xfrm>
              <a:off x="1727055" y="3219052"/>
              <a:ext cx="704925" cy="720488"/>
              <a:chOff x="97824" y="5530674"/>
              <a:chExt cx="704925" cy="720488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D5AE8BE8-9EFE-B711-7449-465B14AA0E7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75DB8F52-464D-E75D-FDD9-60AA0CACAB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41CA838-15DD-C719-C58D-BCAFD11CA79F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25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0DB48C6-4C18-D272-E6FD-3F6BD9A210B0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TNF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700" dirty="0">
                  <a:latin typeface="Arial Rounded MT Bold" pitchFamily="34" charset="0"/>
                </a:endParaRP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68F9EAEE-56D5-5DF2-8C4D-CA6395174848}"/>
                </a:ext>
              </a:extLst>
            </p:cNvPr>
            <p:cNvGrpSpPr/>
            <p:nvPr/>
          </p:nvGrpSpPr>
          <p:grpSpPr>
            <a:xfrm>
              <a:off x="3352632" y="3219052"/>
              <a:ext cx="704925" cy="720488"/>
              <a:chOff x="97824" y="5530674"/>
              <a:chExt cx="704925" cy="720488"/>
            </a:xfrm>
          </p:grpSpPr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AF60543A-B915-27D4-DC3C-8EF76AC878C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69FEA883-175B-EC0A-F8A4-65757C2657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505A3EC-47A6-65A6-6369-03EC1BC6B4E1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25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CB1E1566-5771-116C-5BDC-0B51B67248C1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L-17</a:t>
                </a: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3C651377-8A24-C8D5-29B1-D93F0CF54237}"/>
                </a:ext>
              </a:extLst>
            </p:cNvPr>
            <p:cNvGrpSpPr/>
            <p:nvPr/>
          </p:nvGrpSpPr>
          <p:grpSpPr>
            <a:xfrm>
              <a:off x="5028649" y="3171343"/>
              <a:ext cx="704925" cy="720488"/>
              <a:chOff x="97824" y="5530674"/>
              <a:chExt cx="704925" cy="720488"/>
            </a:xfrm>
          </p:grpSpPr>
          <p:cxnSp>
            <p:nvCxnSpPr>
              <p:cNvPr id="44" name="Straight Arrow Connector 43">
                <a:extLst>
                  <a:ext uri="{FF2B5EF4-FFF2-40B4-BE49-F238E27FC236}">
                    <a16:creationId xmlns:a16="http://schemas.microsoft.com/office/drawing/2014/main" id="{051019F5-7CCA-C28B-9B28-134DBFDADEE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8278" y="5530674"/>
                <a:ext cx="0" cy="52032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>
                <a:extLst>
                  <a:ext uri="{FF2B5EF4-FFF2-40B4-BE49-F238E27FC236}">
                    <a16:creationId xmlns:a16="http://schemas.microsoft.com/office/drawing/2014/main" id="{2E712DE0-A6CE-71E0-9A01-76ED941FD9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49" y="6042440"/>
                <a:ext cx="5040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2C612FB-0340-EC16-A371-2709E6741B60}"/>
                  </a:ext>
                </a:extLst>
              </p:cNvPr>
              <p:cNvSpPr txBox="1"/>
              <p:nvPr/>
            </p:nvSpPr>
            <p:spPr>
              <a:xfrm>
                <a:off x="238262" y="6051107"/>
                <a:ext cx="50213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CD25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42795B3-21CF-09A7-9307-830724BFA20B}"/>
                  </a:ext>
                </a:extLst>
              </p:cNvPr>
              <p:cNvSpPr txBox="1"/>
              <p:nvPr/>
            </p:nvSpPr>
            <p:spPr>
              <a:xfrm rot="16200000">
                <a:off x="-22000" y="5743182"/>
                <a:ext cx="4397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IL-10</a:t>
                </a:r>
              </a:p>
            </p:txBody>
          </p: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CB4DCDF8-14EC-F17D-99ED-A24404B6D47E}"/>
                </a:ext>
              </a:extLst>
            </p:cNvPr>
            <p:cNvGrpSpPr/>
            <p:nvPr/>
          </p:nvGrpSpPr>
          <p:grpSpPr>
            <a:xfrm>
              <a:off x="328093" y="1698648"/>
              <a:ext cx="1345000" cy="200055"/>
              <a:chOff x="309805" y="1698648"/>
              <a:chExt cx="1345000" cy="200055"/>
            </a:xfrm>
          </p:grpSpPr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5816AC17-4584-6DA8-A77B-A32244767F6C}"/>
                  </a:ext>
                </a:extLst>
              </p:cNvPr>
              <p:cNvSpPr txBox="1"/>
              <p:nvPr/>
            </p:nvSpPr>
            <p:spPr>
              <a:xfrm>
                <a:off x="309805" y="1698648"/>
                <a:ext cx="7830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F-Treg alone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7CF19F2-0910-1F72-4C3A-2428E34F3652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07E2BEC-D611-090E-4355-B69731637DAA}"/>
                </a:ext>
              </a:extLst>
            </p:cNvPr>
            <p:cNvSpPr txBox="1"/>
            <p:nvPr/>
          </p:nvSpPr>
          <p:spPr>
            <a:xfrm>
              <a:off x="2408833" y="1440680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TNF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900" dirty="0">
                <a:latin typeface="Arial Rounded MT Bold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130D3E2-C6CB-0D56-92DF-33881231B3A0}"/>
                </a:ext>
              </a:extLst>
            </p:cNvPr>
            <p:cNvSpPr txBox="1"/>
            <p:nvPr/>
          </p:nvSpPr>
          <p:spPr>
            <a:xfrm>
              <a:off x="809496" y="1440680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FN-</a:t>
              </a:r>
              <a:r>
                <a:rPr lang="el-GR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γ</a:t>
              </a:r>
              <a:endParaRPr lang="en-US" sz="900" dirty="0">
                <a:latin typeface="Arial Rounded MT Bold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3789247A-AF2A-9BEB-6E5B-2A2AE97E2E87}"/>
                </a:ext>
              </a:extLst>
            </p:cNvPr>
            <p:cNvSpPr txBox="1"/>
            <p:nvPr/>
          </p:nvSpPr>
          <p:spPr>
            <a:xfrm>
              <a:off x="4016863" y="1440680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L-17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41A0668-88EF-B5FD-0BD4-A093C37883F2}"/>
                </a:ext>
              </a:extLst>
            </p:cNvPr>
            <p:cNvSpPr txBox="1"/>
            <p:nvPr/>
          </p:nvSpPr>
          <p:spPr>
            <a:xfrm>
              <a:off x="5675461" y="1440680"/>
              <a:ext cx="558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 Rounded MT Bold" pitchFamily="34" charset="0"/>
                </a:rPr>
                <a:t>IL-10</a:t>
              </a:r>
            </a:p>
          </p:txBody>
        </p: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B2FA2EAB-9B9E-FAB2-C7A4-9A02B9F1186C}"/>
                </a:ext>
              </a:extLst>
            </p:cNvPr>
            <p:cNvGrpSpPr/>
            <p:nvPr/>
          </p:nvGrpSpPr>
          <p:grpSpPr>
            <a:xfrm>
              <a:off x="1964653" y="1698648"/>
              <a:ext cx="1345000" cy="200055"/>
              <a:chOff x="309805" y="1698648"/>
              <a:chExt cx="1345000" cy="200055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218F192C-D8FF-FBED-408A-22D21B2A6DD2}"/>
                  </a:ext>
                </a:extLst>
              </p:cNvPr>
              <p:cNvSpPr txBox="1"/>
              <p:nvPr/>
            </p:nvSpPr>
            <p:spPr>
              <a:xfrm>
                <a:off x="309805" y="1698648"/>
                <a:ext cx="7830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F-Treg alone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C1597731-D2E5-4D51-021B-56F7C288F64D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691765D3-7461-7FFD-BF91-264F341DA628}"/>
                </a:ext>
              </a:extLst>
            </p:cNvPr>
            <p:cNvGrpSpPr/>
            <p:nvPr/>
          </p:nvGrpSpPr>
          <p:grpSpPr>
            <a:xfrm>
              <a:off x="3612458" y="1698648"/>
              <a:ext cx="1345000" cy="200055"/>
              <a:chOff x="309805" y="1698648"/>
              <a:chExt cx="1345000" cy="200055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4FE535CF-26AA-D02A-2D2A-F2CA5D1568AE}"/>
                  </a:ext>
                </a:extLst>
              </p:cNvPr>
              <p:cNvSpPr txBox="1"/>
              <p:nvPr/>
            </p:nvSpPr>
            <p:spPr>
              <a:xfrm>
                <a:off x="309805" y="1698648"/>
                <a:ext cx="7830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F-Treg alone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34067E4D-9C50-DDED-668C-385AA5B8F25F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1DAAD7B4-9FFC-E885-C006-38A0158180C2}"/>
                </a:ext>
              </a:extLst>
            </p:cNvPr>
            <p:cNvGrpSpPr/>
            <p:nvPr/>
          </p:nvGrpSpPr>
          <p:grpSpPr>
            <a:xfrm>
              <a:off x="5265583" y="1698648"/>
              <a:ext cx="1345000" cy="200055"/>
              <a:chOff x="309805" y="1698648"/>
              <a:chExt cx="1345000" cy="200055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729BF90C-B0BD-95FE-7632-61A9A7B57CC4}"/>
                  </a:ext>
                </a:extLst>
              </p:cNvPr>
              <p:cNvSpPr txBox="1"/>
              <p:nvPr/>
            </p:nvSpPr>
            <p:spPr>
              <a:xfrm>
                <a:off x="309805" y="1698648"/>
                <a:ext cx="7830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F-Treg alone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ABA9F73-400F-F63B-9655-2D8D9F6BDE07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BB28EF9D-2CDE-B92C-9CE2-1915A662CD0E}"/>
                </a:ext>
              </a:extLst>
            </p:cNvPr>
            <p:cNvGrpSpPr/>
            <p:nvPr/>
          </p:nvGrpSpPr>
          <p:grpSpPr>
            <a:xfrm>
              <a:off x="291917" y="2701774"/>
              <a:ext cx="1375632" cy="200055"/>
              <a:chOff x="279173" y="1698648"/>
              <a:chExt cx="1375632" cy="200055"/>
            </a:xfrm>
          </p:grpSpPr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4F07C37B-34AE-9FE7-1162-C0E7B3B4E965}"/>
                  </a:ext>
                </a:extLst>
              </p:cNvPr>
              <p:cNvSpPr txBox="1"/>
              <p:nvPr/>
            </p:nvSpPr>
            <p:spPr>
              <a:xfrm>
                <a:off x="279173" y="1698648"/>
                <a:ext cx="85411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Exp-Treg alone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0C610188-ED5A-9937-F30C-AC6D02100765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96E79F21-A705-32A5-2286-915020A7FF2D}"/>
                </a:ext>
              </a:extLst>
            </p:cNvPr>
            <p:cNvGrpSpPr/>
            <p:nvPr/>
          </p:nvGrpSpPr>
          <p:grpSpPr>
            <a:xfrm>
              <a:off x="1939894" y="2701774"/>
              <a:ext cx="1364215" cy="200055"/>
              <a:chOff x="290590" y="1698648"/>
              <a:chExt cx="1364215" cy="200055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200A6785-81BC-22D2-15F7-5823D8FDB828}"/>
                  </a:ext>
                </a:extLst>
              </p:cNvPr>
              <p:cNvSpPr txBox="1"/>
              <p:nvPr/>
            </p:nvSpPr>
            <p:spPr>
              <a:xfrm>
                <a:off x="290590" y="1698648"/>
                <a:ext cx="8426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Exp-Treg alone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0DBE2EAE-7AF6-6514-DD6C-11CBC1D05018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AC2DFFA6-598D-095D-4112-8B1C7F8CF4FF}"/>
                </a:ext>
              </a:extLst>
            </p:cNvPr>
            <p:cNvGrpSpPr/>
            <p:nvPr/>
          </p:nvGrpSpPr>
          <p:grpSpPr>
            <a:xfrm>
              <a:off x="3587699" y="2701774"/>
              <a:ext cx="1364215" cy="200055"/>
              <a:chOff x="290590" y="1698648"/>
              <a:chExt cx="1364215" cy="200055"/>
            </a:xfrm>
          </p:grpSpPr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D208CD6C-F25D-18F0-5F2D-4A4EFED46528}"/>
                  </a:ext>
                </a:extLst>
              </p:cNvPr>
              <p:cNvSpPr txBox="1"/>
              <p:nvPr/>
            </p:nvSpPr>
            <p:spPr>
              <a:xfrm>
                <a:off x="290590" y="1698648"/>
                <a:ext cx="8426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Exp-Treg alone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5738C382-F545-95A7-7780-EC1EB484E365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AD70F37B-E8A9-1A1C-C834-DF70E7896F80}"/>
                </a:ext>
              </a:extLst>
            </p:cNvPr>
            <p:cNvGrpSpPr/>
            <p:nvPr/>
          </p:nvGrpSpPr>
          <p:grpSpPr>
            <a:xfrm>
              <a:off x="5240824" y="2701774"/>
              <a:ext cx="1364215" cy="200055"/>
              <a:chOff x="290590" y="1698648"/>
              <a:chExt cx="1364215" cy="200055"/>
            </a:xfrm>
          </p:grpSpPr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2D58A28-0B40-55B4-5CCC-D17F0A4FB725}"/>
                  </a:ext>
                </a:extLst>
              </p:cNvPr>
              <p:cNvSpPr txBox="1"/>
              <p:nvPr/>
            </p:nvSpPr>
            <p:spPr>
              <a:xfrm>
                <a:off x="290590" y="1698648"/>
                <a:ext cx="8426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Exp-Treg alone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6186F1C-6A15-B572-CBB7-2AB2BCC733BD}"/>
                  </a:ext>
                </a:extLst>
              </p:cNvPr>
              <p:cNvSpPr txBox="1"/>
              <p:nvPr/>
            </p:nvSpPr>
            <p:spPr>
              <a:xfrm>
                <a:off x="1083819" y="1698648"/>
                <a:ext cx="5709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 Rounded MT Bold" pitchFamily="34" charset="0"/>
                  </a:rPr>
                  <a:t>+B cells</a:t>
                </a:r>
              </a:p>
            </p:txBody>
          </p:sp>
        </p:grpSp>
      </p:grpSp>
      <p:pic>
        <p:nvPicPr>
          <p:cNvPr id="96" name="Graphic 95">
            <a:extLst>
              <a:ext uri="{FF2B5EF4-FFF2-40B4-BE49-F238E27FC236}">
                <a16:creationId xmlns:a16="http://schemas.microsoft.com/office/drawing/2014/main" id="{C467BC9A-23E3-0773-A625-C1C4C23C63E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764804" y="6884300"/>
            <a:ext cx="1613774" cy="1143000"/>
          </a:xfrm>
          <a:prstGeom prst="rect">
            <a:avLst/>
          </a:prstGeom>
        </p:spPr>
      </p:pic>
      <p:pic>
        <p:nvPicPr>
          <p:cNvPr id="100" name="Graphic 99">
            <a:extLst>
              <a:ext uri="{FF2B5EF4-FFF2-40B4-BE49-F238E27FC236}">
                <a16:creationId xmlns:a16="http://schemas.microsoft.com/office/drawing/2014/main" id="{F3ECDDF6-6674-AE0C-A076-AFE43EBC184C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3640789" y="6867174"/>
            <a:ext cx="1619250" cy="1162050"/>
          </a:xfrm>
          <a:prstGeom prst="rect">
            <a:avLst/>
          </a:prstGeom>
        </p:spPr>
      </p:pic>
      <p:pic>
        <p:nvPicPr>
          <p:cNvPr id="112" name="Graphic 111">
            <a:extLst>
              <a:ext uri="{FF2B5EF4-FFF2-40B4-BE49-F238E27FC236}">
                <a16:creationId xmlns:a16="http://schemas.microsoft.com/office/drawing/2014/main" id="{BC987B14-D164-DFC5-3E3A-A26C088E845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96DAC541-7B7A-43D3-8B79-37D633B846F1}">
                <asvg:svgBlip xmlns:asvg="http://schemas.microsoft.com/office/drawing/2016/SVG/main" r:embed="rId23"/>
              </a:ext>
            </a:extLst>
          </a:blip>
          <a:stretch>
            <a:fillRect/>
          </a:stretch>
        </p:blipFill>
        <p:spPr>
          <a:xfrm>
            <a:off x="2254670" y="6886224"/>
            <a:ext cx="1514769" cy="1143000"/>
          </a:xfrm>
          <a:prstGeom prst="rect">
            <a:avLst/>
          </a:prstGeom>
        </p:spPr>
      </p:pic>
      <p:pic>
        <p:nvPicPr>
          <p:cNvPr id="114" name="Graphic 113">
            <a:extLst>
              <a:ext uri="{FF2B5EF4-FFF2-40B4-BE49-F238E27FC236}">
                <a16:creationId xmlns:a16="http://schemas.microsoft.com/office/drawing/2014/main" id="{76992721-162A-23FE-93A0-B4037F8FC4C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96DAC541-7B7A-43D3-8B79-37D633B846F1}">
                <asvg:svgBlip xmlns:asvg="http://schemas.microsoft.com/office/drawing/2016/SVG/main" r:embed="rId25"/>
              </a:ext>
            </a:extLst>
          </a:blip>
          <a:stretch>
            <a:fillRect/>
          </a:stretch>
        </p:blipFill>
        <p:spPr>
          <a:xfrm>
            <a:off x="5094029" y="6886224"/>
            <a:ext cx="1409700" cy="1143000"/>
          </a:xfrm>
          <a:prstGeom prst="rect">
            <a:avLst/>
          </a:prstGeom>
        </p:spPr>
      </p:pic>
      <p:graphicFrame>
        <p:nvGraphicFramePr>
          <p:cNvPr id="115" name="Table 114">
            <a:extLst>
              <a:ext uri="{FF2B5EF4-FFF2-40B4-BE49-F238E27FC236}">
                <a16:creationId xmlns:a16="http://schemas.microsoft.com/office/drawing/2014/main" id="{7EA56928-FCF4-6B73-8713-70E5CF89C6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1644609"/>
              </p:ext>
            </p:extLst>
          </p:nvPr>
        </p:nvGraphicFramePr>
        <p:xfrm>
          <a:off x="1039343" y="8070455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116" name="Table 115">
            <a:extLst>
              <a:ext uri="{FF2B5EF4-FFF2-40B4-BE49-F238E27FC236}">
                <a16:creationId xmlns:a16="http://schemas.microsoft.com/office/drawing/2014/main" id="{2A242047-3B77-87C2-BDB0-DF40921DA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6195201"/>
              </p:ext>
            </p:extLst>
          </p:nvPr>
        </p:nvGraphicFramePr>
        <p:xfrm>
          <a:off x="2504831" y="8070455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117" name="Table 116">
            <a:extLst>
              <a:ext uri="{FF2B5EF4-FFF2-40B4-BE49-F238E27FC236}">
                <a16:creationId xmlns:a16="http://schemas.microsoft.com/office/drawing/2014/main" id="{016EB1C6-6A54-79DD-B8B4-EFCF3C1F88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8415302"/>
              </p:ext>
            </p:extLst>
          </p:nvPr>
        </p:nvGraphicFramePr>
        <p:xfrm>
          <a:off x="3925365" y="8070455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118" name="Table 117">
            <a:extLst>
              <a:ext uri="{FF2B5EF4-FFF2-40B4-BE49-F238E27FC236}">
                <a16:creationId xmlns:a16="http://schemas.microsoft.com/office/drawing/2014/main" id="{BF61824B-ED0E-2134-E882-1534C21528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2368730"/>
              </p:ext>
            </p:extLst>
          </p:nvPr>
        </p:nvGraphicFramePr>
        <p:xfrm>
          <a:off x="5359103" y="8070455"/>
          <a:ext cx="8064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27404432"/>
                    </a:ext>
                  </a:extLst>
                </a:gridCol>
                <a:gridCol w="172800">
                  <a:extLst>
                    <a:ext uri="{9D8B030D-6E8A-4147-A177-3AD203B41FA5}">
                      <a16:colId xmlns:a16="http://schemas.microsoft.com/office/drawing/2014/main" val="553286961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1414154919"/>
                    </a:ext>
                  </a:extLst>
                </a:gridCol>
                <a:gridCol w="158400">
                  <a:extLst>
                    <a:ext uri="{9D8B030D-6E8A-4147-A177-3AD203B41FA5}">
                      <a16:colId xmlns:a16="http://schemas.microsoft.com/office/drawing/2014/main" val="2204703279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-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+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aphicFrame>
        <p:nvGraphicFramePr>
          <p:cNvPr id="119" name="Table 118">
            <a:extLst>
              <a:ext uri="{FF2B5EF4-FFF2-40B4-BE49-F238E27FC236}">
                <a16:creationId xmlns:a16="http://schemas.microsoft.com/office/drawing/2014/main" id="{941E53D3-B8AF-E9FF-38C6-475119063D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761429"/>
              </p:ext>
            </p:extLst>
          </p:nvPr>
        </p:nvGraphicFramePr>
        <p:xfrm>
          <a:off x="201770" y="8092052"/>
          <a:ext cx="690423" cy="685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0423">
                  <a:extLst>
                    <a:ext uri="{9D8B030D-6E8A-4147-A177-3AD203B41FA5}">
                      <a16:colId xmlns:a16="http://schemas.microsoft.com/office/drawing/2014/main" val="3662259644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20034761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Tregs</a:t>
                      </a: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30809628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-Treg</a:t>
                      </a:r>
                      <a:endParaRPr lang="en-GB" sz="9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923565954"/>
                  </a:ext>
                </a:extLst>
              </a:tr>
            </a:tbl>
          </a:graphicData>
        </a:graphic>
      </p:graphicFrame>
      <p:grpSp>
        <p:nvGrpSpPr>
          <p:cNvPr id="120" name="Group 119">
            <a:extLst>
              <a:ext uri="{FF2B5EF4-FFF2-40B4-BE49-F238E27FC236}">
                <a16:creationId xmlns:a16="http://schemas.microsoft.com/office/drawing/2014/main" id="{DDBACA8F-7880-F99A-00F8-39C5907D9086}"/>
              </a:ext>
            </a:extLst>
          </p:cNvPr>
          <p:cNvGrpSpPr/>
          <p:nvPr/>
        </p:nvGrpSpPr>
        <p:grpSpPr>
          <a:xfrm>
            <a:off x="5548466" y="6398955"/>
            <a:ext cx="1234074" cy="339755"/>
            <a:chOff x="2108398" y="8368331"/>
            <a:chExt cx="1234074" cy="339755"/>
          </a:xfrm>
        </p:grpSpPr>
        <p:sp>
          <p:nvSpPr>
            <p:cNvPr id="121" name="Flowchart: Connector 120">
              <a:extLst>
                <a:ext uri="{FF2B5EF4-FFF2-40B4-BE49-F238E27FC236}">
                  <a16:creationId xmlns:a16="http://schemas.microsoft.com/office/drawing/2014/main" id="{D75EA29D-790B-3291-F8FF-8515515B540B}"/>
                </a:ext>
              </a:extLst>
            </p:cNvPr>
            <p:cNvSpPr/>
            <p:nvPr/>
          </p:nvSpPr>
          <p:spPr>
            <a:xfrm>
              <a:off x="2108398" y="8445500"/>
              <a:ext cx="50602" cy="45719"/>
            </a:xfrm>
            <a:prstGeom prst="flowChartConnector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674036F1-F996-16DF-1BD5-36401C9CBC60}"/>
                </a:ext>
              </a:extLst>
            </p:cNvPr>
            <p:cNvSpPr/>
            <p:nvPr/>
          </p:nvSpPr>
          <p:spPr>
            <a:xfrm>
              <a:off x="2108398" y="8591550"/>
              <a:ext cx="50602" cy="45719"/>
            </a:xfrm>
            <a:prstGeom prst="rect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A8D766EC-50B8-3CA8-4EC4-2B50F1FA4C74}"/>
                </a:ext>
              </a:extLst>
            </p:cNvPr>
            <p:cNvSpPr txBox="1"/>
            <p:nvPr/>
          </p:nvSpPr>
          <p:spPr>
            <a:xfrm>
              <a:off x="2163272" y="8368331"/>
              <a:ext cx="7507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Tregs alone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502D9EE8-F9BF-AEE7-1321-EA04ED040C41}"/>
                </a:ext>
              </a:extLst>
            </p:cNvPr>
            <p:cNvSpPr txBox="1"/>
            <p:nvPr/>
          </p:nvSpPr>
          <p:spPr>
            <a:xfrm>
              <a:off x="2188672" y="8508031"/>
              <a:ext cx="11538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 Rounded MT Bold" pitchFamily="34" charset="0"/>
                </a:rPr>
                <a:t>B cell : Treg (1:1 ratio)</a:t>
              </a:r>
            </a:p>
          </p:txBody>
        </p:sp>
      </p:grpSp>
      <p:sp>
        <p:nvSpPr>
          <p:cNvPr id="125" name="TextBox 124">
            <a:extLst>
              <a:ext uri="{FF2B5EF4-FFF2-40B4-BE49-F238E27FC236}">
                <a16:creationId xmlns:a16="http://schemas.microsoft.com/office/drawing/2014/main" id="{78127579-7220-864C-312A-B535F23CC2F5}"/>
              </a:ext>
            </a:extLst>
          </p:cNvPr>
          <p:cNvSpPr txBox="1"/>
          <p:nvPr/>
        </p:nvSpPr>
        <p:spPr>
          <a:xfrm>
            <a:off x="413386" y="3575919"/>
            <a:ext cx="14860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Gated on Tregs</a:t>
            </a:r>
            <a:endParaRPr lang="en-GB" sz="1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6">
            <a:extLst>
              <a:ext uri="{FF2B5EF4-FFF2-40B4-BE49-F238E27FC236}">
                <a16:creationId xmlns:a16="http://schemas.microsoft.com/office/drawing/2014/main" id="{A4FFDF37-8C74-A839-25A9-773A6F59544D}"/>
              </a:ext>
            </a:extLst>
          </p:cNvPr>
          <p:cNvSpPr txBox="1"/>
          <p:nvPr/>
        </p:nvSpPr>
        <p:spPr>
          <a:xfrm>
            <a:off x="137034" y="3459289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7" name="TextBox 6">
            <a:extLst>
              <a:ext uri="{FF2B5EF4-FFF2-40B4-BE49-F238E27FC236}">
                <a16:creationId xmlns:a16="http://schemas.microsoft.com/office/drawing/2014/main" id="{16FFE4F8-6AB9-E6FE-15C3-44C1291B6AD8}"/>
              </a:ext>
            </a:extLst>
          </p:cNvPr>
          <p:cNvSpPr txBox="1"/>
          <p:nvPr/>
        </p:nvSpPr>
        <p:spPr>
          <a:xfrm>
            <a:off x="137034" y="6523009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D840350-7767-A2F3-1685-DFDCF424B6EA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Figure 1 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D182FB13-1FF8-8459-61BC-9673E4F4ED59}"/>
              </a:ext>
            </a:extLst>
          </p:cNvPr>
          <p:cNvGrpSpPr/>
          <p:nvPr/>
        </p:nvGrpSpPr>
        <p:grpSpPr>
          <a:xfrm>
            <a:off x="630878" y="558798"/>
            <a:ext cx="5303525" cy="2741830"/>
            <a:chOff x="378943" y="689429"/>
            <a:chExt cx="5303525" cy="2977120"/>
          </a:xfrm>
        </p:grpSpPr>
        <p:pic>
          <p:nvPicPr>
            <p:cNvPr id="5" name="Graphic 4">
              <a:extLst>
                <a:ext uri="{FF2B5EF4-FFF2-40B4-BE49-F238E27FC236}">
                  <a16:creationId xmlns:a16="http://schemas.microsoft.com/office/drawing/2014/main" id="{B6FCA463-6433-8BCE-9077-3FAC65D8B5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96DAC541-7B7A-43D3-8B79-37D633B846F1}">
                  <asvg:svgBlip xmlns:asvg="http://schemas.microsoft.com/office/drawing/2016/SVG/main" r:embed="rId27"/>
                </a:ext>
              </a:extLst>
            </a:blip>
            <a:srcRect t="6410"/>
            <a:stretch/>
          </p:blipFill>
          <p:spPr>
            <a:xfrm>
              <a:off x="378943" y="689429"/>
              <a:ext cx="3943350" cy="2201861"/>
            </a:xfrm>
            <a:prstGeom prst="rect">
              <a:avLst/>
            </a:prstGeom>
          </p:spPr>
        </p:pic>
        <p:pic>
          <p:nvPicPr>
            <p:cNvPr id="10" name="Graphic 9">
              <a:extLst>
                <a:ext uri="{FF2B5EF4-FFF2-40B4-BE49-F238E27FC236}">
                  <a16:creationId xmlns:a16="http://schemas.microsoft.com/office/drawing/2014/main" id="{52F87678-A4E1-6617-1ADD-8165CE6601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96DAC541-7B7A-43D3-8B79-37D633B846F1}">
                  <asvg:svgBlip xmlns:asvg="http://schemas.microsoft.com/office/drawing/2016/SVG/main" r:embed="rId29"/>
                </a:ext>
              </a:extLst>
            </a:blip>
            <a:stretch>
              <a:fillRect/>
            </a:stretch>
          </p:blipFill>
          <p:spPr>
            <a:xfrm>
              <a:off x="4234668" y="1056699"/>
              <a:ext cx="1447800" cy="2609850"/>
            </a:xfrm>
            <a:prstGeom prst="rect">
              <a:avLst/>
            </a:prstGeom>
          </p:spPr>
        </p:pic>
      </p:grpSp>
      <p:sp>
        <p:nvSpPr>
          <p:cNvPr id="14" name="TextBox 6">
            <a:extLst>
              <a:ext uri="{FF2B5EF4-FFF2-40B4-BE49-F238E27FC236}">
                <a16:creationId xmlns:a16="http://schemas.microsoft.com/office/drawing/2014/main" id="{E03DF448-09FF-ECB5-C9F2-CACC0EFD5C86}"/>
              </a:ext>
            </a:extLst>
          </p:cNvPr>
          <p:cNvSpPr txBox="1"/>
          <p:nvPr/>
        </p:nvSpPr>
        <p:spPr>
          <a:xfrm>
            <a:off x="137034" y="487453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EF51485-69FC-8101-C1A1-34D188E8A138}"/>
              </a:ext>
            </a:extLst>
          </p:cNvPr>
          <p:cNvCxnSpPr/>
          <p:nvPr/>
        </p:nvCxnSpPr>
        <p:spPr>
          <a:xfrm>
            <a:off x="5094029" y="1894114"/>
            <a:ext cx="0" cy="438539"/>
          </a:xfrm>
          <a:prstGeom prst="straightConnector1">
            <a:avLst/>
          </a:prstGeom>
          <a:ln w="6350">
            <a:tailEnd type="stealth" w="med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2" name="Group 21">
            <a:extLst>
              <a:ext uri="{FF2B5EF4-FFF2-40B4-BE49-F238E27FC236}">
                <a16:creationId xmlns:a16="http://schemas.microsoft.com/office/drawing/2014/main" id="{42275812-E992-F3D5-1B10-7E8AE34071C7}"/>
              </a:ext>
            </a:extLst>
          </p:cNvPr>
          <p:cNvGrpSpPr/>
          <p:nvPr/>
        </p:nvGrpSpPr>
        <p:grpSpPr>
          <a:xfrm>
            <a:off x="1193798" y="2789679"/>
            <a:ext cx="2903319" cy="689636"/>
            <a:chOff x="166124" y="3060349"/>
            <a:chExt cx="6669837" cy="201695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F2EE32A-6B14-2ECD-B945-38DED470FB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166124" y="3060349"/>
              <a:ext cx="1765299" cy="201695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E741B55-0275-89A5-AB5A-5678AEB52C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108761" y="3119618"/>
              <a:ext cx="1727200" cy="18415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72122BB-BD9F-FFC1-67D6-249C10AD30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3404771" y="3111151"/>
              <a:ext cx="1765300" cy="19177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D71801C5-C081-6CD9-1D9F-C77F3932FD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1861646" y="3111151"/>
              <a:ext cx="1689100" cy="1943100"/>
            </a:xfrm>
            <a:prstGeom prst="rect">
              <a:avLst/>
            </a:prstGeom>
          </p:spPr>
        </p:pic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68B61CBA-332B-C24F-4EE0-F19D664329E2}"/>
              </a:ext>
            </a:extLst>
          </p:cNvPr>
          <p:cNvSpPr txBox="1"/>
          <p:nvPr/>
        </p:nvSpPr>
        <p:spPr>
          <a:xfrm>
            <a:off x="2257481" y="2557509"/>
            <a:ext cx="841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700" b="1" dirty="0"/>
              <a:t>Gated on B cell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D6C40BD-D780-3ED7-AAFB-F529278E7D37}"/>
              </a:ext>
            </a:extLst>
          </p:cNvPr>
          <p:cNvSpPr txBox="1"/>
          <p:nvPr/>
        </p:nvSpPr>
        <p:spPr>
          <a:xfrm>
            <a:off x="1189171" y="2667185"/>
            <a:ext cx="841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700" dirty="0"/>
              <a:t>Isotyp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C3E08BA-DDDD-E24C-ECB8-D7F78DC567F2}"/>
              </a:ext>
            </a:extLst>
          </p:cNvPr>
          <p:cNvSpPr txBox="1"/>
          <p:nvPr/>
        </p:nvSpPr>
        <p:spPr>
          <a:xfrm>
            <a:off x="1892490" y="2667185"/>
            <a:ext cx="841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700" dirty="0"/>
              <a:t>Isotyp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5CB2510-43AC-1E3C-D5F1-238CB78880A4}"/>
              </a:ext>
            </a:extLst>
          </p:cNvPr>
          <p:cNvSpPr txBox="1"/>
          <p:nvPr/>
        </p:nvSpPr>
        <p:spPr>
          <a:xfrm>
            <a:off x="2628162" y="2667185"/>
            <a:ext cx="841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700" dirty="0"/>
              <a:t>Isotyp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87DD8C7-EEF3-1824-0143-BAC2AAF92175}"/>
              </a:ext>
            </a:extLst>
          </p:cNvPr>
          <p:cNvSpPr txBox="1"/>
          <p:nvPr/>
        </p:nvSpPr>
        <p:spPr>
          <a:xfrm>
            <a:off x="3322615" y="2667185"/>
            <a:ext cx="8413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700" dirty="0"/>
              <a:t>Isotype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219BC6B8-F638-CE58-093E-303A65CA3859}"/>
              </a:ext>
            </a:extLst>
          </p:cNvPr>
          <p:cNvCxnSpPr/>
          <p:nvPr/>
        </p:nvCxnSpPr>
        <p:spPr>
          <a:xfrm flipV="1">
            <a:off x="1176868" y="2794001"/>
            <a:ext cx="0" cy="6141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0106D361-0D78-FAF9-2D5F-A1E094F84B4E}"/>
              </a:ext>
            </a:extLst>
          </p:cNvPr>
          <p:cNvCxnSpPr/>
          <p:nvPr/>
        </p:nvCxnSpPr>
        <p:spPr>
          <a:xfrm>
            <a:off x="1265374" y="3462746"/>
            <a:ext cx="28683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F2BA057-57FA-6107-3171-032D3F267526}"/>
              </a:ext>
            </a:extLst>
          </p:cNvPr>
          <p:cNvSpPr txBox="1"/>
          <p:nvPr/>
        </p:nvSpPr>
        <p:spPr>
          <a:xfrm>
            <a:off x="2478580" y="3449919"/>
            <a:ext cx="3770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700" dirty="0"/>
              <a:t>CD19</a:t>
            </a:r>
            <a:endParaRPr lang="en-SA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0235C92-06BF-B892-03C1-57718EBC181B}"/>
              </a:ext>
            </a:extLst>
          </p:cNvPr>
          <p:cNvSpPr txBox="1"/>
          <p:nvPr/>
        </p:nvSpPr>
        <p:spPr>
          <a:xfrm rot="16200000">
            <a:off x="750650" y="2948107"/>
            <a:ext cx="741159" cy="204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A" sz="700" dirty="0"/>
              <a:t>Cytokines</a:t>
            </a:r>
            <a:endParaRPr lang="en-SA" dirty="0"/>
          </a:p>
        </p:txBody>
      </p:sp>
    </p:spTree>
    <p:extLst>
      <p:ext uri="{BB962C8B-B14F-4D97-AF65-F5344CB8AC3E}">
        <p14:creationId xmlns:p14="http://schemas.microsoft.com/office/powerpoint/2010/main" val="6179351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604DDA-6408-10C3-64E9-9EFC168259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6">
            <a:extLst>
              <a:ext uri="{FF2B5EF4-FFF2-40B4-BE49-F238E27FC236}">
                <a16:creationId xmlns:a16="http://schemas.microsoft.com/office/drawing/2014/main" id="{18F14C66-236E-9BA3-692F-DFBD6DE1573F}"/>
              </a:ext>
            </a:extLst>
          </p:cNvPr>
          <p:cNvSpPr txBox="1"/>
          <p:nvPr/>
        </p:nvSpPr>
        <p:spPr>
          <a:xfrm>
            <a:off x="141228" y="2591291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0CCDF991-65F5-D3D0-9FA7-B5B66C9C1062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</a:t>
            </a:r>
            <a:r>
              <a:rPr lang="en-GB" b="1"/>
              <a:t>Figure 2 </a:t>
            </a:r>
            <a:endParaRPr lang="en-GB" b="1" dirty="0"/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78266432-3D71-8258-A034-E20D76D82EEC}"/>
              </a:ext>
            </a:extLst>
          </p:cNvPr>
          <p:cNvSpPr txBox="1"/>
          <p:nvPr/>
        </p:nvSpPr>
        <p:spPr>
          <a:xfrm>
            <a:off x="157578" y="425574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7A064784-619B-15D7-408C-FF496880039E}"/>
              </a:ext>
            </a:extLst>
          </p:cNvPr>
          <p:cNvCxnSpPr/>
          <p:nvPr/>
        </p:nvCxnSpPr>
        <p:spPr>
          <a:xfrm flipV="1">
            <a:off x="877123" y="614725"/>
            <a:ext cx="0" cy="182880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83B010B-50FC-28DF-2666-09EEFD56DEDF}"/>
              </a:ext>
            </a:extLst>
          </p:cNvPr>
          <p:cNvCxnSpPr/>
          <p:nvPr/>
        </p:nvCxnSpPr>
        <p:spPr>
          <a:xfrm flipV="1">
            <a:off x="3904744" y="615531"/>
            <a:ext cx="0" cy="182880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D7BB5C9D-CC0C-27C3-7679-202FF0420978}"/>
              </a:ext>
            </a:extLst>
          </p:cNvPr>
          <p:cNvCxnSpPr>
            <a:cxnSpLocks/>
          </p:cNvCxnSpPr>
          <p:nvPr/>
        </p:nvCxnSpPr>
        <p:spPr>
          <a:xfrm>
            <a:off x="877123" y="2443509"/>
            <a:ext cx="1897115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F5E8FF6A-DE2B-890F-8122-CCF722EEDC4F}"/>
              </a:ext>
            </a:extLst>
          </p:cNvPr>
          <p:cNvCxnSpPr>
            <a:cxnSpLocks/>
          </p:cNvCxnSpPr>
          <p:nvPr/>
        </p:nvCxnSpPr>
        <p:spPr>
          <a:xfrm>
            <a:off x="3902108" y="2444322"/>
            <a:ext cx="1897115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E7DDDD3-1519-DC1E-D094-D6EE5D03C2CA}"/>
              </a:ext>
            </a:extLst>
          </p:cNvPr>
          <p:cNvSpPr txBox="1"/>
          <p:nvPr/>
        </p:nvSpPr>
        <p:spPr>
          <a:xfrm>
            <a:off x="1116441" y="2415139"/>
            <a:ext cx="1437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800" dirty="0"/>
              <a:t>CD19</a:t>
            </a:r>
            <a:r>
              <a:rPr lang="en-SA" sz="800" baseline="30000" dirty="0"/>
              <a:t>+</a:t>
            </a:r>
            <a:r>
              <a:rPr lang="en-SA" sz="800" dirty="0"/>
              <a:t> B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BDBA818-1803-921F-63E2-92D994FE9BFE}"/>
              </a:ext>
            </a:extLst>
          </p:cNvPr>
          <p:cNvSpPr txBox="1"/>
          <p:nvPr/>
        </p:nvSpPr>
        <p:spPr>
          <a:xfrm>
            <a:off x="4192975" y="2415139"/>
            <a:ext cx="1437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800" dirty="0"/>
              <a:t>CD19</a:t>
            </a:r>
            <a:r>
              <a:rPr lang="en-SA" sz="800" baseline="30000" dirty="0"/>
              <a:t>+</a:t>
            </a:r>
            <a:r>
              <a:rPr lang="en-SA" sz="800" dirty="0"/>
              <a:t> B cell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35BEB8C-9744-A95D-64E8-82A4E480CD71}"/>
              </a:ext>
            </a:extLst>
          </p:cNvPr>
          <p:cNvSpPr txBox="1"/>
          <p:nvPr/>
        </p:nvSpPr>
        <p:spPr>
          <a:xfrm rot="16200000">
            <a:off x="448687" y="1407033"/>
            <a:ext cx="709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800" dirty="0"/>
              <a:t>IL10</a:t>
            </a:r>
            <a:r>
              <a:rPr lang="en-SA" sz="800" baseline="30000" dirty="0"/>
              <a:t>+</a:t>
            </a:r>
            <a:r>
              <a:rPr lang="en-SA" sz="800" dirty="0"/>
              <a:t> B cell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4B48D0C-1AFD-1658-BD71-B4D4C7E0E53D}"/>
              </a:ext>
            </a:extLst>
          </p:cNvPr>
          <p:cNvSpPr txBox="1"/>
          <p:nvPr/>
        </p:nvSpPr>
        <p:spPr>
          <a:xfrm rot="16200000">
            <a:off x="3441459" y="1357465"/>
            <a:ext cx="778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800" dirty="0"/>
              <a:t>CD25</a:t>
            </a:r>
            <a:r>
              <a:rPr lang="en-SA" sz="800" baseline="30000" dirty="0"/>
              <a:t>+</a:t>
            </a:r>
            <a:r>
              <a:rPr lang="en-SA" sz="800" dirty="0"/>
              <a:t> B cell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3FB6968-66A6-EE8F-2673-CE2F5251859B}"/>
              </a:ext>
            </a:extLst>
          </p:cNvPr>
          <p:cNvSpPr txBox="1"/>
          <p:nvPr/>
        </p:nvSpPr>
        <p:spPr>
          <a:xfrm>
            <a:off x="869621" y="532585"/>
            <a:ext cx="7090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Non-stimulate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B2EB21F-7FFD-D5F3-58DC-84AC6950E2BB}"/>
              </a:ext>
            </a:extLst>
          </p:cNvPr>
          <p:cNvSpPr txBox="1"/>
          <p:nvPr/>
        </p:nvSpPr>
        <p:spPr>
          <a:xfrm>
            <a:off x="2071367" y="532585"/>
            <a:ext cx="7090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1Bcells:1Treg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B2AF4B-9C4E-833C-71A6-7BE5935741BA}"/>
              </a:ext>
            </a:extLst>
          </p:cNvPr>
          <p:cNvSpPr txBox="1"/>
          <p:nvPr/>
        </p:nvSpPr>
        <p:spPr>
          <a:xfrm>
            <a:off x="3904433" y="538034"/>
            <a:ext cx="7090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Non-stimulate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D9E749B-7AA8-14B6-8101-3F0551602762}"/>
              </a:ext>
            </a:extLst>
          </p:cNvPr>
          <p:cNvSpPr txBox="1"/>
          <p:nvPr/>
        </p:nvSpPr>
        <p:spPr>
          <a:xfrm>
            <a:off x="4598701" y="538034"/>
            <a:ext cx="54443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Stimulate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C4ECFD4-8F0B-A6DC-1DAD-A8CE03BBFDAC}"/>
              </a:ext>
            </a:extLst>
          </p:cNvPr>
          <p:cNvSpPr txBox="1"/>
          <p:nvPr/>
        </p:nvSpPr>
        <p:spPr>
          <a:xfrm>
            <a:off x="5128374" y="538034"/>
            <a:ext cx="7090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1Bcells:1Treg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1956BC-F745-231C-4AAF-87716B373C38}"/>
              </a:ext>
            </a:extLst>
          </p:cNvPr>
          <p:cNvSpPr txBox="1"/>
          <p:nvPr/>
        </p:nvSpPr>
        <p:spPr>
          <a:xfrm>
            <a:off x="2772997" y="827664"/>
            <a:ext cx="663128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emory B cell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E5E7A55-8D6A-9E46-39F1-301ADA62A4C2}"/>
              </a:ext>
            </a:extLst>
          </p:cNvPr>
          <p:cNvSpPr txBox="1"/>
          <p:nvPr/>
        </p:nvSpPr>
        <p:spPr>
          <a:xfrm>
            <a:off x="2764922" y="1345593"/>
            <a:ext cx="663128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Immature B cell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8A35EC1-7E38-B670-15CF-1B1EAF255A5B}"/>
              </a:ext>
            </a:extLst>
          </p:cNvPr>
          <p:cNvSpPr txBox="1"/>
          <p:nvPr/>
        </p:nvSpPr>
        <p:spPr>
          <a:xfrm>
            <a:off x="2764922" y="1951343"/>
            <a:ext cx="663128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ature B cells</a:t>
            </a:r>
          </a:p>
        </p:txBody>
      </p:sp>
      <p:sp>
        <p:nvSpPr>
          <p:cNvPr id="57" name="TextBox 6">
            <a:extLst>
              <a:ext uri="{FF2B5EF4-FFF2-40B4-BE49-F238E27FC236}">
                <a16:creationId xmlns:a16="http://schemas.microsoft.com/office/drawing/2014/main" id="{6407E0AF-CA3B-B9A7-0B99-A1C0B3EFBD2A}"/>
              </a:ext>
            </a:extLst>
          </p:cNvPr>
          <p:cNvSpPr txBox="1"/>
          <p:nvPr/>
        </p:nvSpPr>
        <p:spPr>
          <a:xfrm>
            <a:off x="3683450" y="425574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5B19F85-F10F-0DC9-6A1A-62A7CF5E9CA2}"/>
              </a:ext>
            </a:extLst>
          </p:cNvPr>
          <p:cNvSpPr txBox="1"/>
          <p:nvPr/>
        </p:nvSpPr>
        <p:spPr>
          <a:xfrm>
            <a:off x="5812465" y="827664"/>
            <a:ext cx="663128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emory B cell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BCD5770-3175-5E04-BDDF-1E3F077D9DFF}"/>
              </a:ext>
            </a:extLst>
          </p:cNvPr>
          <p:cNvSpPr txBox="1"/>
          <p:nvPr/>
        </p:nvSpPr>
        <p:spPr>
          <a:xfrm>
            <a:off x="5804390" y="1345593"/>
            <a:ext cx="663128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Immature B cell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DB27FE4-2026-2587-5C96-588AD474B59D}"/>
              </a:ext>
            </a:extLst>
          </p:cNvPr>
          <p:cNvSpPr txBox="1"/>
          <p:nvPr/>
        </p:nvSpPr>
        <p:spPr>
          <a:xfrm>
            <a:off x="5804390" y="1951343"/>
            <a:ext cx="663128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ature B cells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0119622-4E58-2A17-0015-B6DB0A4410C7}"/>
              </a:ext>
            </a:extLst>
          </p:cNvPr>
          <p:cNvGrpSpPr/>
          <p:nvPr/>
        </p:nvGrpSpPr>
        <p:grpSpPr>
          <a:xfrm>
            <a:off x="831059" y="5786726"/>
            <a:ext cx="5865016" cy="1318203"/>
            <a:chOff x="1451679" y="2687320"/>
            <a:chExt cx="4491921" cy="868680"/>
          </a:xfrm>
        </p:grpSpPr>
        <p:pic>
          <p:nvPicPr>
            <p:cNvPr id="20" name="Graphic 19">
              <a:extLst>
                <a:ext uri="{FF2B5EF4-FFF2-40B4-BE49-F238E27FC236}">
                  <a16:creationId xmlns:a16="http://schemas.microsoft.com/office/drawing/2014/main" id="{4F2D944B-D43E-A4CA-7CFA-32A31D4241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-1" r="1941" b="54642"/>
            <a:stretch/>
          </p:blipFill>
          <p:spPr>
            <a:xfrm>
              <a:off x="1451679" y="2746374"/>
              <a:ext cx="2541201" cy="809626"/>
            </a:xfrm>
            <a:prstGeom prst="rect">
              <a:avLst/>
            </a:prstGeom>
          </p:spPr>
        </p:pic>
        <p:pic>
          <p:nvPicPr>
            <p:cNvPr id="22" name="Graphic 21">
              <a:extLst>
                <a:ext uri="{FF2B5EF4-FFF2-40B4-BE49-F238E27FC236}">
                  <a16:creationId xmlns:a16="http://schemas.microsoft.com/office/drawing/2014/main" id="{F8DDBAA1-A100-5853-2EA1-7EF59885AF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18480" t="57793" r="8378"/>
            <a:stretch/>
          </p:blipFill>
          <p:spPr>
            <a:xfrm>
              <a:off x="4058920" y="2687320"/>
              <a:ext cx="1884680" cy="744854"/>
            </a:xfrm>
            <a:prstGeom prst="rect">
              <a:avLst/>
            </a:prstGeom>
          </p:spPr>
        </p:pic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4FB5CA51-142E-502E-8C75-EEE5F1E40900}"/>
              </a:ext>
            </a:extLst>
          </p:cNvPr>
          <p:cNvSpPr txBox="1"/>
          <p:nvPr/>
        </p:nvSpPr>
        <p:spPr>
          <a:xfrm rot="16200000">
            <a:off x="-244557" y="3240766"/>
            <a:ext cx="867806" cy="18466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emor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7EAF847-E39A-5EC0-A9B7-6051BF52DC4C}"/>
              </a:ext>
            </a:extLst>
          </p:cNvPr>
          <p:cNvSpPr txBox="1"/>
          <p:nvPr/>
        </p:nvSpPr>
        <p:spPr>
          <a:xfrm rot="16200000">
            <a:off x="-229631" y="4149226"/>
            <a:ext cx="837954" cy="18466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Immature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A6C8C13-02C6-8592-50C7-527EFFC731DF}"/>
              </a:ext>
            </a:extLst>
          </p:cNvPr>
          <p:cNvSpPr txBox="1"/>
          <p:nvPr/>
        </p:nvSpPr>
        <p:spPr>
          <a:xfrm rot="16200000">
            <a:off x="-229631" y="5042761"/>
            <a:ext cx="837954" cy="18466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SA" sz="600" dirty="0"/>
              <a:t>Gated on Mature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96B66BA-0973-E6D0-4104-13BEB274D34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5440"/>
          <a:stretch>
            <a:fillRect/>
          </a:stretch>
        </p:blipFill>
        <p:spPr>
          <a:xfrm>
            <a:off x="927297" y="707425"/>
            <a:ext cx="1772495" cy="1654569"/>
          </a:xfrm>
          <a:prstGeom prst="rect">
            <a:avLst/>
          </a:prstGeom>
        </p:spPr>
      </p:pic>
      <p:pic>
        <p:nvPicPr>
          <p:cNvPr id="15063" name="Picture 15062">
            <a:extLst>
              <a:ext uri="{FF2B5EF4-FFF2-40B4-BE49-F238E27FC236}">
                <a16:creationId xmlns:a16="http://schemas.microsoft.com/office/drawing/2014/main" id="{2E133D7E-BD0C-1760-82A4-19A1C6EE752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5108"/>
          <a:stretch>
            <a:fillRect/>
          </a:stretch>
        </p:blipFill>
        <p:spPr>
          <a:xfrm>
            <a:off x="3976177" y="715293"/>
            <a:ext cx="1766232" cy="1634117"/>
          </a:xfrm>
          <a:prstGeom prst="rect">
            <a:avLst/>
          </a:prstGeom>
        </p:spPr>
      </p:pic>
      <p:grpSp>
        <p:nvGrpSpPr>
          <p:cNvPr id="23453" name="Group 23452">
            <a:extLst>
              <a:ext uri="{FF2B5EF4-FFF2-40B4-BE49-F238E27FC236}">
                <a16:creationId xmlns:a16="http://schemas.microsoft.com/office/drawing/2014/main" id="{849F8603-A2AE-D5A0-52C8-9A292124A598}"/>
              </a:ext>
            </a:extLst>
          </p:cNvPr>
          <p:cNvGrpSpPr/>
          <p:nvPr/>
        </p:nvGrpSpPr>
        <p:grpSpPr>
          <a:xfrm>
            <a:off x="600104" y="2806863"/>
            <a:ext cx="5867414" cy="2763882"/>
            <a:chOff x="600104" y="2806863"/>
            <a:chExt cx="5867414" cy="2763882"/>
          </a:xfrm>
        </p:grpSpPr>
        <p:pic>
          <p:nvPicPr>
            <p:cNvPr id="23449" name="Picture 23448">
              <a:extLst>
                <a:ext uri="{FF2B5EF4-FFF2-40B4-BE49-F238E27FC236}">
                  <a16:creationId xmlns:a16="http://schemas.microsoft.com/office/drawing/2014/main" id="{31A871F3-DED9-C648-4725-5038F76FA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t="4412"/>
            <a:stretch>
              <a:fillRect/>
            </a:stretch>
          </p:blipFill>
          <p:spPr>
            <a:xfrm>
              <a:off x="600104" y="2966379"/>
              <a:ext cx="5867414" cy="2604366"/>
            </a:xfrm>
            <a:prstGeom prst="rect">
              <a:avLst/>
            </a:prstGeom>
          </p:spPr>
        </p:pic>
        <p:grpSp>
          <p:nvGrpSpPr>
            <p:cNvPr id="23452" name="Group 23451">
              <a:extLst>
                <a:ext uri="{FF2B5EF4-FFF2-40B4-BE49-F238E27FC236}">
                  <a16:creationId xmlns:a16="http://schemas.microsoft.com/office/drawing/2014/main" id="{A3527AFA-A778-F1F4-27F3-3BB87DD0F462}"/>
                </a:ext>
              </a:extLst>
            </p:cNvPr>
            <p:cNvGrpSpPr/>
            <p:nvPr/>
          </p:nvGrpSpPr>
          <p:grpSpPr>
            <a:xfrm>
              <a:off x="694689" y="2806863"/>
              <a:ext cx="5739323" cy="184666"/>
              <a:chOff x="694689" y="2806863"/>
              <a:chExt cx="5739323" cy="184666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C516A399-B8D6-96B6-E42F-11FDCACF4D44}"/>
                  </a:ext>
                </a:extLst>
              </p:cNvPr>
              <p:cNvSpPr txBox="1"/>
              <p:nvPr/>
            </p:nvSpPr>
            <p:spPr>
              <a:xfrm>
                <a:off x="694689" y="2806863"/>
                <a:ext cx="8590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Non-stimulated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C039334-E0FC-ADE6-66A0-82521C8AD6FD}"/>
                  </a:ext>
                </a:extLst>
              </p:cNvPr>
              <p:cNvSpPr txBox="1"/>
              <p:nvPr/>
            </p:nvSpPr>
            <p:spPr>
              <a:xfrm>
                <a:off x="2693382" y="2806863"/>
                <a:ext cx="8062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Non-stimulated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B584F1E2-794A-A3F6-5C8F-8A45CA2819D6}"/>
                  </a:ext>
                </a:extLst>
              </p:cNvPr>
              <p:cNvSpPr txBox="1"/>
              <p:nvPr/>
            </p:nvSpPr>
            <p:spPr>
              <a:xfrm>
                <a:off x="4671341" y="2806863"/>
                <a:ext cx="914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Non-stimulated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25EA98A3-8519-D7B1-2CA7-C1CEF550206D}"/>
                  </a:ext>
                </a:extLst>
              </p:cNvPr>
              <p:cNvSpPr txBox="1"/>
              <p:nvPr/>
            </p:nvSpPr>
            <p:spPr>
              <a:xfrm>
                <a:off x="5696463" y="2806863"/>
                <a:ext cx="7375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Bcell:Treg</a:t>
                </a:r>
                <a:r>
                  <a:rPr lang="en-US" sz="600" b="1" dirty="0"/>
                  <a:t> (1:1)</a:t>
                </a:r>
                <a:endParaRPr lang="en-SA" sz="600" b="1" dirty="0"/>
              </a:p>
            </p:txBody>
          </p:sp>
          <p:sp>
            <p:nvSpPr>
              <p:cNvPr id="23450" name="TextBox 23449">
                <a:extLst>
                  <a:ext uri="{FF2B5EF4-FFF2-40B4-BE49-F238E27FC236}">
                    <a16:creationId xmlns:a16="http://schemas.microsoft.com/office/drawing/2014/main" id="{5E4E881E-0CD1-63AB-2FF7-D7EA066E6205}"/>
                  </a:ext>
                </a:extLst>
              </p:cNvPr>
              <p:cNvSpPr txBox="1"/>
              <p:nvPr/>
            </p:nvSpPr>
            <p:spPr>
              <a:xfrm>
                <a:off x="3677195" y="2806863"/>
                <a:ext cx="7375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Bcell:Treg</a:t>
                </a:r>
                <a:r>
                  <a:rPr lang="en-US" sz="600" b="1" dirty="0"/>
                  <a:t> (1:1)</a:t>
                </a:r>
                <a:endParaRPr lang="en-SA" sz="600" b="1" dirty="0"/>
              </a:p>
            </p:txBody>
          </p:sp>
          <p:sp>
            <p:nvSpPr>
              <p:cNvPr id="23451" name="TextBox 23450">
                <a:extLst>
                  <a:ext uri="{FF2B5EF4-FFF2-40B4-BE49-F238E27FC236}">
                    <a16:creationId xmlns:a16="http://schemas.microsoft.com/office/drawing/2014/main" id="{6E687EDF-206B-0E78-671B-B0B8A98828B3}"/>
                  </a:ext>
                </a:extLst>
              </p:cNvPr>
              <p:cNvSpPr txBox="1"/>
              <p:nvPr/>
            </p:nvSpPr>
            <p:spPr>
              <a:xfrm>
                <a:off x="1648315" y="2806863"/>
                <a:ext cx="7375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A" sz="600" b="1" dirty="0"/>
                  <a:t>Bcell:Treg</a:t>
                </a:r>
                <a:r>
                  <a:rPr lang="en-US" sz="600" b="1" dirty="0"/>
                  <a:t> (1:1)</a:t>
                </a:r>
                <a:endParaRPr lang="en-SA" sz="600" b="1" dirty="0"/>
              </a:p>
            </p:txBody>
          </p:sp>
        </p:grpSp>
      </p:grpSp>
      <p:cxnSp>
        <p:nvCxnSpPr>
          <p:cNvPr id="23454" name="Straight Arrow Connector 23453">
            <a:extLst>
              <a:ext uri="{FF2B5EF4-FFF2-40B4-BE49-F238E27FC236}">
                <a16:creationId xmlns:a16="http://schemas.microsoft.com/office/drawing/2014/main" id="{9CBF03D8-5BF0-F1D8-D7FD-3556FC04EE08}"/>
              </a:ext>
            </a:extLst>
          </p:cNvPr>
          <p:cNvCxnSpPr>
            <a:cxnSpLocks/>
          </p:cNvCxnSpPr>
          <p:nvPr/>
        </p:nvCxnSpPr>
        <p:spPr>
          <a:xfrm flipV="1">
            <a:off x="504793" y="2887333"/>
            <a:ext cx="14931" cy="2736193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55" name="Straight Arrow Connector 23454">
            <a:extLst>
              <a:ext uri="{FF2B5EF4-FFF2-40B4-BE49-F238E27FC236}">
                <a16:creationId xmlns:a16="http://schemas.microsoft.com/office/drawing/2014/main" id="{35C7263E-9148-6277-ED54-E3A060E1B35B}"/>
              </a:ext>
            </a:extLst>
          </p:cNvPr>
          <p:cNvCxnSpPr>
            <a:cxnSpLocks/>
          </p:cNvCxnSpPr>
          <p:nvPr/>
        </p:nvCxnSpPr>
        <p:spPr>
          <a:xfrm>
            <a:off x="505519" y="5623526"/>
            <a:ext cx="6031628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56" name="TextBox 23455">
            <a:extLst>
              <a:ext uri="{FF2B5EF4-FFF2-40B4-BE49-F238E27FC236}">
                <a16:creationId xmlns:a16="http://schemas.microsoft.com/office/drawing/2014/main" id="{9022E55D-2915-60CA-6290-8BA696E62264}"/>
              </a:ext>
            </a:extLst>
          </p:cNvPr>
          <p:cNvSpPr txBox="1"/>
          <p:nvPr/>
        </p:nvSpPr>
        <p:spPr>
          <a:xfrm>
            <a:off x="2821339" y="5597405"/>
            <a:ext cx="1437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A" sz="800" dirty="0"/>
              <a:t>CD19</a:t>
            </a:r>
            <a:r>
              <a:rPr lang="en-SA" sz="800" baseline="30000" dirty="0"/>
              <a:t>+</a:t>
            </a:r>
            <a:r>
              <a:rPr lang="en-SA" sz="800" dirty="0"/>
              <a:t> B cells</a:t>
            </a:r>
          </a:p>
        </p:txBody>
      </p:sp>
      <p:sp>
        <p:nvSpPr>
          <p:cNvPr id="23457" name="TextBox 23456">
            <a:extLst>
              <a:ext uri="{FF2B5EF4-FFF2-40B4-BE49-F238E27FC236}">
                <a16:creationId xmlns:a16="http://schemas.microsoft.com/office/drawing/2014/main" id="{6425E51A-581D-B758-8C47-589A04992BD0}"/>
              </a:ext>
            </a:extLst>
          </p:cNvPr>
          <p:cNvSpPr txBox="1"/>
          <p:nvPr/>
        </p:nvSpPr>
        <p:spPr>
          <a:xfrm rot="16200000">
            <a:off x="-148768" y="4130163"/>
            <a:ext cx="1160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Positive cells (%)</a:t>
            </a:r>
            <a:endParaRPr lang="en-SA" sz="800" dirty="0"/>
          </a:p>
        </p:txBody>
      </p:sp>
      <p:pic>
        <p:nvPicPr>
          <p:cNvPr id="23467" name="Picture 23466">
            <a:extLst>
              <a:ext uri="{FF2B5EF4-FFF2-40B4-BE49-F238E27FC236}">
                <a16:creationId xmlns:a16="http://schemas.microsoft.com/office/drawing/2014/main" id="{E01E9121-319E-2E83-9772-2C93F1540FF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0164" y="7149446"/>
            <a:ext cx="1506542" cy="1060041"/>
          </a:xfrm>
          <a:prstGeom prst="rect">
            <a:avLst/>
          </a:prstGeom>
        </p:spPr>
      </p:pic>
      <p:pic>
        <p:nvPicPr>
          <p:cNvPr id="23468" name="Picture 23467">
            <a:extLst>
              <a:ext uri="{FF2B5EF4-FFF2-40B4-BE49-F238E27FC236}">
                <a16:creationId xmlns:a16="http://schemas.microsoft.com/office/drawing/2014/main" id="{DD9F741D-724D-D456-7294-BC66E3D09B9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11140" y="7164855"/>
            <a:ext cx="1490975" cy="1044632"/>
          </a:xfrm>
          <a:prstGeom prst="rect">
            <a:avLst/>
          </a:prstGeom>
        </p:spPr>
      </p:pic>
      <p:pic>
        <p:nvPicPr>
          <p:cNvPr id="23469" name="Picture 23468">
            <a:extLst>
              <a:ext uri="{FF2B5EF4-FFF2-40B4-BE49-F238E27FC236}">
                <a16:creationId xmlns:a16="http://schemas.microsoft.com/office/drawing/2014/main" id="{8BA3B507-A3B5-163E-47D2-2F203A7EE30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73770" y="7124863"/>
            <a:ext cx="2175781" cy="1084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4508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45C598-B84A-45B5-DD54-109325142B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Box 127">
            <a:extLst>
              <a:ext uri="{FF2B5EF4-FFF2-40B4-BE49-F238E27FC236}">
                <a16:creationId xmlns:a16="http://schemas.microsoft.com/office/drawing/2014/main" id="{2215A5DA-8A18-1A6A-E0DE-5682C89442D4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Figure 3 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07748E7C-FF76-0D4A-6C81-750DD37D3129}"/>
              </a:ext>
            </a:extLst>
          </p:cNvPr>
          <p:cNvSpPr txBox="1"/>
          <p:nvPr/>
        </p:nvSpPr>
        <p:spPr>
          <a:xfrm>
            <a:off x="525222" y="425574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80A5084-651F-6C21-0761-7E999D47FCAA}"/>
              </a:ext>
            </a:extLst>
          </p:cNvPr>
          <p:cNvCxnSpPr>
            <a:cxnSpLocks/>
          </p:cNvCxnSpPr>
          <p:nvPr/>
        </p:nvCxnSpPr>
        <p:spPr>
          <a:xfrm>
            <a:off x="763130" y="6915264"/>
            <a:ext cx="26528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 Box 4">
            <a:extLst>
              <a:ext uri="{FF2B5EF4-FFF2-40B4-BE49-F238E27FC236}">
                <a16:creationId xmlns:a16="http://schemas.microsoft.com/office/drawing/2014/main" id="{48046DCA-D434-A7DB-DB97-A76CCA2C2129}"/>
              </a:ext>
            </a:extLst>
          </p:cNvPr>
          <p:cNvSpPr txBox="1"/>
          <p:nvPr/>
        </p:nvSpPr>
        <p:spPr>
          <a:xfrm>
            <a:off x="1432627" y="6901522"/>
            <a:ext cx="1371600" cy="228526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buNone/>
            </a:pPr>
            <a:r>
              <a:rPr lang="en-US" sz="7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D19</a:t>
            </a:r>
            <a:r>
              <a:rPr lang="en-US" sz="750" baseline="30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sz="7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 cells</a:t>
            </a:r>
            <a:endParaRPr lang="en-SA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" name="Text Box 4">
            <a:extLst>
              <a:ext uri="{FF2B5EF4-FFF2-40B4-BE49-F238E27FC236}">
                <a16:creationId xmlns:a16="http://schemas.microsoft.com/office/drawing/2014/main" id="{FB0D2901-1190-612A-DCF9-FDE84FF880AA}"/>
              </a:ext>
            </a:extLst>
          </p:cNvPr>
          <p:cNvSpPr txBox="1"/>
          <p:nvPr/>
        </p:nvSpPr>
        <p:spPr>
          <a:xfrm>
            <a:off x="816679" y="5756218"/>
            <a:ext cx="871855" cy="287563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buNone/>
            </a:pPr>
            <a:r>
              <a:rPr lang="en-US" sz="65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on-stimulated</a:t>
            </a:r>
            <a:endParaRPr lang="en-SA" sz="120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ctr">
              <a:buNone/>
            </a:pPr>
            <a:r>
              <a:rPr lang="en-US" sz="65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 cells</a:t>
            </a:r>
            <a:endParaRPr lang="en-SA" sz="120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" name="Text Box 4">
            <a:extLst>
              <a:ext uri="{FF2B5EF4-FFF2-40B4-BE49-F238E27FC236}">
                <a16:creationId xmlns:a16="http://schemas.microsoft.com/office/drawing/2014/main" id="{EB56C097-7999-4601-C36E-90327C54FABE}"/>
              </a:ext>
            </a:extLst>
          </p:cNvPr>
          <p:cNvSpPr txBox="1"/>
          <p:nvPr/>
        </p:nvSpPr>
        <p:spPr>
          <a:xfrm>
            <a:off x="1646412" y="5756218"/>
            <a:ext cx="871855" cy="287563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buNone/>
            </a:pPr>
            <a:r>
              <a:rPr lang="en-US" sz="650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Tcells</a:t>
            </a:r>
            <a:r>
              <a:rPr lang="en-US" sz="6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stimulated</a:t>
            </a:r>
            <a:endParaRPr lang="en-SA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ctr">
              <a:buNone/>
            </a:pPr>
            <a:r>
              <a:rPr lang="en-US" sz="6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 cells only</a:t>
            </a:r>
            <a:endParaRPr lang="en-SA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Text Box 4">
            <a:extLst>
              <a:ext uri="{FF2B5EF4-FFF2-40B4-BE49-F238E27FC236}">
                <a16:creationId xmlns:a16="http://schemas.microsoft.com/office/drawing/2014/main" id="{2FEBFFA3-E810-E25F-00E8-42448BF39811}"/>
              </a:ext>
            </a:extLst>
          </p:cNvPr>
          <p:cNvSpPr txBox="1"/>
          <p:nvPr/>
        </p:nvSpPr>
        <p:spPr>
          <a:xfrm>
            <a:off x="2467679" y="5756218"/>
            <a:ext cx="1022985" cy="287563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buNone/>
            </a:pPr>
            <a:r>
              <a:rPr lang="en-US" sz="65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Tcells-stimulated</a:t>
            </a:r>
            <a:endParaRPr lang="en-SA" sz="120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ctr">
              <a:buNone/>
            </a:pPr>
            <a:r>
              <a:rPr lang="en-US" sz="65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 cells plus TIM3 Block</a:t>
            </a:r>
            <a:endParaRPr lang="en-SA" sz="120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TextBox 6">
            <a:extLst>
              <a:ext uri="{FF2B5EF4-FFF2-40B4-BE49-F238E27FC236}">
                <a16:creationId xmlns:a16="http://schemas.microsoft.com/office/drawing/2014/main" id="{F10E6D36-82E8-4075-A0AF-7B401B444517}"/>
              </a:ext>
            </a:extLst>
          </p:cNvPr>
          <p:cNvSpPr txBox="1"/>
          <p:nvPr/>
        </p:nvSpPr>
        <p:spPr>
          <a:xfrm>
            <a:off x="525222" y="5441017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xtBox 6">
            <a:extLst>
              <a:ext uri="{FF2B5EF4-FFF2-40B4-BE49-F238E27FC236}">
                <a16:creationId xmlns:a16="http://schemas.microsoft.com/office/drawing/2014/main" id="{C3E55F16-04D2-0948-7FE3-7965DEEB8655}"/>
              </a:ext>
            </a:extLst>
          </p:cNvPr>
          <p:cNvSpPr txBox="1"/>
          <p:nvPr/>
        </p:nvSpPr>
        <p:spPr>
          <a:xfrm>
            <a:off x="2137478" y="7354988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DA87EB0-DEBE-0F58-A94F-D9B8E49374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8330" y="641146"/>
            <a:ext cx="2875229" cy="460867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3AF3A73-84CF-25E7-4A93-DB163AA774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3012" y="5346359"/>
            <a:ext cx="2875230" cy="176394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4702070-24A1-7628-273D-7394CB0D6F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8267" y="7354988"/>
            <a:ext cx="2421430" cy="1677770"/>
          </a:xfrm>
          <a:prstGeom prst="rect">
            <a:avLst/>
          </a:prstGeom>
        </p:spPr>
      </p:pic>
      <p:pic>
        <p:nvPicPr>
          <p:cNvPr id="20646" name="Graphic 20645">
            <a:extLst>
              <a:ext uri="{FF2B5EF4-FFF2-40B4-BE49-F238E27FC236}">
                <a16:creationId xmlns:a16="http://schemas.microsoft.com/office/drawing/2014/main" id="{AEB0B118-7240-F937-E957-BB1C3D6FE5E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45425" y="6031295"/>
            <a:ext cx="2473827" cy="810091"/>
          </a:xfrm>
          <a:prstGeom prst="rect">
            <a:avLst/>
          </a:prstGeom>
        </p:spPr>
      </p:pic>
      <p:sp>
        <p:nvSpPr>
          <p:cNvPr id="20647" name="TextBox 20646">
            <a:extLst>
              <a:ext uri="{FF2B5EF4-FFF2-40B4-BE49-F238E27FC236}">
                <a16:creationId xmlns:a16="http://schemas.microsoft.com/office/drawing/2014/main" id="{542C7F94-D5F8-AE5C-19AF-17459286D5FF}"/>
              </a:ext>
            </a:extLst>
          </p:cNvPr>
          <p:cNvSpPr txBox="1"/>
          <p:nvPr/>
        </p:nvSpPr>
        <p:spPr>
          <a:xfrm>
            <a:off x="1152525" y="6124854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Helvetica" panose="020B0604020202020204" pitchFamily="34" charset="0"/>
                <a:cs typeface="Helvetica" panose="020B0604020202020204" pitchFamily="34" charset="0"/>
              </a:rPr>
              <a:t>0.00</a:t>
            </a:r>
            <a:endParaRPr lang="en-GB" sz="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648" name="TextBox 20647">
            <a:extLst>
              <a:ext uri="{FF2B5EF4-FFF2-40B4-BE49-F238E27FC236}">
                <a16:creationId xmlns:a16="http://schemas.microsoft.com/office/drawing/2014/main" id="{EDA50000-2AFF-B3FE-1A94-7E37BB6CDF33}"/>
              </a:ext>
            </a:extLst>
          </p:cNvPr>
          <p:cNvSpPr txBox="1"/>
          <p:nvPr/>
        </p:nvSpPr>
        <p:spPr>
          <a:xfrm>
            <a:off x="1979330" y="6120264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Helvetica" panose="020B0604020202020204" pitchFamily="34" charset="0"/>
                <a:cs typeface="Helvetica" panose="020B0604020202020204" pitchFamily="34" charset="0"/>
              </a:rPr>
              <a:t>3.75</a:t>
            </a:r>
            <a:endParaRPr lang="en-GB" sz="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649" name="TextBox 20648">
            <a:extLst>
              <a:ext uri="{FF2B5EF4-FFF2-40B4-BE49-F238E27FC236}">
                <a16:creationId xmlns:a16="http://schemas.microsoft.com/office/drawing/2014/main" id="{288693EF-FEA5-AF0B-2721-ADB598D03068}"/>
              </a:ext>
            </a:extLst>
          </p:cNvPr>
          <p:cNvSpPr txBox="1"/>
          <p:nvPr/>
        </p:nvSpPr>
        <p:spPr>
          <a:xfrm>
            <a:off x="2842331" y="6124878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Helvetica" panose="020B0604020202020204" pitchFamily="34" charset="0"/>
                <a:cs typeface="Helvetica" panose="020B0604020202020204" pitchFamily="34" charset="0"/>
              </a:rPr>
              <a:t>3.97</a:t>
            </a:r>
            <a:endParaRPr lang="en-GB" sz="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0650" name="Straight Arrow Connector 20649">
            <a:extLst>
              <a:ext uri="{FF2B5EF4-FFF2-40B4-BE49-F238E27FC236}">
                <a16:creationId xmlns:a16="http://schemas.microsoft.com/office/drawing/2014/main" id="{79ECC16D-E6B4-A706-FF23-F7DBEF5A620D}"/>
              </a:ext>
            </a:extLst>
          </p:cNvPr>
          <p:cNvCxnSpPr>
            <a:cxnSpLocks/>
          </p:cNvCxnSpPr>
          <p:nvPr/>
        </p:nvCxnSpPr>
        <p:spPr>
          <a:xfrm flipV="1">
            <a:off x="763130" y="5962650"/>
            <a:ext cx="0" cy="9526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57" name="Text Box 4">
            <a:extLst>
              <a:ext uri="{FF2B5EF4-FFF2-40B4-BE49-F238E27FC236}">
                <a16:creationId xmlns:a16="http://schemas.microsoft.com/office/drawing/2014/main" id="{768537C1-2BF3-43CB-9FBB-8E3062069CE5}"/>
              </a:ext>
            </a:extLst>
          </p:cNvPr>
          <p:cNvSpPr txBox="1"/>
          <p:nvPr/>
        </p:nvSpPr>
        <p:spPr>
          <a:xfrm rot="16200000">
            <a:off x="261453" y="6398968"/>
            <a:ext cx="776583" cy="228526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buNone/>
            </a:pPr>
            <a:r>
              <a:rPr lang="en-US" sz="75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L-</a:t>
            </a:r>
            <a:r>
              <a:rPr lang="en-US" sz="7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10</a:t>
            </a:r>
            <a:r>
              <a:rPr lang="en-US" sz="750" baseline="30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sz="75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ells</a:t>
            </a:r>
            <a:endParaRPr lang="en-SA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82604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62B35A-46A0-016A-E61B-34DD1AE0BD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Box 127">
            <a:extLst>
              <a:ext uri="{FF2B5EF4-FFF2-40B4-BE49-F238E27FC236}">
                <a16:creationId xmlns:a16="http://schemas.microsoft.com/office/drawing/2014/main" id="{A36813F4-B4CE-1484-0630-8FA2340031CB}"/>
              </a:ext>
            </a:extLst>
          </p:cNvPr>
          <p:cNvSpPr txBox="1"/>
          <p:nvPr/>
        </p:nvSpPr>
        <p:spPr>
          <a:xfrm>
            <a:off x="0" y="386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Figure 4 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BF4BFD5A-4CFB-E2DC-0FCC-D8A873D86D43}"/>
              </a:ext>
            </a:extLst>
          </p:cNvPr>
          <p:cNvSpPr txBox="1"/>
          <p:nvPr/>
        </p:nvSpPr>
        <p:spPr>
          <a:xfrm>
            <a:off x="80835" y="468262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1" name="TextBox 6">
            <a:extLst>
              <a:ext uri="{FF2B5EF4-FFF2-40B4-BE49-F238E27FC236}">
                <a16:creationId xmlns:a16="http://schemas.microsoft.com/office/drawing/2014/main" id="{2A5B6EC6-862A-C4B2-98F3-960C885270C0}"/>
              </a:ext>
            </a:extLst>
          </p:cNvPr>
          <p:cNvSpPr txBox="1"/>
          <p:nvPr/>
        </p:nvSpPr>
        <p:spPr>
          <a:xfrm>
            <a:off x="80835" y="5111391"/>
            <a:ext cx="371030" cy="215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Aft>
                <a:spcPts val="8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BC1E739-0690-826F-6398-AB4C7C443A7C}"/>
              </a:ext>
            </a:extLst>
          </p:cNvPr>
          <p:cNvGrpSpPr/>
          <p:nvPr/>
        </p:nvGrpSpPr>
        <p:grpSpPr>
          <a:xfrm>
            <a:off x="202017" y="656503"/>
            <a:ext cx="6478771" cy="3971691"/>
            <a:chOff x="202017" y="1304211"/>
            <a:chExt cx="6478771" cy="3971691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080A462-CA35-63B4-A2B0-E5A651840DA5}"/>
                </a:ext>
              </a:extLst>
            </p:cNvPr>
            <p:cNvSpPr txBox="1"/>
            <p:nvPr/>
          </p:nvSpPr>
          <p:spPr>
            <a:xfrm>
              <a:off x="365582" y="1310307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N</a:t>
              </a:r>
              <a:r>
                <a:rPr lang="en-SA" sz="900" b="1" dirty="0"/>
                <a:t>on-stimulated </a:t>
              </a:r>
              <a:endParaRPr lang="en-SA" sz="1200" b="1" dirty="0"/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B8202C66-A69B-3AA3-C2A6-501DB3F7DAA1}"/>
                </a:ext>
              </a:extLst>
            </p:cNvPr>
            <p:cNvSpPr txBox="1"/>
            <p:nvPr/>
          </p:nvSpPr>
          <p:spPr>
            <a:xfrm>
              <a:off x="1336619" y="1304211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S</a:t>
              </a:r>
              <a:r>
                <a:rPr lang="en-SA" sz="900" b="1" dirty="0"/>
                <a:t>timulated </a:t>
              </a:r>
              <a:endParaRPr lang="en-SA" sz="1200" b="1" dirty="0"/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279EAD7-D360-4D70-A167-6C23D64E1194}"/>
                </a:ext>
              </a:extLst>
            </p:cNvPr>
            <p:cNvSpPr txBox="1"/>
            <p:nvPr/>
          </p:nvSpPr>
          <p:spPr>
            <a:xfrm>
              <a:off x="2269836" y="1304211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err="1"/>
                <a:t>Treg:B</a:t>
              </a:r>
              <a:r>
                <a:rPr lang="en-US" sz="900" b="1" dirty="0"/>
                <a:t> cells </a:t>
              </a:r>
              <a:endParaRPr lang="en-SA" sz="1200" b="1" dirty="0"/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761E5D2-0BF6-0D1F-32D8-86B3423A15A2}"/>
                </a:ext>
              </a:extLst>
            </p:cNvPr>
            <p:cNvSpPr txBox="1"/>
            <p:nvPr/>
          </p:nvSpPr>
          <p:spPr>
            <a:xfrm>
              <a:off x="3541684" y="1314804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N</a:t>
              </a:r>
              <a:r>
                <a:rPr lang="en-SA" sz="900" b="1" dirty="0"/>
                <a:t>on-stimulated </a:t>
              </a:r>
              <a:endParaRPr lang="en-SA" sz="1200" b="1" dirty="0"/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01E9E50A-30FC-359F-CF6C-100588C1F1DF}"/>
                </a:ext>
              </a:extLst>
            </p:cNvPr>
            <p:cNvSpPr txBox="1"/>
            <p:nvPr/>
          </p:nvSpPr>
          <p:spPr>
            <a:xfrm>
              <a:off x="4512721" y="1314804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S</a:t>
              </a:r>
              <a:r>
                <a:rPr lang="en-SA" sz="900" b="1" dirty="0"/>
                <a:t>timulated </a:t>
              </a:r>
              <a:endParaRPr lang="en-SA" sz="1200" b="1" dirty="0"/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A5E08E18-AD75-0C0F-61A8-D54AE9FAF0E3}"/>
                </a:ext>
              </a:extLst>
            </p:cNvPr>
            <p:cNvSpPr txBox="1"/>
            <p:nvPr/>
          </p:nvSpPr>
          <p:spPr>
            <a:xfrm>
              <a:off x="5483758" y="1314804"/>
              <a:ext cx="1197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err="1"/>
                <a:t>Treg:B</a:t>
              </a:r>
              <a:r>
                <a:rPr lang="en-US" sz="900" b="1" dirty="0"/>
                <a:t> cells </a:t>
              </a:r>
              <a:endParaRPr lang="en-SA" sz="1200" b="1" dirty="0"/>
            </a:p>
          </p:txBody>
        </p:sp>
        <p:pic>
          <p:nvPicPr>
            <p:cNvPr id="3" name="Graphic 2">
              <a:extLst>
                <a:ext uri="{FF2B5EF4-FFF2-40B4-BE49-F238E27FC236}">
                  <a16:creationId xmlns:a16="http://schemas.microsoft.com/office/drawing/2014/main" id="{6E83CB84-B8D5-F2B8-141C-283E06AF87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t="3021"/>
            <a:stretch>
              <a:fillRect/>
            </a:stretch>
          </p:blipFill>
          <p:spPr>
            <a:xfrm>
              <a:off x="202017" y="1545636"/>
              <a:ext cx="6334089" cy="3730266"/>
            </a:xfrm>
            <a:prstGeom prst="rect">
              <a:avLst/>
            </a:prstGeom>
          </p:spPr>
        </p:pic>
      </p:grpSp>
      <p:pic>
        <p:nvPicPr>
          <p:cNvPr id="7" name="Graphic 6">
            <a:extLst>
              <a:ext uri="{FF2B5EF4-FFF2-40B4-BE49-F238E27FC236}">
                <a16:creationId xmlns:a16="http://schemas.microsoft.com/office/drawing/2014/main" id="{5E80E7FD-40B2-E7E3-6D9B-E9DBF94DA7A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7794" y="5219177"/>
            <a:ext cx="6699371" cy="31099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1885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64</TotalTime>
  <Words>703</Words>
  <Application>Microsoft Office PowerPoint</Application>
  <PresentationFormat>On-screen Show (4:3)</PresentationFormat>
  <Paragraphs>455</Paragraphs>
  <Slides>9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Arial Rounded MT Bold</vt:lpstr>
      <vt:lpstr>Calibri</vt:lpstr>
      <vt:lpstr>Calibri Light</vt:lpstr>
      <vt:lpstr>Helvetica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otta, Cristiano</dc:creator>
  <cp:lastModifiedBy>Cristiano Scotta (Staff)</cp:lastModifiedBy>
  <cp:revision>41</cp:revision>
  <cp:lastPrinted>2023-11-21T15:23:25Z</cp:lastPrinted>
  <dcterms:created xsi:type="dcterms:W3CDTF">2022-07-13T14:35:20Z</dcterms:created>
  <dcterms:modified xsi:type="dcterms:W3CDTF">2025-11-16T18:11:38Z</dcterms:modified>
</cp:coreProperties>
</file>